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9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9" autoAdjust="0"/>
    <p:restoredTop sz="94660"/>
  </p:normalViewPr>
  <p:slideViewPr>
    <p:cSldViewPr snapToGrid="0">
      <p:cViewPr varScale="1">
        <p:scale>
          <a:sx n="75" d="100"/>
          <a:sy n="75" d="100"/>
        </p:scale>
        <p:origin x="72" y="16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Xuhua Xia" userId="9785434e-9de8-4053-8cae-a75fe059478d" providerId="ADAL" clId="{E60B3390-E288-4A38-BBD3-1C0973405D5A}"/>
    <pc:docChg chg="modSld">
      <pc:chgData name="Xuhua Xia" userId="9785434e-9de8-4053-8cae-a75fe059478d" providerId="ADAL" clId="{E60B3390-E288-4A38-BBD3-1C0973405D5A}" dt="2024-09-22T21:50:22.842" v="10" actId="20577"/>
      <pc:docMkLst>
        <pc:docMk/>
      </pc:docMkLst>
      <pc:sldChg chg="modSp mod">
        <pc:chgData name="Xuhua Xia" userId="9785434e-9de8-4053-8cae-a75fe059478d" providerId="ADAL" clId="{E60B3390-E288-4A38-BBD3-1C0973405D5A}" dt="2024-09-22T21:50:22.842" v="10" actId="20577"/>
        <pc:sldMkLst>
          <pc:docMk/>
          <pc:sldMk cId="1716974175" sldId="493"/>
        </pc:sldMkLst>
        <pc:spChg chg="mod">
          <ac:chgData name="Xuhua Xia" userId="9785434e-9de8-4053-8cae-a75fe059478d" providerId="ADAL" clId="{E60B3390-E288-4A38-BBD3-1C0973405D5A}" dt="2024-09-22T21:48:23.933" v="4" actId="20577"/>
          <ac:spMkLst>
            <pc:docMk/>
            <pc:sldMk cId="1716974175" sldId="493"/>
            <ac:spMk id="229" creationId="{391856A4-83C0-CA34-3A04-B2F619CB8115}"/>
          </ac:spMkLst>
        </pc:spChg>
        <pc:spChg chg="mod">
          <ac:chgData name="Xuhua Xia" userId="9785434e-9de8-4053-8cae-a75fe059478d" providerId="ADAL" clId="{E60B3390-E288-4A38-BBD3-1C0973405D5A}" dt="2024-09-22T21:50:22.842" v="10" actId="20577"/>
          <ac:spMkLst>
            <pc:docMk/>
            <pc:sldMk cId="1716974175" sldId="493"/>
            <ac:spMk id="244" creationId="{3BA0754F-E65B-851A-8921-E6A52D39845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DC3780-BA81-30AD-05A0-B696A13CE8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620872-03AC-A438-56E7-12F33CCDD1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052AD6-4597-C759-9B07-EFC8EFE07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C77D04-696C-ADBB-2F13-AEFDFC22B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8CB947-8983-6D50-1CF6-CF5ED5C35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726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86E57C-E126-20C0-1C62-4C4D87C29E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1C476F-EC97-3C8F-A40D-4BA2C1427A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B094C-C663-661B-CFAF-E530E0F3D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770A64-6553-CAE1-2AE9-84EA131F7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C3D0D1-B235-DDA9-56D3-F813A8BA8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74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3538D7-3E9E-742A-7687-441B9740E1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E98095-361A-E563-2CF4-AC4E20813B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8D5E62-2BC9-5E66-68E3-BDF6C1AE9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C8948-086C-53E2-85EE-8913F4F3A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A52138-07BB-2BDD-A76C-2B0592F6F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617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9EC76-8CBD-9884-00E1-54453EF6A8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2E4EAF-79DE-4053-E62B-86F91E30FC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9E2E2C-1DE9-70B1-123F-C09A652C7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741F62-E446-DC82-FCF5-A70D3D5E2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1435B6-1C3F-C4C0-B4F3-7E289DF7B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020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CB8768-C39A-1BB4-2C86-6D52C4DA07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14FBC4-75A3-B02C-02C6-0DF953D77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4DC553-A9D3-FDD2-2BE1-AF32DFEB0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7FF1DA-2A12-135B-77E8-0580C56F4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6561C8-8037-A82A-18AD-009A7775C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57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2E8C9-8B33-78BD-1080-9D4EB7BE7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EDE5C0-7FD2-6060-228B-F000517F84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786D68-BD8B-F0EE-921A-03AD8C11A2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812570-6037-3F50-D598-4AA3D3F54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403E98-6EEE-7884-007B-71852776C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F4EA45-2562-8E1A-A143-C3B930221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446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337E7D-D35E-9753-A64A-6D37B7FCF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DD080C-7402-C02A-54A6-C4DEE13534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2A97FC-8F00-52EF-071E-A182AE13DF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78CC35-4C73-AE98-677A-B36793F757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EE457D-CEE8-7FCC-E159-588B070DF3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407B6F5-A3FA-C451-BBB3-B10D52F26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BCCA55-AB99-C56D-8F03-945B63D1A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65A9E4-51E2-C3E5-2388-6623C94E4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239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0B9CE-4002-335B-5B32-63D56FC927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59B457-7609-E961-E2A2-6D4B83A2B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0ED198-59EB-FDA5-9F09-FB9F76AA1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633D44-8D47-2D01-CAFC-D8EA49BD5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236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6E74B5-0120-72A7-07E3-F1B73BDDC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D9FDD3-A8E2-D8CA-C096-4A69A8CA3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B5961D-4AB5-65CE-C1F9-ADD678E89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115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3015F3-65BC-BAB9-C4FB-1DF53E4202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392E8E-4913-34FE-C8EF-56D0D7DE36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380D80-E03C-EE9D-2906-3E3B0E4F81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AC69CC-0B6E-91E5-E80E-94A0DB3C6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2E061D-5F07-3642-D18A-732145B65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C5192B-0350-DB3E-7E4D-29AA61B937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561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2E2E76-B227-3373-D60C-41243285B5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3CFB70B-3A4F-E488-FF1A-BF20FDF5A4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E7FD31-332D-972A-A581-6CD138BCA2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6E3295-4A2E-5E13-3D5E-A3C5E5A51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7EDA5A-2CDD-26DC-9D05-4BFB55696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FD4D57-CB6A-997F-A851-49804409E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169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498BBC-DA54-1802-5ED6-5D731E1A71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4EAEA2-8EAF-2C14-EFC1-2C754A3D4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46852E-CACC-CEDE-4BF3-183BC7AE06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209192-F129-432E-AA36-79390934E8E0}" type="datetimeFigureOut">
              <a:rPr lang="en-US" smtClean="0"/>
              <a:t>9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4A4770-1CB3-4211-F795-FC56A02941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978971-C052-F671-5857-C62357BB60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B267BC-9F05-4C43-A356-6C0277D35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632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E0EDE03-6213-75BC-421F-0A474F18568C}"/>
              </a:ext>
            </a:extLst>
          </p:cNvPr>
          <p:cNvGrpSpPr/>
          <p:nvPr/>
        </p:nvGrpSpPr>
        <p:grpSpPr>
          <a:xfrm>
            <a:off x="34703" y="-47731"/>
            <a:ext cx="12219583" cy="6827102"/>
            <a:chOff x="34702" y="-47731"/>
            <a:chExt cx="12470224" cy="6827102"/>
          </a:xfrm>
        </p:grpSpPr>
        <p:grpSp>
          <p:nvGrpSpPr>
            <p:cNvPr id="5" name="Graphic 2">
              <a:extLst>
                <a:ext uri="{FF2B5EF4-FFF2-40B4-BE49-F238E27FC236}">
                  <a16:creationId xmlns:a16="http://schemas.microsoft.com/office/drawing/2014/main" id="{49C1A00B-B157-8E37-01D6-E9DC6819A71F}"/>
                </a:ext>
              </a:extLst>
            </p:cNvPr>
            <p:cNvGrpSpPr/>
            <p:nvPr/>
          </p:nvGrpSpPr>
          <p:grpSpPr>
            <a:xfrm>
              <a:off x="34702" y="57361"/>
              <a:ext cx="10433760" cy="6611659"/>
              <a:chOff x="34702" y="135193"/>
              <a:chExt cx="10433760" cy="6333131"/>
            </a:xfrm>
          </p:grpSpPr>
          <p:sp>
            <p:nvSpPr>
              <p:cNvPr id="8" name="Freeform: Shape 7">
                <a:extLst>
                  <a:ext uri="{FF2B5EF4-FFF2-40B4-BE49-F238E27FC236}">
                    <a16:creationId xmlns:a16="http://schemas.microsoft.com/office/drawing/2014/main" id="{68E9E841-0D01-FD6A-3D1B-546F90FBBA2F}"/>
                  </a:ext>
                </a:extLst>
              </p:cNvPr>
              <p:cNvSpPr/>
              <p:nvPr/>
            </p:nvSpPr>
            <p:spPr>
              <a:xfrm>
                <a:off x="5528690" y="5215694"/>
                <a:ext cx="6" cy="369276"/>
              </a:xfrm>
              <a:custGeom>
                <a:avLst/>
                <a:gdLst>
                  <a:gd name="connsiteX0" fmla="*/ 12 w 6"/>
                  <a:gd name="connsiteY0" fmla="*/ 369283 h 369276"/>
                  <a:gd name="connsiteX1" fmla="*/ 6 w 6"/>
                  <a:gd name="connsiteY1" fmla="*/ 369283 h 369276"/>
                  <a:gd name="connsiteX2" fmla="*/ 6 w 6"/>
                  <a:gd name="connsiteY2" fmla="*/ 6 h 3692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369276">
                    <a:moveTo>
                      <a:pt x="12" y="369283"/>
                    </a:moveTo>
                    <a:lnTo>
                      <a:pt x="6" y="369283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Freeform: Shape 8">
                <a:extLst>
                  <a:ext uri="{FF2B5EF4-FFF2-40B4-BE49-F238E27FC236}">
                    <a16:creationId xmlns:a16="http://schemas.microsoft.com/office/drawing/2014/main" id="{7972CDBB-702E-8BCD-761A-8D44DD19CEE3}"/>
                  </a:ext>
                </a:extLst>
              </p:cNvPr>
              <p:cNvSpPr/>
              <p:nvPr/>
            </p:nvSpPr>
            <p:spPr>
              <a:xfrm>
                <a:off x="5528615" y="4614724"/>
                <a:ext cx="6" cy="113741"/>
              </a:xfrm>
              <a:custGeom>
                <a:avLst/>
                <a:gdLst>
                  <a:gd name="connsiteX0" fmla="*/ 12 w 6"/>
                  <a:gd name="connsiteY0" fmla="*/ 6 h 113741"/>
                  <a:gd name="connsiteX1" fmla="*/ 6 w 6"/>
                  <a:gd name="connsiteY1" fmla="*/ 6 h 113741"/>
                  <a:gd name="connsiteX2" fmla="*/ 6 w 6"/>
                  <a:gd name="connsiteY2" fmla="*/ 113748 h 11374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113741">
                    <a:moveTo>
                      <a:pt x="12" y="6"/>
                    </a:moveTo>
                    <a:lnTo>
                      <a:pt x="6" y="6"/>
                    </a:lnTo>
                    <a:lnTo>
                      <a:pt x="6" y="11374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Freeform: Shape 9">
                <a:extLst>
                  <a:ext uri="{FF2B5EF4-FFF2-40B4-BE49-F238E27FC236}">
                    <a16:creationId xmlns:a16="http://schemas.microsoft.com/office/drawing/2014/main" id="{F4BF9A6C-F140-DC33-1DB9-DC89432CAEDE}"/>
                  </a:ext>
                </a:extLst>
              </p:cNvPr>
              <p:cNvSpPr/>
              <p:nvPr/>
            </p:nvSpPr>
            <p:spPr>
              <a:xfrm>
                <a:off x="9376214" y="2456416"/>
                <a:ext cx="5783" cy="81457"/>
              </a:xfrm>
              <a:custGeom>
                <a:avLst/>
                <a:gdLst>
                  <a:gd name="connsiteX0" fmla="*/ 6 w 5783"/>
                  <a:gd name="connsiteY0" fmla="*/ 81463 h 81457"/>
                  <a:gd name="connsiteX1" fmla="*/ 6 w 5783"/>
                  <a:gd name="connsiteY1" fmla="*/ 81463 h 81457"/>
                  <a:gd name="connsiteX2" fmla="*/ 6 w 5783"/>
                  <a:gd name="connsiteY2" fmla="*/ 6 h 8145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81457">
                    <a:moveTo>
                      <a:pt x="6" y="81463"/>
                    </a:moveTo>
                    <a:lnTo>
                      <a:pt x="6" y="81463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Freeform: Shape 10">
                <a:extLst>
                  <a:ext uri="{FF2B5EF4-FFF2-40B4-BE49-F238E27FC236}">
                    <a16:creationId xmlns:a16="http://schemas.microsoft.com/office/drawing/2014/main" id="{D6EA247E-4417-37D8-C884-3CF448DC3A6F}"/>
                  </a:ext>
                </a:extLst>
              </p:cNvPr>
              <p:cNvSpPr/>
              <p:nvPr/>
            </p:nvSpPr>
            <p:spPr>
              <a:xfrm>
                <a:off x="5528615" y="4728465"/>
                <a:ext cx="34" cy="113736"/>
              </a:xfrm>
              <a:custGeom>
                <a:avLst/>
                <a:gdLst>
                  <a:gd name="connsiteX0" fmla="*/ 41 w 34"/>
                  <a:gd name="connsiteY0" fmla="*/ 113742 h 113736"/>
                  <a:gd name="connsiteX1" fmla="*/ 6 w 34"/>
                  <a:gd name="connsiteY1" fmla="*/ 113742 h 113736"/>
                  <a:gd name="connsiteX2" fmla="*/ 6 w 34"/>
                  <a:gd name="connsiteY2" fmla="*/ 6 h 1137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34" h="113736">
                    <a:moveTo>
                      <a:pt x="41" y="113742"/>
                    </a:moveTo>
                    <a:lnTo>
                      <a:pt x="6" y="11374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Freeform: Shape 11">
                <a:extLst>
                  <a:ext uri="{FF2B5EF4-FFF2-40B4-BE49-F238E27FC236}">
                    <a16:creationId xmlns:a16="http://schemas.microsoft.com/office/drawing/2014/main" id="{1C8A9FEE-8C82-863E-21D9-39E1E48DB601}"/>
                  </a:ext>
                </a:extLst>
              </p:cNvPr>
              <p:cNvSpPr/>
              <p:nvPr/>
            </p:nvSpPr>
            <p:spPr>
              <a:xfrm>
                <a:off x="9376099" y="2143258"/>
                <a:ext cx="5783" cy="77761"/>
              </a:xfrm>
              <a:custGeom>
                <a:avLst/>
                <a:gdLst>
                  <a:gd name="connsiteX0" fmla="*/ 6 w 5783"/>
                  <a:gd name="connsiteY0" fmla="*/ 6 h 77761"/>
                  <a:gd name="connsiteX1" fmla="*/ 6 w 5783"/>
                  <a:gd name="connsiteY1" fmla="*/ 6 h 77761"/>
                  <a:gd name="connsiteX2" fmla="*/ 6 w 5783"/>
                  <a:gd name="connsiteY2" fmla="*/ 77768 h 7776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7761">
                    <a:moveTo>
                      <a:pt x="6" y="6"/>
                    </a:moveTo>
                    <a:lnTo>
                      <a:pt x="6" y="6"/>
                    </a:lnTo>
                    <a:lnTo>
                      <a:pt x="6" y="7776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Freeform: Shape 12">
                <a:extLst>
                  <a:ext uri="{FF2B5EF4-FFF2-40B4-BE49-F238E27FC236}">
                    <a16:creationId xmlns:a16="http://schemas.microsoft.com/office/drawing/2014/main" id="{8D6C936D-D6CD-428A-D87B-EE3C4B8F87E3}"/>
                  </a:ext>
                </a:extLst>
              </p:cNvPr>
              <p:cNvSpPr/>
              <p:nvPr/>
            </p:nvSpPr>
            <p:spPr>
              <a:xfrm>
                <a:off x="8827459" y="3453811"/>
                <a:ext cx="57" cy="74817"/>
              </a:xfrm>
              <a:custGeom>
                <a:avLst/>
                <a:gdLst>
                  <a:gd name="connsiteX0" fmla="*/ 64 w 57"/>
                  <a:gd name="connsiteY0" fmla="*/ 74824 h 74817"/>
                  <a:gd name="connsiteX1" fmla="*/ 6 w 57"/>
                  <a:gd name="connsiteY1" fmla="*/ 74824 h 74817"/>
                  <a:gd name="connsiteX2" fmla="*/ 6 w 57"/>
                  <a:gd name="connsiteY2" fmla="*/ 6 h 748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4817">
                    <a:moveTo>
                      <a:pt x="64" y="74824"/>
                    </a:moveTo>
                    <a:lnTo>
                      <a:pt x="6" y="748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Freeform: Shape 13">
                <a:extLst>
                  <a:ext uri="{FF2B5EF4-FFF2-40B4-BE49-F238E27FC236}">
                    <a16:creationId xmlns:a16="http://schemas.microsoft.com/office/drawing/2014/main" id="{5C325654-95EF-419F-252A-BC7ABE6B03F5}"/>
                  </a:ext>
                </a:extLst>
              </p:cNvPr>
              <p:cNvSpPr/>
              <p:nvPr/>
            </p:nvSpPr>
            <p:spPr>
              <a:xfrm>
                <a:off x="9376157" y="2297723"/>
                <a:ext cx="5783" cy="79346"/>
              </a:xfrm>
              <a:custGeom>
                <a:avLst/>
                <a:gdLst>
                  <a:gd name="connsiteX0" fmla="*/ 6 w 5783"/>
                  <a:gd name="connsiteY0" fmla="*/ 6 h 79346"/>
                  <a:gd name="connsiteX1" fmla="*/ 6 w 5783"/>
                  <a:gd name="connsiteY1" fmla="*/ 6 h 79346"/>
                  <a:gd name="connsiteX2" fmla="*/ 6 w 5783"/>
                  <a:gd name="connsiteY2" fmla="*/ 79352 h 793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9346">
                    <a:moveTo>
                      <a:pt x="6" y="6"/>
                    </a:moveTo>
                    <a:lnTo>
                      <a:pt x="6" y="6"/>
                    </a:lnTo>
                    <a:lnTo>
                      <a:pt x="6" y="7935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Freeform: Shape 14">
                <a:extLst>
                  <a:ext uri="{FF2B5EF4-FFF2-40B4-BE49-F238E27FC236}">
                    <a16:creationId xmlns:a16="http://schemas.microsoft.com/office/drawing/2014/main" id="{ABA4450F-57A2-9A0E-1168-DF46D84BC7D5}"/>
                  </a:ext>
                </a:extLst>
              </p:cNvPr>
              <p:cNvSpPr/>
              <p:nvPr/>
            </p:nvSpPr>
            <p:spPr>
              <a:xfrm>
                <a:off x="8827575" y="3687923"/>
                <a:ext cx="57" cy="38617"/>
              </a:xfrm>
              <a:custGeom>
                <a:avLst/>
                <a:gdLst>
                  <a:gd name="connsiteX0" fmla="*/ 64 w 57"/>
                  <a:gd name="connsiteY0" fmla="*/ 6 h 38617"/>
                  <a:gd name="connsiteX1" fmla="*/ 6 w 57"/>
                  <a:gd name="connsiteY1" fmla="*/ 6 h 38617"/>
                  <a:gd name="connsiteX2" fmla="*/ 6 w 57"/>
                  <a:gd name="connsiteY2" fmla="*/ 38624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38617">
                    <a:moveTo>
                      <a:pt x="64" y="6"/>
                    </a:moveTo>
                    <a:lnTo>
                      <a:pt x="6" y="6"/>
                    </a:lnTo>
                    <a:lnTo>
                      <a:pt x="6" y="386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Freeform: Shape 15">
                <a:extLst>
                  <a:ext uri="{FF2B5EF4-FFF2-40B4-BE49-F238E27FC236}">
                    <a16:creationId xmlns:a16="http://schemas.microsoft.com/office/drawing/2014/main" id="{3ED564EF-1D51-EAAC-EB85-D7015AD73EBC}"/>
                  </a:ext>
                </a:extLst>
              </p:cNvPr>
              <p:cNvSpPr/>
              <p:nvPr/>
            </p:nvSpPr>
            <p:spPr>
              <a:xfrm>
                <a:off x="5528817" y="5464288"/>
                <a:ext cx="560530" cy="57929"/>
              </a:xfrm>
              <a:custGeom>
                <a:avLst/>
                <a:gdLst>
                  <a:gd name="connsiteX0" fmla="*/ 560537 w 560530"/>
                  <a:gd name="connsiteY0" fmla="*/ 6 h 57929"/>
                  <a:gd name="connsiteX1" fmla="*/ 6 w 560530"/>
                  <a:gd name="connsiteY1" fmla="*/ 6 h 57929"/>
                  <a:gd name="connsiteX2" fmla="*/ 6 w 560530"/>
                  <a:gd name="connsiteY2" fmla="*/ 57936 h 579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60530" h="57929">
                    <a:moveTo>
                      <a:pt x="560537" y="6"/>
                    </a:moveTo>
                    <a:lnTo>
                      <a:pt x="6" y="6"/>
                    </a:lnTo>
                    <a:lnTo>
                      <a:pt x="6" y="5793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Freeform: Shape 16">
                <a:extLst>
                  <a:ext uri="{FF2B5EF4-FFF2-40B4-BE49-F238E27FC236}">
                    <a16:creationId xmlns:a16="http://schemas.microsoft.com/office/drawing/2014/main" id="{06B8EEB0-3F38-6FED-FC2E-0ECFB63C9DD6}"/>
                  </a:ext>
                </a:extLst>
              </p:cNvPr>
              <p:cNvSpPr/>
              <p:nvPr/>
            </p:nvSpPr>
            <p:spPr>
              <a:xfrm>
                <a:off x="5528725" y="5068471"/>
                <a:ext cx="28" cy="156882"/>
              </a:xfrm>
              <a:custGeom>
                <a:avLst/>
                <a:gdLst>
                  <a:gd name="connsiteX0" fmla="*/ 35 w 28"/>
                  <a:gd name="connsiteY0" fmla="*/ 6 h 156882"/>
                  <a:gd name="connsiteX1" fmla="*/ 6 w 28"/>
                  <a:gd name="connsiteY1" fmla="*/ 6 h 156882"/>
                  <a:gd name="connsiteX2" fmla="*/ 6 w 28"/>
                  <a:gd name="connsiteY2" fmla="*/ 156888 h 1568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156882">
                    <a:moveTo>
                      <a:pt x="35" y="6"/>
                    </a:moveTo>
                    <a:lnTo>
                      <a:pt x="6" y="6"/>
                    </a:lnTo>
                    <a:lnTo>
                      <a:pt x="6" y="15688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Freeform: Shape 17">
                <a:extLst>
                  <a:ext uri="{FF2B5EF4-FFF2-40B4-BE49-F238E27FC236}">
                    <a16:creationId xmlns:a16="http://schemas.microsoft.com/office/drawing/2014/main" id="{7B4CF103-3E7F-263E-E912-15A27939CE8B}"/>
                  </a:ext>
                </a:extLst>
              </p:cNvPr>
              <p:cNvSpPr/>
              <p:nvPr/>
            </p:nvSpPr>
            <p:spPr>
              <a:xfrm>
                <a:off x="8827459" y="1443334"/>
                <a:ext cx="57" cy="72405"/>
              </a:xfrm>
              <a:custGeom>
                <a:avLst/>
                <a:gdLst>
                  <a:gd name="connsiteX0" fmla="*/ 64 w 57"/>
                  <a:gd name="connsiteY0" fmla="*/ 72412 h 72405"/>
                  <a:gd name="connsiteX1" fmla="*/ 6 w 57"/>
                  <a:gd name="connsiteY1" fmla="*/ 72412 h 72405"/>
                  <a:gd name="connsiteX2" fmla="*/ 6 w 57"/>
                  <a:gd name="connsiteY2" fmla="*/ 6 h 724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2405">
                    <a:moveTo>
                      <a:pt x="64" y="72412"/>
                    </a:moveTo>
                    <a:lnTo>
                      <a:pt x="6" y="7241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Freeform: Shape 18">
                <a:extLst>
                  <a:ext uri="{FF2B5EF4-FFF2-40B4-BE49-F238E27FC236}">
                    <a16:creationId xmlns:a16="http://schemas.microsoft.com/office/drawing/2014/main" id="{95B37E26-10B9-3DCD-2788-FE4B6658A8A4}"/>
                  </a:ext>
                </a:extLst>
              </p:cNvPr>
              <p:cNvSpPr/>
              <p:nvPr/>
            </p:nvSpPr>
            <p:spPr>
              <a:xfrm>
                <a:off x="7712423" y="366893"/>
                <a:ext cx="545169" cy="38616"/>
              </a:xfrm>
              <a:custGeom>
                <a:avLst/>
                <a:gdLst>
                  <a:gd name="connsiteX0" fmla="*/ 545176 w 545169"/>
                  <a:gd name="connsiteY0" fmla="*/ 6 h 38616"/>
                  <a:gd name="connsiteX1" fmla="*/ 6 w 545169"/>
                  <a:gd name="connsiteY1" fmla="*/ 6 h 38616"/>
                  <a:gd name="connsiteX2" fmla="*/ 6 w 545169"/>
                  <a:gd name="connsiteY2" fmla="*/ 38622 h 3861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5169" h="38616">
                    <a:moveTo>
                      <a:pt x="545176" y="6"/>
                    </a:moveTo>
                    <a:lnTo>
                      <a:pt x="6" y="6"/>
                    </a:lnTo>
                    <a:lnTo>
                      <a:pt x="6" y="3862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Freeform: Shape 19">
                <a:extLst>
                  <a:ext uri="{FF2B5EF4-FFF2-40B4-BE49-F238E27FC236}">
                    <a16:creationId xmlns:a16="http://schemas.microsoft.com/office/drawing/2014/main" id="{8196307C-615A-1875-6A75-7AE7281BB099}"/>
                  </a:ext>
                </a:extLst>
              </p:cNvPr>
              <p:cNvSpPr/>
              <p:nvPr/>
            </p:nvSpPr>
            <p:spPr>
              <a:xfrm>
                <a:off x="7162973" y="347585"/>
                <a:ext cx="549449" cy="57924"/>
              </a:xfrm>
              <a:custGeom>
                <a:avLst/>
                <a:gdLst>
                  <a:gd name="connsiteX0" fmla="*/ 549456 w 549449"/>
                  <a:gd name="connsiteY0" fmla="*/ 57931 h 57924"/>
                  <a:gd name="connsiteX1" fmla="*/ 6 w 549449"/>
                  <a:gd name="connsiteY1" fmla="*/ 57931 h 57924"/>
                  <a:gd name="connsiteX2" fmla="*/ 6 w 549449"/>
                  <a:gd name="connsiteY2" fmla="*/ 6 h 5792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9449" h="57924">
                    <a:moveTo>
                      <a:pt x="549456" y="57931"/>
                    </a:moveTo>
                    <a:lnTo>
                      <a:pt x="6" y="5793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Freeform: Shape 20">
                <a:extLst>
                  <a:ext uri="{FF2B5EF4-FFF2-40B4-BE49-F238E27FC236}">
                    <a16:creationId xmlns:a16="http://schemas.microsoft.com/office/drawing/2014/main" id="{18D2DBE7-F108-C126-7458-1D3ED4E21ED8}"/>
                  </a:ext>
                </a:extLst>
              </p:cNvPr>
              <p:cNvSpPr/>
              <p:nvPr/>
            </p:nvSpPr>
            <p:spPr>
              <a:xfrm>
                <a:off x="8827575" y="1641240"/>
                <a:ext cx="546846" cy="38617"/>
              </a:xfrm>
              <a:custGeom>
                <a:avLst/>
                <a:gdLst>
                  <a:gd name="connsiteX0" fmla="*/ 546853 w 546846"/>
                  <a:gd name="connsiteY0" fmla="*/ 38624 h 38617"/>
                  <a:gd name="connsiteX1" fmla="*/ 6 w 546846"/>
                  <a:gd name="connsiteY1" fmla="*/ 38624 h 38617"/>
                  <a:gd name="connsiteX2" fmla="*/ 6 w 546846"/>
                  <a:gd name="connsiteY2" fmla="*/ 6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6846" h="38617">
                    <a:moveTo>
                      <a:pt x="546853" y="38624"/>
                    </a:moveTo>
                    <a:lnTo>
                      <a:pt x="6" y="386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Freeform: Shape 21">
                <a:extLst>
                  <a:ext uri="{FF2B5EF4-FFF2-40B4-BE49-F238E27FC236}">
                    <a16:creationId xmlns:a16="http://schemas.microsoft.com/office/drawing/2014/main" id="{203CAD3F-B4B5-C308-4B9F-32D7113670F7}"/>
                  </a:ext>
                </a:extLst>
              </p:cNvPr>
              <p:cNvSpPr/>
              <p:nvPr/>
            </p:nvSpPr>
            <p:spPr>
              <a:xfrm>
                <a:off x="8828442" y="1969551"/>
                <a:ext cx="547599" cy="96604"/>
              </a:xfrm>
              <a:custGeom>
                <a:avLst/>
                <a:gdLst>
                  <a:gd name="connsiteX0" fmla="*/ 547605 w 547599"/>
                  <a:gd name="connsiteY0" fmla="*/ 96611 h 96604"/>
                  <a:gd name="connsiteX1" fmla="*/ 6 w 547599"/>
                  <a:gd name="connsiteY1" fmla="*/ 96611 h 96604"/>
                  <a:gd name="connsiteX2" fmla="*/ 6 w 547599"/>
                  <a:gd name="connsiteY2" fmla="*/ 6 h 966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7599" h="96604">
                    <a:moveTo>
                      <a:pt x="547605" y="96611"/>
                    </a:moveTo>
                    <a:lnTo>
                      <a:pt x="6" y="9661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Freeform: Shape 22">
                <a:extLst>
                  <a:ext uri="{FF2B5EF4-FFF2-40B4-BE49-F238E27FC236}">
                    <a16:creationId xmlns:a16="http://schemas.microsoft.com/office/drawing/2014/main" id="{F51E3032-DC2E-C367-ED72-97879E2675A7}"/>
                  </a:ext>
                </a:extLst>
              </p:cNvPr>
              <p:cNvSpPr/>
              <p:nvPr/>
            </p:nvSpPr>
            <p:spPr>
              <a:xfrm>
                <a:off x="5528725" y="5695989"/>
                <a:ext cx="5783" cy="142399"/>
              </a:xfrm>
              <a:custGeom>
                <a:avLst/>
                <a:gdLst>
                  <a:gd name="connsiteX0" fmla="*/ 6 w 5783"/>
                  <a:gd name="connsiteY0" fmla="*/ 6 h 142399"/>
                  <a:gd name="connsiteX1" fmla="*/ 6 w 5783"/>
                  <a:gd name="connsiteY1" fmla="*/ 6 h 142399"/>
                  <a:gd name="connsiteX2" fmla="*/ 6 w 5783"/>
                  <a:gd name="connsiteY2" fmla="*/ 142406 h 1423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142399">
                    <a:moveTo>
                      <a:pt x="6" y="6"/>
                    </a:moveTo>
                    <a:lnTo>
                      <a:pt x="6" y="6"/>
                    </a:lnTo>
                    <a:lnTo>
                      <a:pt x="6" y="14240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Freeform: Shape 23">
                <a:extLst>
                  <a:ext uri="{FF2B5EF4-FFF2-40B4-BE49-F238E27FC236}">
                    <a16:creationId xmlns:a16="http://schemas.microsoft.com/office/drawing/2014/main" id="{E7DBE6AD-836C-86EA-A654-0F4EC9E20174}"/>
                  </a:ext>
                </a:extLst>
              </p:cNvPr>
              <p:cNvSpPr/>
              <p:nvPr/>
            </p:nvSpPr>
            <p:spPr>
              <a:xfrm>
                <a:off x="138006" y="419991"/>
                <a:ext cx="3915364" cy="372644"/>
              </a:xfrm>
              <a:custGeom>
                <a:avLst/>
                <a:gdLst>
                  <a:gd name="connsiteX0" fmla="*/ 3915371 w 3915364"/>
                  <a:gd name="connsiteY0" fmla="*/ 6 h 372644"/>
                  <a:gd name="connsiteX1" fmla="*/ 6 w 3915364"/>
                  <a:gd name="connsiteY1" fmla="*/ 6 h 372644"/>
                  <a:gd name="connsiteX2" fmla="*/ 6 w 3915364"/>
                  <a:gd name="connsiteY2" fmla="*/ 372651 h 37264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3915364" h="372644">
                    <a:moveTo>
                      <a:pt x="3915371" y="6"/>
                    </a:moveTo>
                    <a:lnTo>
                      <a:pt x="6" y="6"/>
                    </a:lnTo>
                    <a:lnTo>
                      <a:pt x="6" y="372651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Freeform: Shape 24">
                <a:extLst>
                  <a:ext uri="{FF2B5EF4-FFF2-40B4-BE49-F238E27FC236}">
                    <a16:creationId xmlns:a16="http://schemas.microsoft.com/office/drawing/2014/main" id="{97647F52-9626-0A0C-FAB5-08A06748F07B}"/>
                  </a:ext>
                </a:extLst>
              </p:cNvPr>
              <p:cNvSpPr/>
              <p:nvPr/>
            </p:nvSpPr>
            <p:spPr>
              <a:xfrm>
                <a:off x="6025901" y="521359"/>
                <a:ext cx="544764" cy="57924"/>
              </a:xfrm>
              <a:custGeom>
                <a:avLst/>
                <a:gdLst>
                  <a:gd name="connsiteX0" fmla="*/ 544771 w 544764"/>
                  <a:gd name="connsiteY0" fmla="*/ 6 h 57924"/>
                  <a:gd name="connsiteX1" fmla="*/ 6 w 544764"/>
                  <a:gd name="connsiteY1" fmla="*/ 6 h 57924"/>
                  <a:gd name="connsiteX2" fmla="*/ 6 w 544764"/>
                  <a:gd name="connsiteY2" fmla="*/ 57931 h 5792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4764" h="57924">
                    <a:moveTo>
                      <a:pt x="544771" y="6"/>
                    </a:moveTo>
                    <a:lnTo>
                      <a:pt x="6" y="6"/>
                    </a:lnTo>
                    <a:lnTo>
                      <a:pt x="6" y="57931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Freeform: Shape 25">
                <a:extLst>
                  <a:ext uri="{FF2B5EF4-FFF2-40B4-BE49-F238E27FC236}">
                    <a16:creationId xmlns:a16="http://schemas.microsoft.com/office/drawing/2014/main" id="{3F058E9A-1FEB-9E37-8DD3-CA784E89336E}"/>
                  </a:ext>
                </a:extLst>
              </p:cNvPr>
              <p:cNvSpPr/>
              <p:nvPr/>
            </p:nvSpPr>
            <p:spPr>
              <a:xfrm>
                <a:off x="5528846" y="5580141"/>
                <a:ext cx="1123601" cy="38617"/>
              </a:xfrm>
              <a:custGeom>
                <a:avLst/>
                <a:gdLst>
                  <a:gd name="connsiteX0" fmla="*/ 1123607 w 1123601"/>
                  <a:gd name="connsiteY0" fmla="*/ 38624 h 38617"/>
                  <a:gd name="connsiteX1" fmla="*/ 6 w 1123601"/>
                  <a:gd name="connsiteY1" fmla="*/ 38624 h 38617"/>
                  <a:gd name="connsiteX2" fmla="*/ 6 w 1123601"/>
                  <a:gd name="connsiteY2" fmla="*/ 6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23601" h="38617">
                    <a:moveTo>
                      <a:pt x="1123607" y="38624"/>
                    </a:moveTo>
                    <a:lnTo>
                      <a:pt x="6" y="386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Freeform: Shape 26">
                <a:extLst>
                  <a:ext uri="{FF2B5EF4-FFF2-40B4-BE49-F238E27FC236}">
                    <a16:creationId xmlns:a16="http://schemas.microsoft.com/office/drawing/2014/main" id="{E4DAE5DA-9436-487A-BA2F-8E30491A7052}"/>
                  </a:ext>
                </a:extLst>
              </p:cNvPr>
              <p:cNvSpPr/>
              <p:nvPr/>
            </p:nvSpPr>
            <p:spPr>
              <a:xfrm>
                <a:off x="5528690" y="4846424"/>
                <a:ext cx="6" cy="369270"/>
              </a:xfrm>
              <a:custGeom>
                <a:avLst/>
                <a:gdLst>
                  <a:gd name="connsiteX0" fmla="*/ 12 w 6"/>
                  <a:gd name="connsiteY0" fmla="*/ 6 h 369270"/>
                  <a:gd name="connsiteX1" fmla="*/ 6 w 6"/>
                  <a:gd name="connsiteY1" fmla="*/ 6 h 369270"/>
                  <a:gd name="connsiteX2" fmla="*/ 6 w 6"/>
                  <a:gd name="connsiteY2" fmla="*/ 369277 h 369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369270">
                    <a:moveTo>
                      <a:pt x="12" y="6"/>
                    </a:moveTo>
                    <a:lnTo>
                      <a:pt x="6" y="6"/>
                    </a:lnTo>
                    <a:lnTo>
                      <a:pt x="6" y="369277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Freeform: Shape 27">
                <a:extLst>
                  <a:ext uri="{FF2B5EF4-FFF2-40B4-BE49-F238E27FC236}">
                    <a16:creationId xmlns:a16="http://schemas.microsoft.com/office/drawing/2014/main" id="{020F5728-CAE5-7AD6-42CA-7B0C9FD623E7}"/>
                  </a:ext>
                </a:extLst>
              </p:cNvPr>
              <p:cNvSpPr/>
              <p:nvPr/>
            </p:nvSpPr>
            <p:spPr>
              <a:xfrm>
                <a:off x="6025901" y="579284"/>
                <a:ext cx="551705" cy="57925"/>
              </a:xfrm>
              <a:custGeom>
                <a:avLst/>
                <a:gdLst>
                  <a:gd name="connsiteX0" fmla="*/ 551711 w 551705"/>
                  <a:gd name="connsiteY0" fmla="*/ 57931 h 57925"/>
                  <a:gd name="connsiteX1" fmla="*/ 6 w 551705"/>
                  <a:gd name="connsiteY1" fmla="*/ 57931 h 57925"/>
                  <a:gd name="connsiteX2" fmla="*/ 6 w 551705"/>
                  <a:gd name="connsiteY2" fmla="*/ 6 h 579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51705" h="57925">
                    <a:moveTo>
                      <a:pt x="551711" y="57931"/>
                    </a:moveTo>
                    <a:lnTo>
                      <a:pt x="6" y="5793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Freeform: Shape 28">
                <a:extLst>
                  <a:ext uri="{FF2B5EF4-FFF2-40B4-BE49-F238E27FC236}">
                    <a16:creationId xmlns:a16="http://schemas.microsoft.com/office/drawing/2014/main" id="{A13D8581-FFC7-9169-CDAD-3B22B714B359}"/>
                  </a:ext>
                </a:extLst>
              </p:cNvPr>
              <p:cNvSpPr/>
              <p:nvPr/>
            </p:nvSpPr>
            <p:spPr>
              <a:xfrm>
                <a:off x="8827517" y="1583317"/>
                <a:ext cx="57" cy="57923"/>
              </a:xfrm>
              <a:custGeom>
                <a:avLst/>
                <a:gdLst>
                  <a:gd name="connsiteX0" fmla="*/ 64 w 57"/>
                  <a:gd name="connsiteY0" fmla="*/ 57929 h 57923"/>
                  <a:gd name="connsiteX1" fmla="*/ 6 w 57"/>
                  <a:gd name="connsiteY1" fmla="*/ 57929 h 57923"/>
                  <a:gd name="connsiteX2" fmla="*/ 6 w 57"/>
                  <a:gd name="connsiteY2" fmla="*/ 6 h 57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57923">
                    <a:moveTo>
                      <a:pt x="64" y="57929"/>
                    </a:moveTo>
                    <a:lnTo>
                      <a:pt x="6" y="57929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Freeform: Shape 29">
                <a:extLst>
                  <a:ext uri="{FF2B5EF4-FFF2-40B4-BE49-F238E27FC236}">
                    <a16:creationId xmlns:a16="http://schemas.microsoft.com/office/drawing/2014/main" id="{F4BCB4A1-EDDC-40F6-CD02-8E68CF6A6BA2}"/>
                  </a:ext>
                </a:extLst>
              </p:cNvPr>
              <p:cNvSpPr/>
              <p:nvPr/>
            </p:nvSpPr>
            <p:spPr>
              <a:xfrm>
                <a:off x="8280727" y="1863322"/>
                <a:ext cx="547657" cy="788304"/>
              </a:xfrm>
              <a:custGeom>
                <a:avLst/>
                <a:gdLst>
                  <a:gd name="connsiteX0" fmla="*/ 547663 w 547657"/>
                  <a:gd name="connsiteY0" fmla="*/ 6 h 788304"/>
                  <a:gd name="connsiteX1" fmla="*/ 6 w 547657"/>
                  <a:gd name="connsiteY1" fmla="*/ 6 h 788304"/>
                  <a:gd name="connsiteX2" fmla="*/ 6 w 547657"/>
                  <a:gd name="connsiteY2" fmla="*/ 788310 h 7883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7657" h="788304">
                    <a:moveTo>
                      <a:pt x="547663" y="6"/>
                    </a:moveTo>
                    <a:lnTo>
                      <a:pt x="6" y="6"/>
                    </a:lnTo>
                    <a:lnTo>
                      <a:pt x="6" y="788310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Freeform: Shape 30">
                <a:extLst>
                  <a:ext uri="{FF2B5EF4-FFF2-40B4-BE49-F238E27FC236}">
                    <a16:creationId xmlns:a16="http://schemas.microsoft.com/office/drawing/2014/main" id="{CCDED37B-1049-0F18-4794-FE145736CD8C}"/>
                  </a:ext>
                </a:extLst>
              </p:cNvPr>
              <p:cNvSpPr/>
              <p:nvPr/>
            </p:nvSpPr>
            <p:spPr>
              <a:xfrm>
                <a:off x="9376157" y="2377069"/>
                <a:ext cx="57" cy="79346"/>
              </a:xfrm>
              <a:custGeom>
                <a:avLst/>
                <a:gdLst>
                  <a:gd name="connsiteX0" fmla="*/ 64 w 57"/>
                  <a:gd name="connsiteY0" fmla="*/ 79352 h 79346"/>
                  <a:gd name="connsiteX1" fmla="*/ 6 w 57"/>
                  <a:gd name="connsiteY1" fmla="*/ 79352 h 79346"/>
                  <a:gd name="connsiteX2" fmla="*/ 6 w 57"/>
                  <a:gd name="connsiteY2" fmla="*/ 6 h 793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9346">
                    <a:moveTo>
                      <a:pt x="64" y="79352"/>
                    </a:moveTo>
                    <a:lnTo>
                      <a:pt x="6" y="7935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Freeform: Shape 31">
                <a:extLst>
                  <a:ext uri="{FF2B5EF4-FFF2-40B4-BE49-F238E27FC236}">
                    <a16:creationId xmlns:a16="http://schemas.microsoft.com/office/drawing/2014/main" id="{BD8EE998-4970-A5B9-97E1-EFFD4C1DD902}"/>
                  </a:ext>
                </a:extLst>
              </p:cNvPr>
              <p:cNvSpPr/>
              <p:nvPr/>
            </p:nvSpPr>
            <p:spPr>
              <a:xfrm>
                <a:off x="6084490" y="5193977"/>
                <a:ext cx="1686752" cy="38612"/>
              </a:xfrm>
              <a:custGeom>
                <a:avLst/>
                <a:gdLst>
                  <a:gd name="connsiteX0" fmla="*/ 1686759 w 1686752"/>
                  <a:gd name="connsiteY0" fmla="*/ 38618 h 38612"/>
                  <a:gd name="connsiteX1" fmla="*/ 6 w 1686752"/>
                  <a:gd name="connsiteY1" fmla="*/ 38618 h 38612"/>
                  <a:gd name="connsiteX2" fmla="*/ 6 w 1686752"/>
                  <a:gd name="connsiteY2" fmla="*/ 6 h 386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86752" h="38612">
                    <a:moveTo>
                      <a:pt x="1686759" y="38618"/>
                    </a:moveTo>
                    <a:lnTo>
                      <a:pt x="6" y="38618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Freeform: Shape 32">
                <a:extLst>
                  <a:ext uri="{FF2B5EF4-FFF2-40B4-BE49-F238E27FC236}">
                    <a16:creationId xmlns:a16="http://schemas.microsoft.com/office/drawing/2014/main" id="{1C96FA97-655D-E43C-6C6B-66B68C29AE0A}"/>
                  </a:ext>
                </a:extLst>
              </p:cNvPr>
              <p:cNvSpPr/>
              <p:nvPr/>
            </p:nvSpPr>
            <p:spPr>
              <a:xfrm>
                <a:off x="5528649" y="4691959"/>
                <a:ext cx="5783" cy="150242"/>
              </a:xfrm>
              <a:custGeom>
                <a:avLst/>
                <a:gdLst>
                  <a:gd name="connsiteX0" fmla="*/ 6 w 5783"/>
                  <a:gd name="connsiteY0" fmla="*/ 6 h 150242"/>
                  <a:gd name="connsiteX1" fmla="*/ 6 w 5783"/>
                  <a:gd name="connsiteY1" fmla="*/ 6 h 150242"/>
                  <a:gd name="connsiteX2" fmla="*/ 6 w 5783"/>
                  <a:gd name="connsiteY2" fmla="*/ 150249 h 1502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150242">
                    <a:moveTo>
                      <a:pt x="6" y="6"/>
                    </a:moveTo>
                    <a:lnTo>
                      <a:pt x="6" y="6"/>
                    </a:lnTo>
                    <a:lnTo>
                      <a:pt x="6" y="150249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Freeform: Shape 33">
                <a:extLst>
                  <a:ext uri="{FF2B5EF4-FFF2-40B4-BE49-F238E27FC236}">
                    <a16:creationId xmlns:a16="http://schemas.microsoft.com/office/drawing/2014/main" id="{72B55140-D2E1-995D-9E5E-AECA829657CE}"/>
                  </a:ext>
                </a:extLst>
              </p:cNvPr>
              <p:cNvSpPr/>
              <p:nvPr/>
            </p:nvSpPr>
            <p:spPr>
              <a:xfrm>
                <a:off x="8827459" y="3377785"/>
                <a:ext cx="5783" cy="76026"/>
              </a:xfrm>
              <a:custGeom>
                <a:avLst/>
                <a:gdLst>
                  <a:gd name="connsiteX0" fmla="*/ 6 w 5783"/>
                  <a:gd name="connsiteY0" fmla="*/ 76032 h 76026"/>
                  <a:gd name="connsiteX1" fmla="*/ 6 w 5783"/>
                  <a:gd name="connsiteY1" fmla="*/ 76032 h 76026"/>
                  <a:gd name="connsiteX2" fmla="*/ 6 w 5783"/>
                  <a:gd name="connsiteY2" fmla="*/ 6 h 760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6026">
                    <a:moveTo>
                      <a:pt x="6" y="76032"/>
                    </a:moveTo>
                    <a:lnTo>
                      <a:pt x="6" y="7603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Freeform: Shape 34">
                <a:extLst>
                  <a:ext uri="{FF2B5EF4-FFF2-40B4-BE49-F238E27FC236}">
                    <a16:creationId xmlns:a16="http://schemas.microsoft.com/office/drawing/2014/main" id="{BC534169-7494-00D4-31FF-0B5B5B1D5F2D}"/>
                  </a:ext>
                </a:extLst>
              </p:cNvPr>
              <p:cNvSpPr/>
              <p:nvPr/>
            </p:nvSpPr>
            <p:spPr>
              <a:xfrm>
                <a:off x="8827459" y="1293693"/>
                <a:ext cx="5783" cy="74817"/>
              </a:xfrm>
              <a:custGeom>
                <a:avLst/>
                <a:gdLst>
                  <a:gd name="connsiteX0" fmla="*/ 6 w 5783"/>
                  <a:gd name="connsiteY0" fmla="*/ 6 h 74817"/>
                  <a:gd name="connsiteX1" fmla="*/ 6 w 5783"/>
                  <a:gd name="connsiteY1" fmla="*/ 6 h 74817"/>
                  <a:gd name="connsiteX2" fmla="*/ 6 w 5783"/>
                  <a:gd name="connsiteY2" fmla="*/ 74824 h 748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4817">
                    <a:moveTo>
                      <a:pt x="6" y="6"/>
                    </a:moveTo>
                    <a:lnTo>
                      <a:pt x="6" y="6"/>
                    </a:lnTo>
                    <a:lnTo>
                      <a:pt x="6" y="748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Freeform: Shape 35">
                <a:extLst>
                  <a:ext uri="{FF2B5EF4-FFF2-40B4-BE49-F238E27FC236}">
                    <a16:creationId xmlns:a16="http://schemas.microsoft.com/office/drawing/2014/main" id="{BA3FFE7B-9E03-C3B6-3CA5-D3BC7044D27F}"/>
                  </a:ext>
                </a:extLst>
              </p:cNvPr>
              <p:cNvSpPr/>
              <p:nvPr/>
            </p:nvSpPr>
            <p:spPr>
              <a:xfrm>
                <a:off x="9373438" y="4305794"/>
                <a:ext cx="5783" cy="38611"/>
              </a:xfrm>
              <a:custGeom>
                <a:avLst/>
                <a:gdLst>
                  <a:gd name="connsiteX0" fmla="*/ 6 w 5783"/>
                  <a:gd name="connsiteY0" fmla="*/ 6 h 38611"/>
                  <a:gd name="connsiteX1" fmla="*/ 6 w 5783"/>
                  <a:gd name="connsiteY1" fmla="*/ 6 h 38611"/>
                  <a:gd name="connsiteX2" fmla="*/ 6 w 5783"/>
                  <a:gd name="connsiteY2" fmla="*/ 38618 h 386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1">
                    <a:moveTo>
                      <a:pt x="6" y="6"/>
                    </a:moveTo>
                    <a:lnTo>
                      <a:pt x="6" y="6"/>
                    </a:lnTo>
                    <a:lnTo>
                      <a:pt x="6" y="3861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Freeform: Shape 36">
                <a:extLst>
                  <a:ext uri="{FF2B5EF4-FFF2-40B4-BE49-F238E27FC236}">
                    <a16:creationId xmlns:a16="http://schemas.microsoft.com/office/drawing/2014/main" id="{30146F0D-AAD0-8339-660D-1A7424EFFF75}"/>
                  </a:ext>
                </a:extLst>
              </p:cNvPr>
              <p:cNvSpPr/>
              <p:nvPr/>
            </p:nvSpPr>
            <p:spPr>
              <a:xfrm>
                <a:off x="5528846" y="5541524"/>
                <a:ext cx="5" cy="38617"/>
              </a:xfrm>
              <a:custGeom>
                <a:avLst/>
                <a:gdLst>
                  <a:gd name="connsiteX0" fmla="*/ 12 w 5"/>
                  <a:gd name="connsiteY0" fmla="*/ 6 h 38617"/>
                  <a:gd name="connsiteX1" fmla="*/ 6 w 5"/>
                  <a:gd name="connsiteY1" fmla="*/ 6 h 38617"/>
                  <a:gd name="connsiteX2" fmla="*/ 6 w 5"/>
                  <a:gd name="connsiteY2" fmla="*/ 38624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" h="38617">
                    <a:moveTo>
                      <a:pt x="12" y="6"/>
                    </a:moveTo>
                    <a:lnTo>
                      <a:pt x="6" y="6"/>
                    </a:lnTo>
                    <a:lnTo>
                      <a:pt x="6" y="386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Freeform: Shape 37">
                <a:extLst>
                  <a:ext uri="{FF2B5EF4-FFF2-40B4-BE49-F238E27FC236}">
                    <a16:creationId xmlns:a16="http://schemas.microsoft.com/office/drawing/2014/main" id="{D0BBC223-F3B4-33D7-EEDD-9EADCEACD490}"/>
                  </a:ext>
                </a:extLst>
              </p:cNvPr>
              <p:cNvSpPr/>
              <p:nvPr/>
            </p:nvSpPr>
            <p:spPr>
              <a:xfrm>
                <a:off x="5154335" y="173809"/>
                <a:ext cx="1855717" cy="86887"/>
              </a:xfrm>
              <a:custGeom>
                <a:avLst/>
                <a:gdLst>
                  <a:gd name="connsiteX0" fmla="*/ 1855724 w 1855717"/>
                  <a:gd name="connsiteY0" fmla="*/ 6 h 86887"/>
                  <a:gd name="connsiteX1" fmla="*/ 6 w 1855717"/>
                  <a:gd name="connsiteY1" fmla="*/ 6 h 86887"/>
                  <a:gd name="connsiteX2" fmla="*/ 6 w 1855717"/>
                  <a:gd name="connsiteY2" fmla="*/ 86894 h 868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855717" h="86887">
                    <a:moveTo>
                      <a:pt x="1855724" y="6"/>
                    </a:moveTo>
                    <a:lnTo>
                      <a:pt x="6" y="6"/>
                    </a:lnTo>
                    <a:lnTo>
                      <a:pt x="6" y="8689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Freeform: Shape 38">
                <a:extLst>
                  <a:ext uri="{FF2B5EF4-FFF2-40B4-BE49-F238E27FC236}">
                    <a16:creationId xmlns:a16="http://schemas.microsoft.com/office/drawing/2014/main" id="{43618677-18EE-5ADF-AC2D-D44130CAD172}"/>
                  </a:ext>
                </a:extLst>
              </p:cNvPr>
              <p:cNvSpPr/>
              <p:nvPr/>
            </p:nvSpPr>
            <p:spPr>
              <a:xfrm>
                <a:off x="8827575" y="3610694"/>
                <a:ext cx="5783" cy="57923"/>
              </a:xfrm>
              <a:custGeom>
                <a:avLst/>
                <a:gdLst>
                  <a:gd name="connsiteX0" fmla="*/ 6 w 5783"/>
                  <a:gd name="connsiteY0" fmla="*/ 6 h 57923"/>
                  <a:gd name="connsiteX1" fmla="*/ 6 w 5783"/>
                  <a:gd name="connsiteY1" fmla="*/ 6 h 57923"/>
                  <a:gd name="connsiteX2" fmla="*/ 6 w 5783"/>
                  <a:gd name="connsiteY2" fmla="*/ 57930 h 57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57923">
                    <a:moveTo>
                      <a:pt x="6" y="6"/>
                    </a:moveTo>
                    <a:lnTo>
                      <a:pt x="6" y="6"/>
                    </a:lnTo>
                    <a:lnTo>
                      <a:pt x="6" y="57930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Freeform: Shape 39">
                <a:extLst>
                  <a:ext uri="{FF2B5EF4-FFF2-40B4-BE49-F238E27FC236}">
                    <a16:creationId xmlns:a16="http://schemas.microsoft.com/office/drawing/2014/main" id="{67894BA6-40E0-9BBE-E0D8-D89B60BC2251}"/>
                  </a:ext>
                </a:extLst>
              </p:cNvPr>
              <p:cNvSpPr/>
              <p:nvPr/>
            </p:nvSpPr>
            <p:spPr>
              <a:xfrm>
                <a:off x="138006" y="792636"/>
                <a:ext cx="4842026" cy="372642"/>
              </a:xfrm>
              <a:custGeom>
                <a:avLst/>
                <a:gdLst>
                  <a:gd name="connsiteX0" fmla="*/ 4842033 w 4842026"/>
                  <a:gd name="connsiteY0" fmla="*/ 372649 h 372642"/>
                  <a:gd name="connsiteX1" fmla="*/ 6 w 4842026"/>
                  <a:gd name="connsiteY1" fmla="*/ 372649 h 372642"/>
                  <a:gd name="connsiteX2" fmla="*/ 6 w 4842026"/>
                  <a:gd name="connsiteY2" fmla="*/ 6 h 3726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4842026" h="372642">
                    <a:moveTo>
                      <a:pt x="4842033" y="372649"/>
                    </a:moveTo>
                    <a:lnTo>
                      <a:pt x="6" y="372649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Freeform: Shape 40">
                <a:extLst>
                  <a:ext uri="{FF2B5EF4-FFF2-40B4-BE49-F238E27FC236}">
                    <a16:creationId xmlns:a16="http://schemas.microsoft.com/office/drawing/2014/main" id="{10CB65D4-2C3C-BE72-2A5D-79593DA913F8}"/>
                  </a:ext>
                </a:extLst>
              </p:cNvPr>
              <p:cNvSpPr/>
              <p:nvPr/>
            </p:nvSpPr>
            <p:spPr>
              <a:xfrm>
                <a:off x="8828442" y="1872940"/>
                <a:ext cx="547715" cy="96610"/>
              </a:xfrm>
              <a:custGeom>
                <a:avLst/>
                <a:gdLst>
                  <a:gd name="connsiteX0" fmla="*/ 547721 w 547715"/>
                  <a:gd name="connsiteY0" fmla="*/ 6 h 96610"/>
                  <a:gd name="connsiteX1" fmla="*/ 6 w 547715"/>
                  <a:gd name="connsiteY1" fmla="*/ 6 h 96610"/>
                  <a:gd name="connsiteX2" fmla="*/ 6 w 547715"/>
                  <a:gd name="connsiteY2" fmla="*/ 96617 h 966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7715" h="96610">
                    <a:moveTo>
                      <a:pt x="547721" y="6"/>
                    </a:moveTo>
                    <a:lnTo>
                      <a:pt x="6" y="6"/>
                    </a:lnTo>
                    <a:lnTo>
                      <a:pt x="6" y="96617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Freeform: Shape 41">
                <a:extLst>
                  <a:ext uri="{FF2B5EF4-FFF2-40B4-BE49-F238E27FC236}">
                    <a16:creationId xmlns:a16="http://schemas.microsoft.com/office/drawing/2014/main" id="{34F04677-AE11-8695-0290-5914703339D1}"/>
                  </a:ext>
                </a:extLst>
              </p:cNvPr>
              <p:cNvSpPr/>
              <p:nvPr/>
            </p:nvSpPr>
            <p:spPr>
              <a:xfrm>
                <a:off x="5528696" y="5838389"/>
                <a:ext cx="28" cy="257061"/>
              </a:xfrm>
              <a:custGeom>
                <a:avLst/>
                <a:gdLst>
                  <a:gd name="connsiteX0" fmla="*/ 35 w 28"/>
                  <a:gd name="connsiteY0" fmla="*/ 6 h 257061"/>
                  <a:gd name="connsiteX1" fmla="*/ 6 w 28"/>
                  <a:gd name="connsiteY1" fmla="*/ 6 h 257061"/>
                  <a:gd name="connsiteX2" fmla="*/ 6 w 28"/>
                  <a:gd name="connsiteY2" fmla="*/ 257068 h 25706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257061">
                    <a:moveTo>
                      <a:pt x="35" y="6"/>
                    </a:moveTo>
                    <a:lnTo>
                      <a:pt x="6" y="6"/>
                    </a:lnTo>
                    <a:lnTo>
                      <a:pt x="6" y="25706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Freeform: Shape 42">
                <a:extLst>
                  <a:ext uri="{FF2B5EF4-FFF2-40B4-BE49-F238E27FC236}">
                    <a16:creationId xmlns:a16="http://schemas.microsoft.com/office/drawing/2014/main" id="{7480627E-9699-1796-E4AF-149EC6B8B3E8}"/>
                  </a:ext>
                </a:extLst>
              </p:cNvPr>
              <p:cNvSpPr/>
              <p:nvPr/>
            </p:nvSpPr>
            <p:spPr>
              <a:xfrm>
                <a:off x="9373380" y="4218906"/>
                <a:ext cx="57" cy="67576"/>
              </a:xfrm>
              <a:custGeom>
                <a:avLst/>
                <a:gdLst>
                  <a:gd name="connsiteX0" fmla="*/ 64 w 57"/>
                  <a:gd name="connsiteY0" fmla="*/ 67582 h 67576"/>
                  <a:gd name="connsiteX1" fmla="*/ 6 w 57"/>
                  <a:gd name="connsiteY1" fmla="*/ 67582 h 67576"/>
                  <a:gd name="connsiteX2" fmla="*/ 6 w 57"/>
                  <a:gd name="connsiteY2" fmla="*/ 6 h 675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67576">
                    <a:moveTo>
                      <a:pt x="64" y="67582"/>
                    </a:moveTo>
                    <a:lnTo>
                      <a:pt x="6" y="6758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Freeform: Shape 43">
                <a:extLst>
                  <a:ext uri="{FF2B5EF4-FFF2-40B4-BE49-F238E27FC236}">
                    <a16:creationId xmlns:a16="http://schemas.microsoft.com/office/drawing/2014/main" id="{EF6449DC-D703-08EF-E2A6-0AE178DF2C2F}"/>
                  </a:ext>
                </a:extLst>
              </p:cNvPr>
              <p:cNvSpPr/>
              <p:nvPr/>
            </p:nvSpPr>
            <p:spPr>
              <a:xfrm>
                <a:off x="6577607" y="598592"/>
                <a:ext cx="5783" cy="38617"/>
              </a:xfrm>
              <a:custGeom>
                <a:avLst/>
                <a:gdLst>
                  <a:gd name="connsiteX0" fmla="*/ 6 w 5783"/>
                  <a:gd name="connsiteY0" fmla="*/ 6 h 38617"/>
                  <a:gd name="connsiteX1" fmla="*/ 6 w 5783"/>
                  <a:gd name="connsiteY1" fmla="*/ 6 h 38617"/>
                  <a:gd name="connsiteX2" fmla="*/ 6 w 5783"/>
                  <a:gd name="connsiteY2" fmla="*/ 38623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7">
                    <a:moveTo>
                      <a:pt x="6" y="6"/>
                    </a:moveTo>
                    <a:lnTo>
                      <a:pt x="6" y="6"/>
                    </a:lnTo>
                    <a:lnTo>
                      <a:pt x="6" y="38623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Freeform: Shape 44">
                <a:extLst>
                  <a:ext uri="{FF2B5EF4-FFF2-40B4-BE49-F238E27FC236}">
                    <a16:creationId xmlns:a16="http://schemas.microsoft.com/office/drawing/2014/main" id="{30AE64A1-D5BE-4932-5062-4317B1C81EC0}"/>
                  </a:ext>
                </a:extLst>
              </p:cNvPr>
              <p:cNvSpPr/>
              <p:nvPr/>
            </p:nvSpPr>
            <p:spPr>
              <a:xfrm>
                <a:off x="9376272" y="2717682"/>
                <a:ext cx="57" cy="111023"/>
              </a:xfrm>
              <a:custGeom>
                <a:avLst/>
                <a:gdLst>
                  <a:gd name="connsiteX0" fmla="*/ 64 w 57"/>
                  <a:gd name="connsiteY0" fmla="*/ 111030 h 111023"/>
                  <a:gd name="connsiteX1" fmla="*/ 6 w 57"/>
                  <a:gd name="connsiteY1" fmla="*/ 111030 h 111023"/>
                  <a:gd name="connsiteX2" fmla="*/ 6 w 57"/>
                  <a:gd name="connsiteY2" fmla="*/ 6 h 1110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111023">
                    <a:moveTo>
                      <a:pt x="64" y="111030"/>
                    </a:moveTo>
                    <a:lnTo>
                      <a:pt x="6" y="111030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Freeform: Shape 45">
                <a:extLst>
                  <a:ext uri="{FF2B5EF4-FFF2-40B4-BE49-F238E27FC236}">
                    <a16:creationId xmlns:a16="http://schemas.microsoft.com/office/drawing/2014/main" id="{DF4E2EC5-F442-EF54-C566-11D24960B156}"/>
                  </a:ext>
                </a:extLst>
              </p:cNvPr>
              <p:cNvSpPr/>
              <p:nvPr/>
            </p:nvSpPr>
            <p:spPr>
              <a:xfrm>
                <a:off x="5154335" y="260697"/>
                <a:ext cx="2008637" cy="86887"/>
              </a:xfrm>
              <a:custGeom>
                <a:avLst/>
                <a:gdLst>
                  <a:gd name="connsiteX0" fmla="*/ 2008644 w 2008637"/>
                  <a:gd name="connsiteY0" fmla="*/ 86894 h 86887"/>
                  <a:gd name="connsiteX1" fmla="*/ 6 w 2008637"/>
                  <a:gd name="connsiteY1" fmla="*/ 86894 h 86887"/>
                  <a:gd name="connsiteX2" fmla="*/ 6 w 2008637"/>
                  <a:gd name="connsiteY2" fmla="*/ 6 h 868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008637" h="86887">
                    <a:moveTo>
                      <a:pt x="2008644" y="86894"/>
                    </a:moveTo>
                    <a:lnTo>
                      <a:pt x="6" y="8689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Freeform: Shape 46">
                <a:extLst>
                  <a:ext uri="{FF2B5EF4-FFF2-40B4-BE49-F238E27FC236}">
                    <a16:creationId xmlns:a16="http://schemas.microsoft.com/office/drawing/2014/main" id="{E1391F84-6028-E435-B7B5-3AB7E1087101}"/>
                  </a:ext>
                </a:extLst>
              </p:cNvPr>
              <p:cNvSpPr/>
              <p:nvPr/>
            </p:nvSpPr>
            <p:spPr>
              <a:xfrm>
                <a:off x="8827575" y="3668617"/>
                <a:ext cx="5783" cy="57923"/>
              </a:xfrm>
              <a:custGeom>
                <a:avLst/>
                <a:gdLst>
                  <a:gd name="connsiteX0" fmla="*/ 6 w 5783"/>
                  <a:gd name="connsiteY0" fmla="*/ 57930 h 57923"/>
                  <a:gd name="connsiteX1" fmla="*/ 6 w 5783"/>
                  <a:gd name="connsiteY1" fmla="*/ 57930 h 57923"/>
                  <a:gd name="connsiteX2" fmla="*/ 6 w 5783"/>
                  <a:gd name="connsiteY2" fmla="*/ 6 h 57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57923">
                    <a:moveTo>
                      <a:pt x="6" y="57930"/>
                    </a:moveTo>
                    <a:lnTo>
                      <a:pt x="6" y="57930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Freeform: Shape 47">
                <a:extLst>
                  <a:ext uri="{FF2B5EF4-FFF2-40B4-BE49-F238E27FC236}">
                    <a16:creationId xmlns:a16="http://schemas.microsoft.com/office/drawing/2014/main" id="{3DC452AC-B7C6-327C-2F9C-39F32E4AA495}"/>
                  </a:ext>
                </a:extLst>
              </p:cNvPr>
              <p:cNvSpPr/>
              <p:nvPr/>
            </p:nvSpPr>
            <p:spPr>
              <a:xfrm>
                <a:off x="6084490" y="5155359"/>
                <a:ext cx="1105608" cy="38617"/>
              </a:xfrm>
              <a:custGeom>
                <a:avLst/>
                <a:gdLst>
                  <a:gd name="connsiteX0" fmla="*/ 1105615 w 1105608"/>
                  <a:gd name="connsiteY0" fmla="*/ 6 h 38617"/>
                  <a:gd name="connsiteX1" fmla="*/ 6 w 1105608"/>
                  <a:gd name="connsiteY1" fmla="*/ 6 h 38617"/>
                  <a:gd name="connsiteX2" fmla="*/ 6 w 1105608"/>
                  <a:gd name="connsiteY2" fmla="*/ 38624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05608" h="38617">
                    <a:moveTo>
                      <a:pt x="1105615" y="6"/>
                    </a:moveTo>
                    <a:lnTo>
                      <a:pt x="6" y="6"/>
                    </a:lnTo>
                    <a:lnTo>
                      <a:pt x="6" y="386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Freeform: Shape 48">
                <a:extLst>
                  <a:ext uri="{FF2B5EF4-FFF2-40B4-BE49-F238E27FC236}">
                    <a16:creationId xmlns:a16="http://schemas.microsoft.com/office/drawing/2014/main" id="{B8D7775F-65E7-8F6C-0755-7C8B63959039}"/>
                  </a:ext>
                </a:extLst>
              </p:cNvPr>
              <p:cNvSpPr/>
              <p:nvPr/>
            </p:nvSpPr>
            <p:spPr>
              <a:xfrm>
                <a:off x="5528759" y="6082148"/>
                <a:ext cx="554169" cy="38635"/>
              </a:xfrm>
              <a:custGeom>
                <a:avLst/>
                <a:gdLst>
                  <a:gd name="connsiteX0" fmla="*/ 554175 w 554169"/>
                  <a:gd name="connsiteY0" fmla="*/ 6 h 38635"/>
                  <a:gd name="connsiteX1" fmla="*/ 6 w 554169"/>
                  <a:gd name="connsiteY1" fmla="*/ 6 h 38635"/>
                  <a:gd name="connsiteX2" fmla="*/ 6 w 554169"/>
                  <a:gd name="connsiteY2" fmla="*/ 38641 h 38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54169" h="38635">
                    <a:moveTo>
                      <a:pt x="554175" y="6"/>
                    </a:moveTo>
                    <a:lnTo>
                      <a:pt x="6" y="6"/>
                    </a:lnTo>
                    <a:lnTo>
                      <a:pt x="6" y="38641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Freeform: Shape 49">
                <a:extLst>
                  <a:ext uri="{FF2B5EF4-FFF2-40B4-BE49-F238E27FC236}">
                    <a16:creationId xmlns:a16="http://schemas.microsoft.com/office/drawing/2014/main" id="{E24AA807-C531-B71D-7A08-2BFC4DCF71AF}"/>
                  </a:ext>
                </a:extLst>
              </p:cNvPr>
              <p:cNvSpPr/>
              <p:nvPr/>
            </p:nvSpPr>
            <p:spPr>
              <a:xfrm>
                <a:off x="9376272" y="2606658"/>
                <a:ext cx="5783" cy="111023"/>
              </a:xfrm>
              <a:custGeom>
                <a:avLst/>
                <a:gdLst>
                  <a:gd name="connsiteX0" fmla="*/ 6 w 5783"/>
                  <a:gd name="connsiteY0" fmla="*/ 6 h 111023"/>
                  <a:gd name="connsiteX1" fmla="*/ 6 w 5783"/>
                  <a:gd name="connsiteY1" fmla="*/ 6 h 111023"/>
                  <a:gd name="connsiteX2" fmla="*/ 6 w 5783"/>
                  <a:gd name="connsiteY2" fmla="*/ 111030 h 1110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111023">
                    <a:moveTo>
                      <a:pt x="6" y="6"/>
                    </a:moveTo>
                    <a:lnTo>
                      <a:pt x="6" y="6"/>
                    </a:lnTo>
                    <a:lnTo>
                      <a:pt x="6" y="111030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Freeform: Shape 50">
                <a:extLst>
                  <a:ext uri="{FF2B5EF4-FFF2-40B4-BE49-F238E27FC236}">
                    <a16:creationId xmlns:a16="http://schemas.microsoft.com/office/drawing/2014/main" id="{F0D1DF0E-4099-DC65-B0B0-83E9DB2CDC99}"/>
                  </a:ext>
                </a:extLst>
              </p:cNvPr>
              <p:cNvSpPr/>
              <p:nvPr/>
            </p:nvSpPr>
            <p:spPr>
              <a:xfrm>
                <a:off x="8827517" y="3456223"/>
                <a:ext cx="5783" cy="72406"/>
              </a:xfrm>
              <a:custGeom>
                <a:avLst/>
                <a:gdLst>
                  <a:gd name="connsiteX0" fmla="*/ 6 w 5783"/>
                  <a:gd name="connsiteY0" fmla="*/ 6 h 72406"/>
                  <a:gd name="connsiteX1" fmla="*/ 6 w 5783"/>
                  <a:gd name="connsiteY1" fmla="*/ 6 h 72406"/>
                  <a:gd name="connsiteX2" fmla="*/ 6 w 5783"/>
                  <a:gd name="connsiteY2" fmla="*/ 72412 h 7240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2406">
                    <a:moveTo>
                      <a:pt x="6" y="6"/>
                    </a:moveTo>
                    <a:lnTo>
                      <a:pt x="6" y="6"/>
                    </a:lnTo>
                    <a:lnTo>
                      <a:pt x="6" y="7241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Freeform: Shape 51">
                <a:extLst>
                  <a:ext uri="{FF2B5EF4-FFF2-40B4-BE49-F238E27FC236}">
                    <a16:creationId xmlns:a16="http://schemas.microsoft.com/office/drawing/2014/main" id="{453DF13E-E030-DE6E-8727-4176B4BEF04C}"/>
                  </a:ext>
                </a:extLst>
              </p:cNvPr>
              <p:cNvSpPr/>
              <p:nvPr/>
            </p:nvSpPr>
            <p:spPr>
              <a:xfrm>
                <a:off x="8827459" y="3377785"/>
                <a:ext cx="5783" cy="277558"/>
              </a:xfrm>
              <a:custGeom>
                <a:avLst/>
                <a:gdLst>
                  <a:gd name="connsiteX0" fmla="*/ 6 w 5783"/>
                  <a:gd name="connsiteY0" fmla="*/ 6 h 277558"/>
                  <a:gd name="connsiteX1" fmla="*/ 6 w 5783"/>
                  <a:gd name="connsiteY1" fmla="*/ 6 h 277558"/>
                  <a:gd name="connsiteX2" fmla="*/ 6 w 5783"/>
                  <a:gd name="connsiteY2" fmla="*/ 277565 h 27755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277558">
                    <a:moveTo>
                      <a:pt x="6" y="6"/>
                    </a:moveTo>
                    <a:lnTo>
                      <a:pt x="6" y="6"/>
                    </a:lnTo>
                    <a:lnTo>
                      <a:pt x="6" y="277565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Freeform: Shape 52">
                <a:extLst>
                  <a:ext uri="{FF2B5EF4-FFF2-40B4-BE49-F238E27FC236}">
                    <a16:creationId xmlns:a16="http://schemas.microsoft.com/office/drawing/2014/main" id="{216A5FE4-4E35-A35F-66F5-3D28B5621C2F}"/>
                  </a:ext>
                </a:extLst>
              </p:cNvPr>
              <p:cNvSpPr/>
              <p:nvPr/>
            </p:nvSpPr>
            <p:spPr>
              <a:xfrm>
                <a:off x="4980073" y="1577498"/>
                <a:ext cx="28" cy="747205"/>
              </a:xfrm>
              <a:custGeom>
                <a:avLst/>
                <a:gdLst>
                  <a:gd name="connsiteX0" fmla="*/ 35 w 28"/>
                  <a:gd name="connsiteY0" fmla="*/ 747211 h 747205"/>
                  <a:gd name="connsiteX1" fmla="*/ 6 w 28"/>
                  <a:gd name="connsiteY1" fmla="*/ 747211 h 747205"/>
                  <a:gd name="connsiteX2" fmla="*/ 6 w 28"/>
                  <a:gd name="connsiteY2" fmla="*/ 6 h 7472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747205">
                    <a:moveTo>
                      <a:pt x="35" y="747211"/>
                    </a:moveTo>
                    <a:lnTo>
                      <a:pt x="6" y="74721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Freeform: Shape 53">
                <a:extLst>
                  <a:ext uri="{FF2B5EF4-FFF2-40B4-BE49-F238E27FC236}">
                    <a16:creationId xmlns:a16="http://schemas.microsoft.com/office/drawing/2014/main" id="{0F1F40F7-29E9-CF14-1763-18CFF5C182F8}"/>
                  </a:ext>
                </a:extLst>
              </p:cNvPr>
              <p:cNvSpPr/>
              <p:nvPr/>
            </p:nvSpPr>
            <p:spPr>
              <a:xfrm>
                <a:off x="8827517" y="1448158"/>
                <a:ext cx="5783" cy="67582"/>
              </a:xfrm>
              <a:custGeom>
                <a:avLst/>
                <a:gdLst>
                  <a:gd name="connsiteX0" fmla="*/ 6 w 5783"/>
                  <a:gd name="connsiteY0" fmla="*/ 6 h 67582"/>
                  <a:gd name="connsiteX1" fmla="*/ 6 w 5783"/>
                  <a:gd name="connsiteY1" fmla="*/ 6 h 67582"/>
                  <a:gd name="connsiteX2" fmla="*/ 6 w 5783"/>
                  <a:gd name="connsiteY2" fmla="*/ 67588 h 675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67582">
                    <a:moveTo>
                      <a:pt x="6" y="6"/>
                    </a:moveTo>
                    <a:lnTo>
                      <a:pt x="6" y="6"/>
                    </a:lnTo>
                    <a:lnTo>
                      <a:pt x="6" y="6758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Freeform: Shape 54">
                <a:extLst>
                  <a:ext uri="{FF2B5EF4-FFF2-40B4-BE49-F238E27FC236}">
                    <a16:creationId xmlns:a16="http://schemas.microsoft.com/office/drawing/2014/main" id="{ACF73F31-3C7E-4077-3756-C36F922D36C4}"/>
                  </a:ext>
                </a:extLst>
              </p:cNvPr>
              <p:cNvSpPr/>
              <p:nvPr/>
            </p:nvSpPr>
            <p:spPr>
              <a:xfrm>
                <a:off x="9376041" y="2143524"/>
                <a:ext cx="57" cy="77495"/>
              </a:xfrm>
              <a:custGeom>
                <a:avLst/>
                <a:gdLst>
                  <a:gd name="connsiteX0" fmla="*/ 64 w 57"/>
                  <a:gd name="connsiteY0" fmla="*/ 77502 h 77495"/>
                  <a:gd name="connsiteX1" fmla="*/ 6 w 57"/>
                  <a:gd name="connsiteY1" fmla="*/ 77502 h 77495"/>
                  <a:gd name="connsiteX2" fmla="*/ 6 w 57"/>
                  <a:gd name="connsiteY2" fmla="*/ 6 h 774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7495">
                    <a:moveTo>
                      <a:pt x="64" y="77502"/>
                    </a:moveTo>
                    <a:lnTo>
                      <a:pt x="6" y="7750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Freeform: Shape 55">
                <a:extLst>
                  <a:ext uri="{FF2B5EF4-FFF2-40B4-BE49-F238E27FC236}">
                    <a16:creationId xmlns:a16="http://schemas.microsoft.com/office/drawing/2014/main" id="{168DCC16-843D-AEFC-461A-32755F6D4242}"/>
                  </a:ext>
                </a:extLst>
              </p:cNvPr>
              <p:cNvSpPr/>
              <p:nvPr/>
            </p:nvSpPr>
            <p:spPr>
              <a:xfrm>
                <a:off x="9373380" y="3996859"/>
                <a:ext cx="1095082" cy="38617"/>
              </a:xfrm>
              <a:custGeom>
                <a:avLst/>
                <a:gdLst>
                  <a:gd name="connsiteX0" fmla="*/ 1095088 w 1095082"/>
                  <a:gd name="connsiteY0" fmla="*/ 6 h 38617"/>
                  <a:gd name="connsiteX1" fmla="*/ 6 w 1095082"/>
                  <a:gd name="connsiteY1" fmla="*/ 6 h 38617"/>
                  <a:gd name="connsiteX2" fmla="*/ 6 w 1095082"/>
                  <a:gd name="connsiteY2" fmla="*/ 38624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95082" h="38617">
                    <a:moveTo>
                      <a:pt x="1095088" y="6"/>
                    </a:moveTo>
                    <a:lnTo>
                      <a:pt x="6" y="6"/>
                    </a:lnTo>
                    <a:lnTo>
                      <a:pt x="6" y="386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Freeform: Shape 56">
                <a:extLst>
                  <a:ext uri="{FF2B5EF4-FFF2-40B4-BE49-F238E27FC236}">
                    <a16:creationId xmlns:a16="http://schemas.microsoft.com/office/drawing/2014/main" id="{0D75C4E7-D1FB-9599-A312-788DB033AFF4}"/>
                  </a:ext>
                </a:extLst>
              </p:cNvPr>
              <p:cNvSpPr/>
              <p:nvPr/>
            </p:nvSpPr>
            <p:spPr>
              <a:xfrm>
                <a:off x="9376157" y="1834323"/>
                <a:ext cx="5783" cy="38617"/>
              </a:xfrm>
              <a:custGeom>
                <a:avLst/>
                <a:gdLst>
                  <a:gd name="connsiteX0" fmla="*/ 6 w 5783"/>
                  <a:gd name="connsiteY0" fmla="*/ 6 h 38617"/>
                  <a:gd name="connsiteX1" fmla="*/ 6 w 5783"/>
                  <a:gd name="connsiteY1" fmla="*/ 6 h 38617"/>
                  <a:gd name="connsiteX2" fmla="*/ 6 w 5783"/>
                  <a:gd name="connsiteY2" fmla="*/ 38624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7">
                    <a:moveTo>
                      <a:pt x="6" y="6"/>
                    </a:moveTo>
                    <a:lnTo>
                      <a:pt x="6" y="6"/>
                    </a:lnTo>
                    <a:lnTo>
                      <a:pt x="6" y="386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Freeform: Shape 57">
                <a:extLst>
                  <a:ext uri="{FF2B5EF4-FFF2-40B4-BE49-F238E27FC236}">
                    <a16:creationId xmlns:a16="http://schemas.microsoft.com/office/drawing/2014/main" id="{9EA12023-6504-162B-68A9-C1F89F90BABB}"/>
                  </a:ext>
                </a:extLst>
              </p:cNvPr>
              <p:cNvSpPr/>
              <p:nvPr/>
            </p:nvSpPr>
            <p:spPr>
              <a:xfrm>
                <a:off x="5528725" y="5225353"/>
                <a:ext cx="34" cy="156876"/>
              </a:xfrm>
              <a:custGeom>
                <a:avLst/>
                <a:gdLst>
                  <a:gd name="connsiteX0" fmla="*/ 41 w 34"/>
                  <a:gd name="connsiteY0" fmla="*/ 156882 h 156876"/>
                  <a:gd name="connsiteX1" fmla="*/ 6 w 34"/>
                  <a:gd name="connsiteY1" fmla="*/ 156882 h 156876"/>
                  <a:gd name="connsiteX2" fmla="*/ 6 w 34"/>
                  <a:gd name="connsiteY2" fmla="*/ 6 h 1568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34" h="156876">
                    <a:moveTo>
                      <a:pt x="41" y="156882"/>
                    </a:moveTo>
                    <a:lnTo>
                      <a:pt x="6" y="15688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Freeform: Shape 58">
                <a:extLst>
                  <a:ext uri="{FF2B5EF4-FFF2-40B4-BE49-F238E27FC236}">
                    <a16:creationId xmlns:a16="http://schemas.microsoft.com/office/drawing/2014/main" id="{AA7EC5F4-F518-48CC-3B8C-899859E9753A}"/>
                  </a:ext>
                </a:extLst>
              </p:cNvPr>
              <p:cNvSpPr/>
              <p:nvPr/>
            </p:nvSpPr>
            <p:spPr>
              <a:xfrm>
                <a:off x="8827343" y="1139228"/>
                <a:ext cx="5783" cy="76627"/>
              </a:xfrm>
              <a:custGeom>
                <a:avLst/>
                <a:gdLst>
                  <a:gd name="connsiteX0" fmla="*/ 6 w 5783"/>
                  <a:gd name="connsiteY0" fmla="*/ 6 h 76627"/>
                  <a:gd name="connsiteX1" fmla="*/ 6 w 5783"/>
                  <a:gd name="connsiteY1" fmla="*/ 6 h 76627"/>
                  <a:gd name="connsiteX2" fmla="*/ 6 w 5783"/>
                  <a:gd name="connsiteY2" fmla="*/ 76634 h 766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6627">
                    <a:moveTo>
                      <a:pt x="6" y="6"/>
                    </a:moveTo>
                    <a:lnTo>
                      <a:pt x="6" y="6"/>
                    </a:lnTo>
                    <a:lnTo>
                      <a:pt x="6" y="7663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Freeform: Shape 59">
                <a:extLst>
                  <a:ext uri="{FF2B5EF4-FFF2-40B4-BE49-F238E27FC236}">
                    <a16:creationId xmlns:a16="http://schemas.microsoft.com/office/drawing/2014/main" id="{70C59BC9-E816-822D-7E8F-192CC6716E5D}"/>
                  </a:ext>
                </a:extLst>
              </p:cNvPr>
              <p:cNvSpPr/>
              <p:nvPr/>
            </p:nvSpPr>
            <p:spPr>
              <a:xfrm>
                <a:off x="5528725" y="5840806"/>
                <a:ext cx="34" cy="140011"/>
              </a:xfrm>
              <a:custGeom>
                <a:avLst/>
                <a:gdLst>
                  <a:gd name="connsiteX0" fmla="*/ 41 w 34"/>
                  <a:gd name="connsiteY0" fmla="*/ 6 h 140011"/>
                  <a:gd name="connsiteX1" fmla="*/ 6 w 34"/>
                  <a:gd name="connsiteY1" fmla="*/ 6 h 140011"/>
                  <a:gd name="connsiteX2" fmla="*/ 6 w 34"/>
                  <a:gd name="connsiteY2" fmla="*/ 140017 h 1400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34" h="140011">
                    <a:moveTo>
                      <a:pt x="41" y="6"/>
                    </a:moveTo>
                    <a:lnTo>
                      <a:pt x="6" y="6"/>
                    </a:lnTo>
                    <a:lnTo>
                      <a:pt x="6" y="140017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Freeform: Shape 60">
                <a:extLst>
                  <a:ext uri="{FF2B5EF4-FFF2-40B4-BE49-F238E27FC236}">
                    <a16:creationId xmlns:a16="http://schemas.microsoft.com/office/drawing/2014/main" id="{1FCD3FEF-805E-5F36-A077-1152E82166BB}"/>
                  </a:ext>
                </a:extLst>
              </p:cNvPr>
              <p:cNvSpPr/>
              <p:nvPr/>
            </p:nvSpPr>
            <p:spPr>
              <a:xfrm>
                <a:off x="8827401" y="1292484"/>
                <a:ext cx="57" cy="76026"/>
              </a:xfrm>
              <a:custGeom>
                <a:avLst/>
                <a:gdLst>
                  <a:gd name="connsiteX0" fmla="*/ 64 w 57"/>
                  <a:gd name="connsiteY0" fmla="*/ 76033 h 76026"/>
                  <a:gd name="connsiteX1" fmla="*/ 6 w 57"/>
                  <a:gd name="connsiteY1" fmla="*/ 76033 h 76026"/>
                  <a:gd name="connsiteX2" fmla="*/ 6 w 57"/>
                  <a:gd name="connsiteY2" fmla="*/ 6 h 760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6026">
                    <a:moveTo>
                      <a:pt x="64" y="76033"/>
                    </a:moveTo>
                    <a:lnTo>
                      <a:pt x="6" y="76033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Freeform: Shape 61">
                <a:extLst>
                  <a:ext uri="{FF2B5EF4-FFF2-40B4-BE49-F238E27FC236}">
                    <a16:creationId xmlns:a16="http://schemas.microsoft.com/office/drawing/2014/main" id="{972181A5-C82F-76DB-6F8E-16C328311659}"/>
                  </a:ext>
                </a:extLst>
              </p:cNvPr>
              <p:cNvSpPr/>
              <p:nvPr/>
            </p:nvSpPr>
            <p:spPr>
              <a:xfrm>
                <a:off x="5528753" y="6429689"/>
                <a:ext cx="5783" cy="38635"/>
              </a:xfrm>
              <a:custGeom>
                <a:avLst/>
                <a:gdLst>
                  <a:gd name="connsiteX0" fmla="*/ 6 w 5783"/>
                  <a:gd name="connsiteY0" fmla="*/ 38641 h 38635"/>
                  <a:gd name="connsiteX1" fmla="*/ 6 w 5783"/>
                  <a:gd name="connsiteY1" fmla="*/ 38641 h 38635"/>
                  <a:gd name="connsiteX2" fmla="*/ 6 w 5783"/>
                  <a:gd name="connsiteY2" fmla="*/ 6 h 38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35">
                    <a:moveTo>
                      <a:pt x="6" y="38641"/>
                    </a:moveTo>
                    <a:lnTo>
                      <a:pt x="6" y="3864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Freeform: Shape 62">
                <a:extLst>
                  <a:ext uri="{FF2B5EF4-FFF2-40B4-BE49-F238E27FC236}">
                    <a16:creationId xmlns:a16="http://schemas.microsoft.com/office/drawing/2014/main" id="{86BD9525-8922-CA6B-2D6C-3B9B009D0DA9}"/>
                  </a:ext>
                </a:extLst>
              </p:cNvPr>
              <p:cNvSpPr/>
              <p:nvPr/>
            </p:nvSpPr>
            <p:spPr>
              <a:xfrm>
                <a:off x="9376157" y="1872940"/>
                <a:ext cx="5783" cy="38617"/>
              </a:xfrm>
              <a:custGeom>
                <a:avLst/>
                <a:gdLst>
                  <a:gd name="connsiteX0" fmla="*/ 6 w 5783"/>
                  <a:gd name="connsiteY0" fmla="*/ 38624 h 38617"/>
                  <a:gd name="connsiteX1" fmla="*/ 6 w 5783"/>
                  <a:gd name="connsiteY1" fmla="*/ 38624 h 38617"/>
                  <a:gd name="connsiteX2" fmla="*/ 6 w 5783"/>
                  <a:gd name="connsiteY2" fmla="*/ 6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7">
                    <a:moveTo>
                      <a:pt x="6" y="38624"/>
                    </a:moveTo>
                    <a:lnTo>
                      <a:pt x="6" y="386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Freeform: Shape 63">
                <a:extLst>
                  <a:ext uri="{FF2B5EF4-FFF2-40B4-BE49-F238E27FC236}">
                    <a16:creationId xmlns:a16="http://schemas.microsoft.com/office/drawing/2014/main" id="{99026634-EA98-9EB6-1B67-F45DEA2A475A}"/>
                  </a:ext>
                </a:extLst>
              </p:cNvPr>
              <p:cNvSpPr/>
              <p:nvPr/>
            </p:nvSpPr>
            <p:spPr>
              <a:xfrm>
                <a:off x="8827517" y="3601035"/>
                <a:ext cx="57" cy="67582"/>
              </a:xfrm>
              <a:custGeom>
                <a:avLst/>
                <a:gdLst>
                  <a:gd name="connsiteX0" fmla="*/ 64 w 57"/>
                  <a:gd name="connsiteY0" fmla="*/ 67588 h 67582"/>
                  <a:gd name="connsiteX1" fmla="*/ 6 w 57"/>
                  <a:gd name="connsiteY1" fmla="*/ 67588 h 67582"/>
                  <a:gd name="connsiteX2" fmla="*/ 6 w 57"/>
                  <a:gd name="connsiteY2" fmla="*/ 6 h 675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67582">
                    <a:moveTo>
                      <a:pt x="64" y="67588"/>
                    </a:moveTo>
                    <a:lnTo>
                      <a:pt x="6" y="67588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Freeform: Shape 64">
                <a:extLst>
                  <a:ext uri="{FF2B5EF4-FFF2-40B4-BE49-F238E27FC236}">
                    <a16:creationId xmlns:a16="http://schemas.microsoft.com/office/drawing/2014/main" id="{A3A507CF-D20F-076E-CFA5-49EEB3B37738}"/>
                  </a:ext>
                </a:extLst>
              </p:cNvPr>
              <p:cNvSpPr/>
              <p:nvPr/>
            </p:nvSpPr>
            <p:spPr>
              <a:xfrm>
                <a:off x="9376388" y="3108676"/>
                <a:ext cx="5783" cy="38617"/>
              </a:xfrm>
              <a:custGeom>
                <a:avLst/>
                <a:gdLst>
                  <a:gd name="connsiteX0" fmla="*/ 6 w 5783"/>
                  <a:gd name="connsiteY0" fmla="*/ 38624 h 38617"/>
                  <a:gd name="connsiteX1" fmla="*/ 6 w 5783"/>
                  <a:gd name="connsiteY1" fmla="*/ 38624 h 38617"/>
                  <a:gd name="connsiteX2" fmla="*/ 6 w 5783"/>
                  <a:gd name="connsiteY2" fmla="*/ 6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7">
                    <a:moveTo>
                      <a:pt x="6" y="38624"/>
                    </a:moveTo>
                    <a:lnTo>
                      <a:pt x="6" y="386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Freeform: Shape 65">
                <a:extLst>
                  <a:ext uri="{FF2B5EF4-FFF2-40B4-BE49-F238E27FC236}">
                    <a16:creationId xmlns:a16="http://schemas.microsoft.com/office/drawing/2014/main" id="{20469993-6840-3ED5-FCA9-F3E41AFA3B9D}"/>
                  </a:ext>
                </a:extLst>
              </p:cNvPr>
              <p:cNvSpPr/>
              <p:nvPr/>
            </p:nvSpPr>
            <p:spPr>
              <a:xfrm>
                <a:off x="8827575" y="3726541"/>
                <a:ext cx="551126" cy="38617"/>
              </a:xfrm>
              <a:custGeom>
                <a:avLst/>
                <a:gdLst>
                  <a:gd name="connsiteX0" fmla="*/ 551133 w 551126"/>
                  <a:gd name="connsiteY0" fmla="*/ 38624 h 38617"/>
                  <a:gd name="connsiteX1" fmla="*/ 6 w 551126"/>
                  <a:gd name="connsiteY1" fmla="*/ 38624 h 38617"/>
                  <a:gd name="connsiteX2" fmla="*/ 6 w 551126"/>
                  <a:gd name="connsiteY2" fmla="*/ 6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51126" h="38617">
                    <a:moveTo>
                      <a:pt x="551133" y="38624"/>
                    </a:moveTo>
                    <a:lnTo>
                      <a:pt x="6" y="386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Freeform: Shape 66">
                <a:extLst>
                  <a:ext uri="{FF2B5EF4-FFF2-40B4-BE49-F238E27FC236}">
                    <a16:creationId xmlns:a16="http://schemas.microsoft.com/office/drawing/2014/main" id="{8B5C199B-1582-D10E-EF03-3AFD133C7E4E}"/>
                  </a:ext>
                </a:extLst>
              </p:cNvPr>
              <p:cNvSpPr/>
              <p:nvPr/>
            </p:nvSpPr>
            <p:spPr>
              <a:xfrm>
                <a:off x="5528782" y="5078124"/>
                <a:ext cx="6" cy="57923"/>
              </a:xfrm>
              <a:custGeom>
                <a:avLst/>
                <a:gdLst>
                  <a:gd name="connsiteX0" fmla="*/ 12 w 6"/>
                  <a:gd name="connsiteY0" fmla="*/ 6 h 57923"/>
                  <a:gd name="connsiteX1" fmla="*/ 6 w 6"/>
                  <a:gd name="connsiteY1" fmla="*/ 6 h 57923"/>
                  <a:gd name="connsiteX2" fmla="*/ 6 w 6"/>
                  <a:gd name="connsiteY2" fmla="*/ 57930 h 57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57923">
                    <a:moveTo>
                      <a:pt x="12" y="6"/>
                    </a:moveTo>
                    <a:lnTo>
                      <a:pt x="6" y="6"/>
                    </a:lnTo>
                    <a:lnTo>
                      <a:pt x="6" y="57930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Freeform: Shape 67">
                <a:extLst>
                  <a:ext uri="{FF2B5EF4-FFF2-40B4-BE49-F238E27FC236}">
                    <a16:creationId xmlns:a16="http://schemas.microsoft.com/office/drawing/2014/main" id="{5D5AA5C3-BA63-6D3F-C065-FE95B4792F14}"/>
                  </a:ext>
                </a:extLst>
              </p:cNvPr>
              <p:cNvSpPr/>
              <p:nvPr/>
            </p:nvSpPr>
            <p:spPr>
              <a:xfrm>
                <a:off x="5528788" y="5454635"/>
                <a:ext cx="28" cy="67582"/>
              </a:xfrm>
              <a:custGeom>
                <a:avLst/>
                <a:gdLst>
                  <a:gd name="connsiteX0" fmla="*/ 35 w 28"/>
                  <a:gd name="connsiteY0" fmla="*/ 67589 h 67582"/>
                  <a:gd name="connsiteX1" fmla="*/ 6 w 28"/>
                  <a:gd name="connsiteY1" fmla="*/ 67589 h 67582"/>
                  <a:gd name="connsiteX2" fmla="*/ 6 w 28"/>
                  <a:gd name="connsiteY2" fmla="*/ 6 h 675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67582">
                    <a:moveTo>
                      <a:pt x="35" y="67589"/>
                    </a:moveTo>
                    <a:lnTo>
                      <a:pt x="6" y="67589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Freeform: Shape 68">
                <a:extLst>
                  <a:ext uri="{FF2B5EF4-FFF2-40B4-BE49-F238E27FC236}">
                    <a16:creationId xmlns:a16="http://schemas.microsoft.com/office/drawing/2014/main" id="{850B99DC-133D-0B25-D6BE-7B7EF4B9E81E}"/>
                  </a:ext>
                </a:extLst>
              </p:cNvPr>
              <p:cNvSpPr/>
              <p:nvPr/>
            </p:nvSpPr>
            <p:spPr>
              <a:xfrm>
                <a:off x="4053371" y="419991"/>
                <a:ext cx="1972530" cy="159293"/>
              </a:xfrm>
              <a:custGeom>
                <a:avLst/>
                <a:gdLst>
                  <a:gd name="connsiteX0" fmla="*/ 1972536 w 1972530"/>
                  <a:gd name="connsiteY0" fmla="*/ 159300 h 159293"/>
                  <a:gd name="connsiteX1" fmla="*/ 6 w 1972530"/>
                  <a:gd name="connsiteY1" fmla="*/ 159300 h 159293"/>
                  <a:gd name="connsiteX2" fmla="*/ 6 w 1972530"/>
                  <a:gd name="connsiteY2" fmla="*/ 6 h 1592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972530" h="159293">
                    <a:moveTo>
                      <a:pt x="1972536" y="159300"/>
                    </a:moveTo>
                    <a:lnTo>
                      <a:pt x="6" y="159300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Freeform: Shape 69">
                <a:extLst>
                  <a:ext uri="{FF2B5EF4-FFF2-40B4-BE49-F238E27FC236}">
                    <a16:creationId xmlns:a16="http://schemas.microsoft.com/office/drawing/2014/main" id="{3CEB334D-67F2-89FD-D39F-8CBEF14E2AC3}"/>
                  </a:ext>
                </a:extLst>
              </p:cNvPr>
              <p:cNvSpPr/>
              <p:nvPr/>
            </p:nvSpPr>
            <p:spPr>
              <a:xfrm>
                <a:off x="8827459" y="1370923"/>
                <a:ext cx="5783" cy="72411"/>
              </a:xfrm>
              <a:custGeom>
                <a:avLst/>
                <a:gdLst>
                  <a:gd name="connsiteX0" fmla="*/ 6 w 5783"/>
                  <a:gd name="connsiteY0" fmla="*/ 6 h 72411"/>
                  <a:gd name="connsiteX1" fmla="*/ 6 w 5783"/>
                  <a:gd name="connsiteY1" fmla="*/ 6 h 72411"/>
                  <a:gd name="connsiteX2" fmla="*/ 6 w 5783"/>
                  <a:gd name="connsiteY2" fmla="*/ 72418 h 724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2411">
                    <a:moveTo>
                      <a:pt x="6" y="6"/>
                    </a:moveTo>
                    <a:lnTo>
                      <a:pt x="6" y="6"/>
                    </a:lnTo>
                    <a:lnTo>
                      <a:pt x="6" y="7241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Freeform: Shape 70">
                <a:extLst>
                  <a:ext uri="{FF2B5EF4-FFF2-40B4-BE49-F238E27FC236}">
                    <a16:creationId xmlns:a16="http://schemas.microsoft.com/office/drawing/2014/main" id="{83CF585A-7DD0-E1DA-9DCD-38B4BEF4264E}"/>
                  </a:ext>
                </a:extLst>
              </p:cNvPr>
              <p:cNvSpPr/>
              <p:nvPr/>
            </p:nvSpPr>
            <p:spPr>
              <a:xfrm>
                <a:off x="5528563" y="2850788"/>
                <a:ext cx="5783" cy="891091"/>
              </a:xfrm>
              <a:custGeom>
                <a:avLst/>
                <a:gdLst>
                  <a:gd name="connsiteX0" fmla="*/ 6 w 5783"/>
                  <a:gd name="connsiteY0" fmla="*/ 6 h 891091"/>
                  <a:gd name="connsiteX1" fmla="*/ 6 w 5783"/>
                  <a:gd name="connsiteY1" fmla="*/ 6 h 891091"/>
                  <a:gd name="connsiteX2" fmla="*/ 6 w 5783"/>
                  <a:gd name="connsiteY2" fmla="*/ 891098 h 8910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891091">
                    <a:moveTo>
                      <a:pt x="6" y="6"/>
                    </a:moveTo>
                    <a:lnTo>
                      <a:pt x="6" y="6"/>
                    </a:lnTo>
                    <a:lnTo>
                      <a:pt x="6" y="89109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Freeform: Shape 71">
                <a:extLst>
                  <a:ext uri="{FF2B5EF4-FFF2-40B4-BE49-F238E27FC236}">
                    <a16:creationId xmlns:a16="http://schemas.microsoft.com/office/drawing/2014/main" id="{079F3938-09C8-8485-E174-22B19693989B}"/>
                  </a:ext>
                </a:extLst>
              </p:cNvPr>
              <p:cNvSpPr/>
              <p:nvPr/>
            </p:nvSpPr>
            <p:spPr>
              <a:xfrm>
                <a:off x="8827401" y="3439936"/>
                <a:ext cx="57" cy="215407"/>
              </a:xfrm>
              <a:custGeom>
                <a:avLst/>
                <a:gdLst>
                  <a:gd name="connsiteX0" fmla="*/ 64 w 57"/>
                  <a:gd name="connsiteY0" fmla="*/ 215414 h 215407"/>
                  <a:gd name="connsiteX1" fmla="*/ 6 w 57"/>
                  <a:gd name="connsiteY1" fmla="*/ 215414 h 215407"/>
                  <a:gd name="connsiteX2" fmla="*/ 6 w 57"/>
                  <a:gd name="connsiteY2" fmla="*/ 6 h 21540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215407">
                    <a:moveTo>
                      <a:pt x="64" y="215414"/>
                    </a:moveTo>
                    <a:lnTo>
                      <a:pt x="6" y="21541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Freeform: Shape 72">
                <a:extLst>
                  <a:ext uri="{FF2B5EF4-FFF2-40B4-BE49-F238E27FC236}">
                    <a16:creationId xmlns:a16="http://schemas.microsoft.com/office/drawing/2014/main" id="{7F6E525B-F391-2FAF-233F-8A592B0AFAE3}"/>
                  </a:ext>
                </a:extLst>
              </p:cNvPr>
              <p:cNvSpPr/>
              <p:nvPr/>
            </p:nvSpPr>
            <p:spPr>
              <a:xfrm>
                <a:off x="5528828" y="5966301"/>
                <a:ext cx="5783" cy="38634"/>
              </a:xfrm>
              <a:custGeom>
                <a:avLst/>
                <a:gdLst>
                  <a:gd name="connsiteX0" fmla="*/ 6 w 5783"/>
                  <a:gd name="connsiteY0" fmla="*/ 38641 h 38634"/>
                  <a:gd name="connsiteX1" fmla="*/ 6 w 5783"/>
                  <a:gd name="connsiteY1" fmla="*/ 38641 h 38634"/>
                  <a:gd name="connsiteX2" fmla="*/ 6 w 5783"/>
                  <a:gd name="connsiteY2" fmla="*/ 6 h 386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34">
                    <a:moveTo>
                      <a:pt x="6" y="38641"/>
                    </a:moveTo>
                    <a:lnTo>
                      <a:pt x="6" y="3864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Freeform: Shape 73">
                <a:extLst>
                  <a:ext uri="{FF2B5EF4-FFF2-40B4-BE49-F238E27FC236}">
                    <a16:creationId xmlns:a16="http://schemas.microsoft.com/office/drawing/2014/main" id="{C93092AD-1E17-B127-5628-A4C9EDD92FF7}"/>
                  </a:ext>
                </a:extLst>
              </p:cNvPr>
              <p:cNvSpPr/>
              <p:nvPr/>
            </p:nvSpPr>
            <p:spPr>
              <a:xfrm>
                <a:off x="8827459" y="3655344"/>
                <a:ext cx="5783" cy="277553"/>
              </a:xfrm>
              <a:custGeom>
                <a:avLst/>
                <a:gdLst>
                  <a:gd name="connsiteX0" fmla="*/ 6 w 5783"/>
                  <a:gd name="connsiteY0" fmla="*/ 277559 h 277553"/>
                  <a:gd name="connsiteX1" fmla="*/ 6 w 5783"/>
                  <a:gd name="connsiteY1" fmla="*/ 277559 h 277553"/>
                  <a:gd name="connsiteX2" fmla="*/ 6 w 5783"/>
                  <a:gd name="connsiteY2" fmla="*/ 6 h 2775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277553">
                    <a:moveTo>
                      <a:pt x="6" y="277559"/>
                    </a:moveTo>
                    <a:lnTo>
                      <a:pt x="6" y="277559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Freeform: Shape 74">
                <a:extLst>
                  <a:ext uri="{FF2B5EF4-FFF2-40B4-BE49-F238E27FC236}">
                    <a16:creationId xmlns:a16="http://schemas.microsoft.com/office/drawing/2014/main" id="{1FE6D3C3-7190-5A04-C423-D1FFB29D1EAE}"/>
                  </a:ext>
                </a:extLst>
              </p:cNvPr>
              <p:cNvSpPr/>
              <p:nvPr/>
            </p:nvSpPr>
            <p:spPr>
              <a:xfrm>
                <a:off x="5528753" y="5068471"/>
                <a:ext cx="28" cy="67576"/>
              </a:xfrm>
              <a:custGeom>
                <a:avLst/>
                <a:gdLst>
                  <a:gd name="connsiteX0" fmla="*/ 35 w 28"/>
                  <a:gd name="connsiteY0" fmla="*/ 67582 h 67576"/>
                  <a:gd name="connsiteX1" fmla="*/ 6 w 28"/>
                  <a:gd name="connsiteY1" fmla="*/ 67582 h 67576"/>
                  <a:gd name="connsiteX2" fmla="*/ 6 w 28"/>
                  <a:gd name="connsiteY2" fmla="*/ 6 h 675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67576">
                    <a:moveTo>
                      <a:pt x="35" y="67582"/>
                    </a:moveTo>
                    <a:lnTo>
                      <a:pt x="6" y="6758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Freeform: Shape 75">
                <a:extLst>
                  <a:ext uri="{FF2B5EF4-FFF2-40B4-BE49-F238E27FC236}">
                    <a16:creationId xmlns:a16="http://schemas.microsoft.com/office/drawing/2014/main" id="{D204A015-EE72-6856-7684-EB3FB2B3F6FC}"/>
                  </a:ext>
                </a:extLst>
              </p:cNvPr>
              <p:cNvSpPr/>
              <p:nvPr/>
            </p:nvSpPr>
            <p:spPr>
              <a:xfrm>
                <a:off x="5528725" y="6275265"/>
                <a:ext cx="22" cy="77212"/>
              </a:xfrm>
              <a:custGeom>
                <a:avLst/>
                <a:gdLst>
                  <a:gd name="connsiteX0" fmla="*/ 29 w 22"/>
                  <a:gd name="connsiteY0" fmla="*/ 6 h 77212"/>
                  <a:gd name="connsiteX1" fmla="*/ 6 w 22"/>
                  <a:gd name="connsiteY1" fmla="*/ 6 h 77212"/>
                  <a:gd name="connsiteX2" fmla="*/ 6 w 22"/>
                  <a:gd name="connsiteY2" fmla="*/ 77218 h 772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2" h="77212">
                    <a:moveTo>
                      <a:pt x="29" y="6"/>
                    </a:moveTo>
                    <a:lnTo>
                      <a:pt x="6" y="6"/>
                    </a:lnTo>
                    <a:lnTo>
                      <a:pt x="6" y="7721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Freeform: Shape 76">
                <a:extLst>
                  <a:ext uri="{FF2B5EF4-FFF2-40B4-BE49-F238E27FC236}">
                    <a16:creationId xmlns:a16="http://schemas.microsoft.com/office/drawing/2014/main" id="{476D3C8A-D2A2-19B9-3C47-F3A43973D35E}"/>
                  </a:ext>
                </a:extLst>
              </p:cNvPr>
              <p:cNvSpPr/>
              <p:nvPr/>
            </p:nvSpPr>
            <p:spPr>
              <a:xfrm>
                <a:off x="5528725" y="6352477"/>
                <a:ext cx="28" cy="77212"/>
              </a:xfrm>
              <a:custGeom>
                <a:avLst/>
                <a:gdLst>
                  <a:gd name="connsiteX0" fmla="*/ 35 w 28"/>
                  <a:gd name="connsiteY0" fmla="*/ 77218 h 77212"/>
                  <a:gd name="connsiteX1" fmla="*/ 6 w 28"/>
                  <a:gd name="connsiteY1" fmla="*/ 77218 h 77212"/>
                  <a:gd name="connsiteX2" fmla="*/ 6 w 28"/>
                  <a:gd name="connsiteY2" fmla="*/ 6 h 772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77212">
                    <a:moveTo>
                      <a:pt x="35" y="77218"/>
                    </a:moveTo>
                    <a:lnTo>
                      <a:pt x="6" y="77218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Freeform: Shape 77">
                <a:extLst>
                  <a:ext uri="{FF2B5EF4-FFF2-40B4-BE49-F238E27FC236}">
                    <a16:creationId xmlns:a16="http://schemas.microsoft.com/office/drawing/2014/main" id="{9FBF54D8-89CE-D1DF-1AA7-A3BD65A4508B}"/>
                  </a:ext>
                </a:extLst>
              </p:cNvPr>
              <p:cNvSpPr/>
              <p:nvPr/>
            </p:nvSpPr>
            <p:spPr>
              <a:xfrm>
                <a:off x="5528586" y="4537494"/>
                <a:ext cx="6" cy="95482"/>
              </a:xfrm>
              <a:custGeom>
                <a:avLst/>
                <a:gdLst>
                  <a:gd name="connsiteX0" fmla="*/ 12 w 6"/>
                  <a:gd name="connsiteY0" fmla="*/ 6 h 95482"/>
                  <a:gd name="connsiteX1" fmla="*/ 6 w 6"/>
                  <a:gd name="connsiteY1" fmla="*/ 6 h 95482"/>
                  <a:gd name="connsiteX2" fmla="*/ 6 w 6"/>
                  <a:gd name="connsiteY2" fmla="*/ 95489 h 954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95482">
                    <a:moveTo>
                      <a:pt x="12" y="6"/>
                    </a:moveTo>
                    <a:lnTo>
                      <a:pt x="6" y="6"/>
                    </a:lnTo>
                    <a:lnTo>
                      <a:pt x="6" y="95489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Freeform: Shape 78">
                <a:extLst>
                  <a:ext uri="{FF2B5EF4-FFF2-40B4-BE49-F238E27FC236}">
                    <a16:creationId xmlns:a16="http://schemas.microsoft.com/office/drawing/2014/main" id="{7307F921-3EB6-7D14-0903-BE2706333092}"/>
                  </a:ext>
                </a:extLst>
              </p:cNvPr>
              <p:cNvSpPr/>
              <p:nvPr/>
            </p:nvSpPr>
            <p:spPr>
              <a:xfrm>
                <a:off x="8827517" y="3533458"/>
                <a:ext cx="5783" cy="67576"/>
              </a:xfrm>
              <a:custGeom>
                <a:avLst/>
                <a:gdLst>
                  <a:gd name="connsiteX0" fmla="*/ 6 w 5783"/>
                  <a:gd name="connsiteY0" fmla="*/ 6 h 67576"/>
                  <a:gd name="connsiteX1" fmla="*/ 6 w 5783"/>
                  <a:gd name="connsiteY1" fmla="*/ 6 h 67576"/>
                  <a:gd name="connsiteX2" fmla="*/ 6 w 5783"/>
                  <a:gd name="connsiteY2" fmla="*/ 67583 h 675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67576">
                    <a:moveTo>
                      <a:pt x="6" y="6"/>
                    </a:moveTo>
                    <a:lnTo>
                      <a:pt x="6" y="6"/>
                    </a:lnTo>
                    <a:lnTo>
                      <a:pt x="6" y="67583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Freeform: Shape 79">
                <a:extLst>
                  <a:ext uri="{FF2B5EF4-FFF2-40B4-BE49-F238E27FC236}">
                    <a16:creationId xmlns:a16="http://schemas.microsoft.com/office/drawing/2014/main" id="{A3B537E4-9A09-7147-B3C6-5D3B5F598173}"/>
                  </a:ext>
                </a:extLst>
              </p:cNvPr>
              <p:cNvSpPr/>
              <p:nvPr/>
            </p:nvSpPr>
            <p:spPr>
              <a:xfrm>
                <a:off x="5528753" y="6391112"/>
                <a:ext cx="552150" cy="38576"/>
              </a:xfrm>
              <a:custGeom>
                <a:avLst/>
                <a:gdLst>
                  <a:gd name="connsiteX0" fmla="*/ 552157 w 552150"/>
                  <a:gd name="connsiteY0" fmla="*/ 6 h 38576"/>
                  <a:gd name="connsiteX1" fmla="*/ 6 w 552150"/>
                  <a:gd name="connsiteY1" fmla="*/ 6 h 38576"/>
                  <a:gd name="connsiteX2" fmla="*/ 6 w 552150"/>
                  <a:gd name="connsiteY2" fmla="*/ 38583 h 385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52150" h="38576">
                    <a:moveTo>
                      <a:pt x="552157" y="6"/>
                    </a:moveTo>
                    <a:lnTo>
                      <a:pt x="6" y="6"/>
                    </a:lnTo>
                    <a:lnTo>
                      <a:pt x="6" y="38583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Freeform: Shape 80">
                <a:extLst>
                  <a:ext uri="{FF2B5EF4-FFF2-40B4-BE49-F238E27FC236}">
                    <a16:creationId xmlns:a16="http://schemas.microsoft.com/office/drawing/2014/main" id="{7DEF545D-0B33-F695-79F6-E4AA518FCE15}"/>
                  </a:ext>
                </a:extLst>
              </p:cNvPr>
              <p:cNvSpPr/>
              <p:nvPr/>
            </p:nvSpPr>
            <p:spPr>
              <a:xfrm>
                <a:off x="9373438" y="4228559"/>
                <a:ext cx="5783" cy="57923"/>
              </a:xfrm>
              <a:custGeom>
                <a:avLst/>
                <a:gdLst>
                  <a:gd name="connsiteX0" fmla="*/ 6 w 5783"/>
                  <a:gd name="connsiteY0" fmla="*/ 6 h 57923"/>
                  <a:gd name="connsiteX1" fmla="*/ 6 w 5783"/>
                  <a:gd name="connsiteY1" fmla="*/ 6 h 57923"/>
                  <a:gd name="connsiteX2" fmla="*/ 6 w 5783"/>
                  <a:gd name="connsiteY2" fmla="*/ 57929 h 57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57923">
                    <a:moveTo>
                      <a:pt x="6" y="6"/>
                    </a:moveTo>
                    <a:lnTo>
                      <a:pt x="6" y="6"/>
                    </a:lnTo>
                    <a:lnTo>
                      <a:pt x="6" y="57929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Freeform: Shape 81">
                <a:extLst>
                  <a:ext uri="{FF2B5EF4-FFF2-40B4-BE49-F238E27FC236}">
                    <a16:creationId xmlns:a16="http://schemas.microsoft.com/office/drawing/2014/main" id="{8927EEDE-BE97-281B-1C9F-BEF0842F2B78}"/>
                  </a:ext>
                </a:extLst>
              </p:cNvPr>
              <p:cNvSpPr/>
              <p:nvPr/>
            </p:nvSpPr>
            <p:spPr>
              <a:xfrm>
                <a:off x="8827517" y="3528629"/>
                <a:ext cx="5783" cy="72405"/>
              </a:xfrm>
              <a:custGeom>
                <a:avLst/>
                <a:gdLst>
                  <a:gd name="connsiteX0" fmla="*/ 6 w 5783"/>
                  <a:gd name="connsiteY0" fmla="*/ 72412 h 72405"/>
                  <a:gd name="connsiteX1" fmla="*/ 6 w 5783"/>
                  <a:gd name="connsiteY1" fmla="*/ 72412 h 72405"/>
                  <a:gd name="connsiteX2" fmla="*/ 6 w 5783"/>
                  <a:gd name="connsiteY2" fmla="*/ 6 h 724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2405">
                    <a:moveTo>
                      <a:pt x="6" y="72412"/>
                    </a:moveTo>
                    <a:lnTo>
                      <a:pt x="6" y="7241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Freeform: Shape 82">
                <a:extLst>
                  <a:ext uri="{FF2B5EF4-FFF2-40B4-BE49-F238E27FC236}">
                    <a16:creationId xmlns:a16="http://schemas.microsoft.com/office/drawing/2014/main" id="{1D238D68-18BF-8A2E-2EF0-8E50D98B7100}"/>
                  </a:ext>
                </a:extLst>
              </p:cNvPr>
              <p:cNvSpPr/>
              <p:nvPr/>
            </p:nvSpPr>
            <p:spPr>
              <a:xfrm>
                <a:off x="9373380" y="4151324"/>
                <a:ext cx="5783" cy="67582"/>
              </a:xfrm>
              <a:custGeom>
                <a:avLst/>
                <a:gdLst>
                  <a:gd name="connsiteX0" fmla="*/ 6 w 5783"/>
                  <a:gd name="connsiteY0" fmla="*/ 6 h 67582"/>
                  <a:gd name="connsiteX1" fmla="*/ 6 w 5783"/>
                  <a:gd name="connsiteY1" fmla="*/ 6 h 67582"/>
                  <a:gd name="connsiteX2" fmla="*/ 6 w 5783"/>
                  <a:gd name="connsiteY2" fmla="*/ 67588 h 675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67582">
                    <a:moveTo>
                      <a:pt x="6" y="6"/>
                    </a:moveTo>
                    <a:lnTo>
                      <a:pt x="6" y="6"/>
                    </a:lnTo>
                    <a:lnTo>
                      <a:pt x="6" y="6758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Freeform: Shape 83">
                <a:extLst>
                  <a:ext uri="{FF2B5EF4-FFF2-40B4-BE49-F238E27FC236}">
                    <a16:creationId xmlns:a16="http://schemas.microsoft.com/office/drawing/2014/main" id="{B3FDA27D-8DF2-1B12-43D6-6B149C46AFCF}"/>
                  </a:ext>
                </a:extLst>
              </p:cNvPr>
              <p:cNvSpPr/>
              <p:nvPr/>
            </p:nvSpPr>
            <p:spPr>
              <a:xfrm>
                <a:off x="5528696" y="6095450"/>
                <a:ext cx="28" cy="257026"/>
              </a:xfrm>
              <a:custGeom>
                <a:avLst/>
                <a:gdLst>
                  <a:gd name="connsiteX0" fmla="*/ 35 w 28"/>
                  <a:gd name="connsiteY0" fmla="*/ 257032 h 257026"/>
                  <a:gd name="connsiteX1" fmla="*/ 6 w 28"/>
                  <a:gd name="connsiteY1" fmla="*/ 257032 h 257026"/>
                  <a:gd name="connsiteX2" fmla="*/ 6 w 28"/>
                  <a:gd name="connsiteY2" fmla="*/ 6 h 2570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257026">
                    <a:moveTo>
                      <a:pt x="35" y="257032"/>
                    </a:moveTo>
                    <a:lnTo>
                      <a:pt x="6" y="25703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Freeform: Shape 84">
                <a:extLst>
                  <a:ext uri="{FF2B5EF4-FFF2-40B4-BE49-F238E27FC236}">
                    <a16:creationId xmlns:a16="http://schemas.microsoft.com/office/drawing/2014/main" id="{48208E27-CD35-5D3A-C651-FF61C3D34C39}"/>
                  </a:ext>
                </a:extLst>
              </p:cNvPr>
              <p:cNvSpPr/>
              <p:nvPr/>
            </p:nvSpPr>
            <p:spPr>
              <a:xfrm>
                <a:off x="5528759" y="5309824"/>
                <a:ext cx="5783" cy="72405"/>
              </a:xfrm>
              <a:custGeom>
                <a:avLst/>
                <a:gdLst>
                  <a:gd name="connsiteX0" fmla="*/ 6 w 5783"/>
                  <a:gd name="connsiteY0" fmla="*/ 6 h 72405"/>
                  <a:gd name="connsiteX1" fmla="*/ 6 w 5783"/>
                  <a:gd name="connsiteY1" fmla="*/ 6 h 72405"/>
                  <a:gd name="connsiteX2" fmla="*/ 6 w 5783"/>
                  <a:gd name="connsiteY2" fmla="*/ 72412 h 724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2405">
                    <a:moveTo>
                      <a:pt x="6" y="6"/>
                    </a:moveTo>
                    <a:lnTo>
                      <a:pt x="6" y="6"/>
                    </a:lnTo>
                    <a:lnTo>
                      <a:pt x="6" y="7241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Freeform: Shape 85">
                <a:extLst>
                  <a:ext uri="{FF2B5EF4-FFF2-40B4-BE49-F238E27FC236}">
                    <a16:creationId xmlns:a16="http://schemas.microsoft.com/office/drawing/2014/main" id="{49583A84-7352-2C1A-3C1F-A0DA9D38DFCC}"/>
                  </a:ext>
                </a:extLst>
              </p:cNvPr>
              <p:cNvSpPr/>
              <p:nvPr/>
            </p:nvSpPr>
            <p:spPr>
              <a:xfrm>
                <a:off x="9376041" y="2066156"/>
                <a:ext cx="5783" cy="77368"/>
              </a:xfrm>
              <a:custGeom>
                <a:avLst/>
                <a:gdLst>
                  <a:gd name="connsiteX0" fmla="*/ 6 w 5783"/>
                  <a:gd name="connsiteY0" fmla="*/ 77374 h 77368"/>
                  <a:gd name="connsiteX1" fmla="*/ 6 w 5783"/>
                  <a:gd name="connsiteY1" fmla="*/ 77374 h 77368"/>
                  <a:gd name="connsiteX2" fmla="*/ 6 w 5783"/>
                  <a:gd name="connsiteY2" fmla="*/ 6 h 7736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7368">
                    <a:moveTo>
                      <a:pt x="6" y="77374"/>
                    </a:moveTo>
                    <a:lnTo>
                      <a:pt x="6" y="7737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Freeform: Shape 86">
                <a:extLst>
                  <a:ext uri="{FF2B5EF4-FFF2-40B4-BE49-F238E27FC236}">
                    <a16:creationId xmlns:a16="http://schemas.microsoft.com/office/drawing/2014/main" id="{C6266C8F-DDEB-33E2-2A0C-40E6DFE2DA21}"/>
                  </a:ext>
                </a:extLst>
              </p:cNvPr>
              <p:cNvSpPr/>
              <p:nvPr/>
            </p:nvSpPr>
            <p:spPr>
              <a:xfrm>
                <a:off x="9376330" y="2828705"/>
                <a:ext cx="5783" cy="106194"/>
              </a:xfrm>
              <a:custGeom>
                <a:avLst/>
                <a:gdLst>
                  <a:gd name="connsiteX0" fmla="*/ 6 w 5783"/>
                  <a:gd name="connsiteY0" fmla="*/ 106200 h 106194"/>
                  <a:gd name="connsiteX1" fmla="*/ 6 w 5783"/>
                  <a:gd name="connsiteY1" fmla="*/ 106200 h 106194"/>
                  <a:gd name="connsiteX2" fmla="*/ 6 w 5783"/>
                  <a:gd name="connsiteY2" fmla="*/ 6 h 1061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106194">
                    <a:moveTo>
                      <a:pt x="6" y="106200"/>
                    </a:moveTo>
                    <a:lnTo>
                      <a:pt x="6" y="106200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Freeform: Shape 87">
                <a:extLst>
                  <a:ext uri="{FF2B5EF4-FFF2-40B4-BE49-F238E27FC236}">
                    <a16:creationId xmlns:a16="http://schemas.microsoft.com/office/drawing/2014/main" id="{D62C87D0-4F4B-155A-AB43-9DC097CDB7AB}"/>
                  </a:ext>
                </a:extLst>
              </p:cNvPr>
              <p:cNvSpPr/>
              <p:nvPr/>
            </p:nvSpPr>
            <p:spPr>
              <a:xfrm>
                <a:off x="4053371" y="260697"/>
                <a:ext cx="1100964" cy="159293"/>
              </a:xfrm>
              <a:custGeom>
                <a:avLst/>
                <a:gdLst>
                  <a:gd name="connsiteX0" fmla="*/ 1100970 w 1100964"/>
                  <a:gd name="connsiteY0" fmla="*/ 6 h 159293"/>
                  <a:gd name="connsiteX1" fmla="*/ 6 w 1100964"/>
                  <a:gd name="connsiteY1" fmla="*/ 6 h 159293"/>
                  <a:gd name="connsiteX2" fmla="*/ 6 w 1100964"/>
                  <a:gd name="connsiteY2" fmla="*/ 159300 h 1592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00964" h="159293">
                    <a:moveTo>
                      <a:pt x="1100970" y="6"/>
                    </a:moveTo>
                    <a:lnTo>
                      <a:pt x="6" y="6"/>
                    </a:lnTo>
                    <a:lnTo>
                      <a:pt x="6" y="159300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Freeform: Shape 88">
                <a:extLst>
                  <a:ext uri="{FF2B5EF4-FFF2-40B4-BE49-F238E27FC236}">
                    <a16:creationId xmlns:a16="http://schemas.microsoft.com/office/drawing/2014/main" id="{18E3D510-B5A4-DFC7-9637-C95D9C21E269}"/>
                  </a:ext>
                </a:extLst>
              </p:cNvPr>
              <p:cNvSpPr/>
              <p:nvPr/>
            </p:nvSpPr>
            <p:spPr>
              <a:xfrm>
                <a:off x="9376157" y="2298781"/>
                <a:ext cx="5783" cy="78287"/>
              </a:xfrm>
              <a:custGeom>
                <a:avLst/>
                <a:gdLst>
                  <a:gd name="connsiteX0" fmla="*/ 6 w 5783"/>
                  <a:gd name="connsiteY0" fmla="*/ 78294 h 78287"/>
                  <a:gd name="connsiteX1" fmla="*/ 6 w 5783"/>
                  <a:gd name="connsiteY1" fmla="*/ 78294 h 78287"/>
                  <a:gd name="connsiteX2" fmla="*/ 6 w 5783"/>
                  <a:gd name="connsiteY2" fmla="*/ 6 h 782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8287">
                    <a:moveTo>
                      <a:pt x="6" y="78294"/>
                    </a:moveTo>
                    <a:lnTo>
                      <a:pt x="6" y="7829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Freeform: Shape 89">
                <a:extLst>
                  <a:ext uri="{FF2B5EF4-FFF2-40B4-BE49-F238E27FC236}">
                    <a16:creationId xmlns:a16="http://schemas.microsoft.com/office/drawing/2014/main" id="{84E773D0-F412-1020-CAEC-28594BE1BDF3}"/>
                  </a:ext>
                </a:extLst>
              </p:cNvPr>
              <p:cNvSpPr/>
              <p:nvPr/>
            </p:nvSpPr>
            <p:spPr>
              <a:xfrm>
                <a:off x="6077897" y="984758"/>
                <a:ext cx="1101559" cy="256558"/>
              </a:xfrm>
              <a:custGeom>
                <a:avLst/>
                <a:gdLst>
                  <a:gd name="connsiteX0" fmla="*/ 1101566 w 1101559"/>
                  <a:gd name="connsiteY0" fmla="*/ 6 h 256558"/>
                  <a:gd name="connsiteX1" fmla="*/ 6 w 1101559"/>
                  <a:gd name="connsiteY1" fmla="*/ 6 h 256558"/>
                  <a:gd name="connsiteX2" fmla="*/ 6 w 1101559"/>
                  <a:gd name="connsiteY2" fmla="*/ 256564 h 25655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01559" h="256558">
                    <a:moveTo>
                      <a:pt x="1101566" y="6"/>
                    </a:moveTo>
                    <a:lnTo>
                      <a:pt x="6" y="6"/>
                    </a:lnTo>
                    <a:lnTo>
                      <a:pt x="6" y="25656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Freeform: Shape 90">
                <a:extLst>
                  <a:ext uri="{FF2B5EF4-FFF2-40B4-BE49-F238E27FC236}">
                    <a16:creationId xmlns:a16="http://schemas.microsoft.com/office/drawing/2014/main" id="{F45FA57A-2C59-3BDD-F40D-3AB9FC60A17B}"/>
                  </a:ext>
                </a:extLst>
              </p:cNvPr>
              <p:cNvSpPr/>
              <p:nvPr/>
            </p:nvSpPr>
            <p:spPr>
              <a:xfrm>
                <a:off x="5528788" y="5387059"/>
                <a:ext cx="5" cy="67576"/>
              </a:xfrm>
              <a:custGeom>
                <a:avLst/>
                <a:gdLst>
                  <a:gd name="connsiteX0" fmla="*/ 12 w 5"/>
                  <a:gd name="connsiteY0" fmla="*/ 6 h 67576"/>
                  <a:gd name="connsiteX1" fmla="*/ 6 w 5"/>
                  <a:gd name="connsiteY1" fmla="*/ 6 h 67576"/>
                  <a:gd name="connsiteX2" fmla="*/ 6 w 5"/>
                  <a:gd name="connsiteY2" fmla="*/ 67582 h 675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" h="67576">
                    <a:moveTo>
                      <a:pt x="12" y="6"/>
                    </a:moveTo>
                    <a:lnTo>
                      <a:pt x="6" y="6"/>
                    </a:lnTo>
                    <a:lnTo>
                      <a:pt x="6" y="6758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Freeform: Shape 91">
                <a:extLst>
                  <a:ext uri="{FF2B5EF4-FFF2-40B4-BE49-F238E27FC236}">
                    <a16:creationId xmlns:a16="http://schemas.microsoft.com/office/drawing/2014/main" id="{075B5E3C-3758-ECAA-3F28-9C60131762E9}"/>
                  </a:ext>
                </a:extLst>
              </p:cNvPr>
              <p:cNvSpPr/>
              <p:nvPr/>
            </p:nvSpPr>
            <p:spPr>
              <a:xfrm>
                <a:off x="5528586" y="4632977"/>
                <a:ext cx="28" cy="95488"/>
              </a:xfrm>
              <a:custGeom>
                <a:avLst/>
                <a:gdLst>
                  <a:gd name="connsiteX0" fmla="*/ 35 w 28"/>
                  <a:gd name="connsiteY0" fmla="*/ 95494 h 95488"/>
                  <a:gd name="connsiteX1" fmla="*/ 6 w 28"/>
                  <a:gd name="connsiteY1" fmla="*/ 95494 h 95488"/>
                  <a:gd name="connsiteX2" fmla="*/ 6 w 28"/>
                  <a:gd name="connsiteY2" fmla="*/ 6 h 954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95488">
                    <a:moveTo>
                      <a:pt x="35" y="95494"/>
                    </a:moveTo>
                    <a:lnTo>
                      <a:pt x="6" y="9549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Freeform: Shape 92">
                <a:extLst>
                  <a:ext uri="{FF2B5EF4-FFF2-40B4-BE49-F238E27FC236}">
                    <a16:creationId xmlns:a16="http://schemas.microsoft.com/office/drawing/2014/main" id="{1A1819A9-66A6-54E5-A5DD-58F3A4A3A1DC}"/>
                  </a:ext>
                </a:extLst>
              </p:cNvPr>
              <p:cNvSpPr/>
              <p:nvPr/>
            </p:nvSpPr>
            <p:spPr>
              <a:xfrm>
                <a:off x="5528719" y="4923659"/>
                <a:ext cx="6" cy="150844"/>
              </a:xfrm>
              <a:custGeom>
                <a:avLst/>
                <a:gdLst>
                  <a:gd name="connsiteX0" fmla="*/ 12 w 6"/>
                  <a:gd name="connsiteY0" fmla="*/ 6 h 150844"/>
                  <a:gd name="connsiteX1" fmla="*/ 6 w 6"/>
                  <a:gd name="connsiteY1" fmla="*/ 6 h 150844"/>
                  <a:gd name="connsiteX2" fmla="*/ 6 w 6"/>
                  <a:gd name="connsiteY2" fmla="*/ 150850 h 15084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150844">
                    <a:moveTo>
                      <a:pt x="12" y="6"/>
                    </a:moveTo>
                    <a:lnTo>
                      <a:pt x="6" y="6"/>
                    </a:lnTo>
                    <a:lnTo>
                      <a:pt x="6" y="150850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Freeform: Shape 93">
                <a:extLst>
                  <a:ext uri="{FF2B5EF4-FFF2-40B4-BE49-F238E27FC236}">
                    <a16:creationId xmlns:a16="http://schemas.microsoft.com/office/drawing/2014/main" id="{037FE56C-7F47-B84C-5D02-BC393215F89A}"/>
                  </a:ext>
                </a:extLst>
              </p:cNvPr>
              <p:cNvSpPr/>
              <p:nvPr/>
            </p:nvSpPr>
            <p:spPr>
              <a:xfrm>
                <a:off x="7010053" y="135193"/>
                <a:ext cx="5783" cy="38616"/>
              </a:xfrm>
              <a:custGeom>
                <a:avLst/>
                <a:gdLst>
                  <a:gd name="connsiteX0" fmla="*/ 6 w 5783"/>
                  <a:gd name="connsiteY0" fmla="*/ 6 h 38616"/>
                  <a:gd name="connsiteX1" fmla="*/ 6 w 5783"/>
                  <a:gd name="connsiteY1" fmla="*/ 6 h 38616"/>
                  <a:gd name="connsiteX2" fmla="*/ 6 w 5783"/>
                  <a:gd name="connsiteY2" fmla="*/ 38622 h 3861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6">
                    <a:moveTo>
                      <a:pt x="6" y="6"/>
                    </a:moveTo>
                    <a:lnTo>
                      <a:pt x="6" y="6"/>
                    </a:lnTo>
                    <a:lnTo>
                      <a:pt x="6" y="3862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Freeform: Shape 94">
                <a:extLst>
                  <a:ext uri="{FF2B5EF4-FFF2-40B4-BE49-F238E27FC236}">
                    <a16:creationId xmlns:a16="http://schemas.microsoft.com/office/drawing/2014/main" id="{88181F8B-AE87-6AB3-229F-06DC119E8799}"/>
                  </a:ext>
                </a:extLst>
              </p:cNvPr>
              <p:cNvSpPr/>
              <p:nvPr/>
            </p:nvSpPr>
            <p:spPr>
              <a:xfrm>
                <a:off x="9376272" y="2623552"/>
                <a:ext cx="5783" cy="94129"/>
              </a:xfrm>
              <a:custGeom>
                <a:avLst/>
                <a:gdLst>
                  <a:gd name="connsiteX0" fmla="*/ 6 w 5783"/>
                  <a:gd name="connsiteY0" fmla="*/ 94135 h 94129"/>
                  <a:gd name="connsiteX1" fmla="*/ 6 w 5783"/>
                  <a:gd name="connsiteY1" fmla="*/ 94135 h 94129"/>
                  <a:gd name="connsiteX2" fmla="*/ 6 w 5783"/>
                  <a:gd name="connsiteY2" fmla="*/ 6 h 941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94129">
                    <a:moveTo>
                      <a:pt x="6" y="94135"/>
                    </a:moveTo>
                    <a:lnTo>
                      <a:pt x="6" y="94135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Freeform: Shape 95">
                <a:extLst>
                  <a:ext uri="{FF2B5EF4-FFF2-40B4-BE49-F238E27FC236}">
                    <a16:creationId xmlns:a16="http://schemas.microsoft.com/office/drawing/2014/main" id="{30727753-AC3B-7DB1-2EC3-CE0EB577AE5C}"/>
                  </a:ext>
                </a:extLst>
              </p:cNvPr>
              <p:cNvSpPr/>
              <p:nvPr/>
            </p:nvSpPr>
            <p:spPr>
              <a:xfrm>
                <a:off x="9376388" y="3031441"/>
                <a:ext cx="5783" cy="77235"/>
              </a:xfrm>
              <a:custGeom>
                <a:avLst/>
                <a:gdLst>
                  <a:gd name="connsiteX0" fmla="*/ 6 w 5783"/>
                  <a:gd name="connsiteY0" fmla="*/ 77241 h 77235"/>
                  <a:gd name="connsiteX1" fmla="*/ 6 w 5783"/>
                  <a:gd name="connsiteY1" fmla="*/ 77241 h 77235"/>
                  <a:gd name="connsiteX2" fmla="*/ 6 w 5783"/>
                  <a:gd name="connsiteY2" fmla="*/ 6 h 772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7235">
                    <a:moveTo>
                      <a:pt x="6" y="77241"/>
                    </a:moveTo>
                    <a:lnTo>
                      <a:pt x="6" y="7724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Freeform: Shape 96">
                <a:extLst>
                  <a:ext uri="{FF2B5EF4-FFF2-40B4-BE49-F238E27FC236}">
                    <a16:creationId xmlns:a16="http://schemas.microsoft.com/office/drawing/2014/main" id="{F08EFE51-5041-0A37-9CC5-BD4C6C3014C3}"/>
                  </a:ext>
                </a:extLst>
              </p:cNvPr>
              <p:cNvSpPr/>
              <p:nvPr/>
            </p:nvSpPr>
            <p:spPr>
              <a:xfrm>
                <a:off x="7184546" y="1497869"/>
                <a:ext cx="1096123" cy="435875"/>
              </a:xfrm>
              <a:custGeom>
                <a:avLst/>
                <a:gdLst>
                  <a:gd name="connsiteX0" fmla="*/ 1096129 w 1096123"/>
                  <a:gd name="connsiteY0" fmla="*/ 435882 h 435875"/>
                  <a:gd name="connsiteX1" fmla="*/ 6 w 1096123"/>
                  <a:gd name="connsiteY1" fmla="*/ 435882 h 435875"/>
                  <a:gd name="connsiteX2" fmla="*/ 6 w 1096123"/>
                  <a:gd name="connsiteY2" fmla="*/ 6 h 4358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096123" h="435875">
                    <a:moveTo>
                      <a:pt x="1096129" y="435882"/>
                    </a:moveTo>
                    <a:lnTo>
                      <a:pt x="6" y="43588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Freeform: Shape 97">
                <a:extLst>
                  <a:ext uri="{FF2B5EF4-FFF2-40B4-BE49-F238E27FC236}">
                    <a16:creationId xmlns:a16="http://schemas.microsoft.com/office/drawing/2014/main" id="{2CE4225F-F91E-B7DF-36BD-6322F707C4B6}"/>
                  </a:ext>
                </a:extLst>
              </p:cNvPr>
              <p:cNvSpPr/>
              <p:nvPr/>
            </p:nvSpPr>
            <p:spPr>
              <a:xfrm>
                <a:off x="7712423" y="405509"/>
                <a:ext cx="2756039" cy="38616"/>
              </a:xfrm>
              <a:custGeom>
                <a:avLst/>
                <a:gdLst>
                  <a:gd name="connsiteX0" fmla="*/ 2756046 w 2756039"/>
                  <a:gd name="connsiteY0" fmla="*/ 38622 h 38616"/>
                  <a:gd name="connsiteX1" fmla="*/ 6 w 2756039"/>
                  <a:gd name="connsiteY1" fmla="*/ 38622 h 38616"/>
                  <a:gd name="connsiteX2" fmla="*/ 6 w 2756039"/>
                  <a:gd name="connsiteY2" fmla="*/ 6 h 3861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756039" h="38616">
                    <a:moveTo>
                      <a:pt x="2756046" y="38622"/>
                    </a:moveTo>
                    <a:lnTo>
                      <a:pt x="6" y="3862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Freeform: Shape 98">
                <a:extLst>
                  <a:ext uri="{FF2B5EF4-FFF2-40B4-BE49-F238E27FC236}">
                    <a16:creationId xmlns:a16="http://schemas.microsoft.com/office/drawing/2014/main" id="{D15D8577-7DE6-9504-48F7-078A8E9C0736}"/>
                  </a:ext>
                </a:extLst>
              </p:cNvPr>
              <p:cNvSpPr/>
              <p:nvPr/>
            </p:nvSpPr>
            <p:spPr>
              <a:xfrm>
                <a:off x="7162973" y="289659"/>
                <a:ext cx="5783" cy="57925"/>
              </a:xfrm>
              <a:custGeom>
                <a:avLst/>
                <a:gdLst>
                  <a:gd name="connsiteX0" fmla="*/ 6 w 5783"/>
                  <a:gd name="connsiteY0" fmla="*/ 6 h 57925"/>
                  <a:gd name="connsiteX1" fmla="*/ 6 w 5783"/>
                  <a:gd name="connsiteY1" fmla="*/ 6 h 57925"/>
                  <a:gd name="connsiteX2" fmla="*/ 6 w 5783"/>
                  <a:gd name="connsiteY2" fmla="*/ 57931 h 579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57925">
                    <a:moveTo>
                      <a:pt x="6" y="6"/>
                    </a:moveTo>
                    <a:lnTo>
                      <a:pt x="6" y="6"/>
                    </a:lnTo>
                    <a:lnTo>
                      <a:pt x="6" y="57931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Freeform: Shape 99">
                <a:extLst>
                  <a:ext uri="{FF2B5EF4-FFF2-40B4-BE49-F238E27FC236}">
                    <a16:creationId xmlns:a16="http://schemas.microsoft.com/office/drawing/2014/main" id="{1C817CF7-6F0F-DF94-03C4-F485407FE868}"/>
                  </a:ext>
                </a:extLst>
              </p:cNvPr>
              <p:cNvSpPr/>
              <p:nvPr/>
            </p:nvSpPr>
            <p:spPr>
              <a:xfrm>
                <a:off x="8280669" y="1933744"/>
                <a:ext cx="57" cy="717882"/>
              </a:xfrm>
              <a:custGeom>
                <a:avLst/>
                <a:gdLst>
                  <a:gd name="connsiteX0" fmla="*/ 64 w 57"/>
                  <a:gd name="connsiteY0" fmla="*/ 717888 h 717882"/>
                  <a:gd name="connsiteX1" fmla="*/ 6 w 57"/>
                  <a:gd name="connsiteY1" fmla="*/ 717888 h 717882"/>
                  <a:gd name="connsiteX2" fmla="*/ 6 w 57"/>
                  <a:gd name="connsiteY2" fmla="*/ 6 h 7178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17882">
                    <a:moveTo>
                      <a:pt x="64" y="717888"/>
                    </a:moveTo>
                    <a:lnTo>
                      <a:pt x="6" y="717888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Freeform: Shape 100">
                <a:extLst>
                  <a:ext uri="{FF2B5EF4-FFF2-40B4-BE49-F238E27FC236}">
                    <a16:creationId xmlns:a16="http://schemas.microsoft.com/office/drawing/2014/main" id="{2F5759BF-C62B-379A-48B7-DE593DF20077}"/>
                  </a:ext>
                </a:extLst>
              </p:cNvPr>
              <p:cNvSpPr/>
              <p:nvPr/>
            </p:nvSpPr>
            <p:spPr>
              <a:xfrm>
                <a:off x="5528759" y="5773224"/>
                <a:ext cx="5" cy="67582"/>
              </a:xfrm>
              <a:custGeom>
                <a:avLst/>
                <a:gdLst>
                  <a:gd name="connsiteX0" fmla="*/ 12 w 5"/>
                  <a:gd name="connsiteY0" fmla="*/ 6 h 67582"/>
                  <a:gd name="connsiteX1" fmla="*/ 6 w 5"/>
                  <a:gd name="connsiteY1" fmla="*/ 6 h 67582"/>
                  <a:gd name="connsiteX2" fmla="*/ 6 w 5"/>
                  <a:gd name="connsiteY2" fmla="*/ 67588 h 675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" h="67582">
                    <a:moveTo>
                      <a:pt x="12" y="6"/>
                    </a:moveTo>
                    <a:lnTo>
                      <a:pt x="6" y="6"/>
                    </a:lnTo>
                    <a:lnTo>
                      <a:pt x="6" y="6758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Freeform: Shape 101">
                <a:extLst>
                  <a:ext uri="{FF2B5EF4-FFF2-40B4-BE49-F238E27FC236}">
                    <a16:creationId xmlns:a16="http://schemas.microsoft.com/office/drawing/2014/main" id="{F01D5608-6D34-D345-9CCB-969B73A80B92}"/>
                  </a:ext>
                </a:extLst>
              </p:cNvPr>
              <p:cNvSpPr/>
              <p:nvPr/>
            </p:nvSpPr>
            <p:spPr>
              <a:xfrm>
                <a:off x="7010053" y="173809"/>
                <a:ext cx="5783" cy="38617"/>
              </a:xfrm>
              <a:custGeom>
                <a:avLst/>
                <a:gdLst>
                  <a:gd name="connsiteX0" fmla="*/ 6 w 5783"/>
                  <a:gd name="connsiteY0" fmla="*/ 38623 h 38617"/>
                  <a:gd name="connsiteX1" fmla="*/ 6 w 5783"/>
                  <a:gd name="connsiteY1" fmla="*/ 38623 h 38617"/>
                  <a:gd name="connsiteX2" fmla="*/ 6 w 5783"/>
                  <a:gd name="connsiteY2" fmla="*/ 6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7">
                    <a:moveTo>
                      <a:pt x="6" y="38623"/>
                    </a:moveTo>
                    <a:lnTo>
                      <a:pt x="6" y="38623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Freeform: Shape 102">
                <a:extLst>
                  <a:ext uri="{FF2B5EF4-FFF2-40B4-BE49-F238E27FC236}">
                    <a16:creationId xmlns:a16="http://schemas.microsoft.com/office/drawing/2014/main" id="{8A1904A1-D035-07A3-D13A-291EC521A04E}"/>
                  </a:ext>
                </a:extLst>
              </p:cNvPr>
              <p:cNvSpPr/>
              <p:nvPr/>
            </p:nvSpPr>
            <p:spPr>
              <a:xfrm>
                <a:off x="9373323" y="4023406"/>
                <a:ext cx="5783" cy="103782"/>
              </a:xfrm>
              <a:custGeom>
                <a:avLst/>
                <a:gdLst>
                  <a:gd name="connsiteX0" fmla="*/ 6 w 5783"/>
                  <a:gd name="connsiteY0" fmla="*/ 103788 h 103782"/>
                  <a:gd name="connsiteX1" fmla="*/ 6 w 5783"/>
                  <a:gd name="connsiteY1" fmla="*/ 103788 h 103782"/>
                  <a:gd name="connsiteX2" fmla="*/ 6 w 5783"/>
                  <a:gd name="connsiteY2" fmla="*/ 6 h 1037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103782">
                    <a:moveTo>
                      <a:pt x="6" y="103788"/>
                    </a:moveTo>
                    <a:lnTo>
                      <a:pt x="6" y="103788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Freeform: Shape 103">
                <a:extLst>
                  <a:ext uri="{FF2B5EF4-FFF2-40B4-BE49-F238E27FC236}">
                    <a16:creationId xmlns:a16="http://schemas.microsoft.com/office/drawing/2014/main" id="{D4D23068-9D99-3677-DC6A-865B6DD73DE8}"/>
                  </a:ext>
                </a:extLst>
              </p:cNvPr>
              <p:cNvSpPr/>
              <p:nvPr/>
            </p:nvSpPr>
            <p:spPr>
              <a:xfrm>
                <a:off x="5528759" y="5382230"/>
                <a:ext cx="28" cy="72405"/>
              </a:xfrm>
              <a:custGeom>
                <a:avLst/>
                <a:gdLst>
                  <a:gd name="connsiteX0" fmla="*/ 35 w 28"/>
                  <a:gd name="connsiteY0" fmla="*/ 72412 h 72405"/>
                  <a:gd name="connsiteX1" fmla="*/ 6 w 28"/>
                  <a:gd name="connsiteY1" fmla="*/ 72412 h 72405"/>
                  <a:gd name="connsiteX2" fmla="*/ 6 w 28"/>
                  <a:gd name="connsiteY2" fmla="*/ 6 h 724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72405">
                    <a:moveTo>
                      <a:pt x="35" y="72412"/>
                    </a:moveTo>
                    <a:lnTo>
                      <a:pt x="6" y="7241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Freeform: Shape 104">
                <a:extLst>
                  <a:ext uri="{FF2B5EF4-FFF2-40B4-BE49-F238E27FC236}">
                    <a16:creationId xmlns:a16="http://schemas.microsoft.com/office/drawing/2014/main" id="{B67A4BB1-BD03-D21D-357F-1016DE805297}"/>
                  </a:ext>
                </a:extLst>
              </p:cNvPr>
              <p:cNvSpPr/>
              <p:nvPr/>
            </p:nvSpPr>
            <p:spPr>
              <a:xfrm>
                <a:off x="5528759" y="6120783"/>
                <a:ext cx="5783" cy="38634"/>
              </a:xfrm>
              <a:custGeom>
                <a:avLst/>
                <a:gdLst>
                  <a:gd name="connsiteX0" fmla="*/ 6 w 5783"/>
                  <a:gd name="connsiteY0" fmla="*/ 38641 h 38634"/>
                  <a:gd name="connsiteX1" fmla="*/ 6 w 5783"/>
                  <a:gd name="connsiteY1" fmla="*/ 38641 h 38634"/>
                  <a:gd name="connsiteX2" fmla="*/ 6 w 5783"/>
                  <a:gd name="connsiteY2" fmla="*/ 6 h 386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34">
                    <a:moveTo>
                      <a:pt x="6" y="38641"/>
                    </a:moveTo>
                    <a:lnTo>
                      <a:pt x="6" y="3864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Freeform: Shape 105">
                <a:extLst>
                  <a:ext uri="{FF2B5EF4-FFF2-40B4-BE49-F238E27FC236}">
                    <a16:creationId xmlns:a16="http://schemas.microsoft.com/office/drawing/2014/main" id="{D5FC27E8-86B4-9B58-BFD5-11E69B8D140C}"/>
                  </a:ext>
                </a:extLst>
              </p:cNvPr>
              <p:cNvSpPr/>
              <p:nvPr/>
            </p:nvSpPr>
            <p:spPr>
              <a:xfrm>
                <a:off x="9376330" y="2722511"/>
                <a:ext cx="5783" cy="38611"/>
              </a:xfrm>
              <a:custGeom>
                <a:avLst/>
                <a:gdLst>
                  <a:gd name="connsiteX0" fmla="*/ 6 w 5783"/>
                  <a:gd name="connsiteY0" fmla="*/ 38618 h 38611"/>
                  <a:gd name="connsiteX1" fmla="*/ 6 w 5783"/>
                  <a:gd name="connsiteY1" fmla="*/ 38618 h 38611"/>
                  <a:gd name="connsiteX2" fmla="*/ 6 w 5783"/>
                  <a:gd name="connsiteY2" fmla="*/ 6 h 386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1">
                    <a:moveTo>
                      <a:pt x="6" y="38618"/>
                    </a:moveTo>
                    <a:lnTo>
                      <a:pt x="6" y="38618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Freeform: Shape 106">
                <a:extLst>
                  <a:ext uri="{FF2B5EF4-FFF2-40B4-BE49-F238E27FC236}">
                    <a16:creationId xmlns:a16="http://schemas.microsoft.com/office/drawing/2014/main" id="{6248608E-79DF-7D02-2C7F-8ACCD5B6BDC7}"/>
                  </a:ext>
                </a:extLst>
              </p:cNvPr>
              <p:cNvSpPr/>
              <p:nvPr/>
            </p:nvSpPr>
            <p:spPr>
              <a:xfrm>
                <a:off x="9373323" y="4035476"/>
                <a:ext cx="57" cy="91711"/>
              </a:xfrm>
              <a:custGeom>
                <a:avLst/>
                <a:gdLst>
                  <a:gd name="connsiteX0" fmla="*/ 64 w 57"/>
                  <a:gd name="connsiteY0" fmla="*/ 6 h 91711"/>
                  <a:gd name="connsiteX1" fmla="*/ 6 w 57"/>
                  <a:gd name="connsiteY1" fmla="*/ 6 h 91711"/>
                  <a:gd name="connsiteX2" fmla="*/ 6 w 57"/>
                  <a:gd name="connsiteY2" fmla="*/ 91718 h 917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91711">
                    <a:moveTo>
                      <a:pt x="64" y="6"/>
                    </a:moveTo>
                    <a:lnTo>
                      <a:pt x="6" y="6"/>
                    </a:lnTo>
                    <a:lnTo>
                      <a:pt x="6" y="9171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Freeform: Shape 107">
                <a:extLst>
                  <a:ext uri="{FF2B5EF4-FFF2-40B4-BE49-F238E27FC236}">
                    <a16:creationId xmlns:a16="http://schemas.microsoft.com/office/drawing/2014/main" id="{71CF9ECF-5462-8B31-FA35-347C0CAC121B}"/>
                  </a:ext>
                </a:extLst>
              </p:cNvPr>
              <p:cNvSpPr/>
              <p:nvPr/>
            </p:nvSpPr>
            <p:spPr>
              <a:xfrm>
                <a:off x="8827343" y="1215856"/>
                <a:ext cx="57" cy="76627"/>
              </a:xfrm>
              <a:custGeom>
                <a:avLst/>
                <a:gdLst>
                  <a:gd name="connsiteX0" fmla="*/ 64 w 57"/>
                  <a:gd name="connsiteY0" fmla="*/ 76634 h 76627"/>
                  <a:gd name="connsiteX1" fmla="*/ 6 w 57"/>
                  <a:gd name="connsiteY1" fmla="*/ 76634 h 76627"/>
                  <a:gd name="connsiteX2" fmla="*/ 6 w 57"/>
                  <a:gd name="connsiteY2" fmla="*/ 6 h 766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6627">
                    <a:moveTo>
                      <a:pt x="64" y="76634"/>
                    </a:moveTo>
                    <a:lnTo>
                      <a:pt x="6" y="7663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Freeform: Shape 108">
                <a:extLst>
                  <a:ext uri="{FF2B5EF4-FFF2-40B4-BE49-F238E27FC236}">
                    <a16:creationId xmlns:a16="http://schemas.microsoft.com/office/drawing/2014/main" id="{6C68953B-2494-BB3E-864E-14FC142B2F83}"/>
                  </a:ext>
                </a:extLst>
              </p:cNvPr>
              <p:cNvSpPr/>
              <p:nvPr/>
            </p:nvSpPr>
            <p:spPr>
              <a:xfrm>
                <a:off x="8828384" y="1863322"/>
                <a:ext cx="57" cy="106228"/>
              </a:xfrm>
              <a:custGeom>
                <a:avLst/>
                <a:gdLst>
                  <a:gd name="connsiteX0" fmla="*/ 63 w 57"/>
                  <a:gd name="connsiteY0" fmla="*/ 106235 h 106228"/>
                  <a:gd name="connsiteX1" fmla="*/ 6 w 57"/>
                  <a:gd name="connsiteY1" fmla="*/ 106235 h 106228"/>
                  <a:gd name="connsiteX2" fmla="*/ 6 w 57"/>
                  <a:gd name="connsiteY2" fmla="*/ 6 h 1062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106228">
                    <a:moveTo>
                      <a:pt x="63" y="106235"/>
                    </a:moveTo>
                    <a:lnTo>
                      <a:pt x="6" y="106235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Freeform: Shape 109">
                <a:extLst>
                  <a:ext uri="{FF2B5EF4-FFF2-40B4-BE49-F238E27FC236}">
                    <a16:creationId xmlns:a16="http://schemas.microsoft.com/office/drawing/2014/main" id="{6FB84F36-85ED-00CE-7C37-9AD3AA800A40}"/>
                  </a:ext>
                </a:extLst>
              </p:cNvPr>
              <p:cNvSpPr/>
              <p:nvPr/>
            </p:nvSpPr>
            <p:spPr>
              <a:xfrm>
                <a:off x="4980032" y="753058"/>
                <a:ext cx="40" cy="412220"/>
              </a:xfrm>
              <a:custGeom>
                <a:avLst/>
                <a:gdLst>
                  <a:gd name="connsiteX0" fmla="*/ 47 w 40"/>
                  <a:gd name="connsiteY0" fmla="*/ 6 h 412220"/>
                  <a:gd name="connsiteX1" fmla="*/ 6 w 40"/>
                  <a:gd name="connsiteY1" fmla="*/ 6 h 412220"/>
                  <a:gd name="connsiteX2" fmla="*/ 6 w 40"/>
                  <a:gd name="connsiteY2" fmla="*/ 412226 h 4122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40" h="412220">
                    <a:moveTo>
                      <a:pt x="47" y="6"/>
                    </a:moveTo>
                    <a:lnTo>
                      <a:pt x="6" y="6"/>
                    </a:lnTo>
                    <a:lnTo>
                      <a:pt x="6" y="41222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Freeform: Shape 110">
                <a:extLst>
                  <a:ext uri="{FF2B5EF4-FFF2-40B4-BE49-F238E27FC236}">
                    <a16:creationId xmlns:a16="http://schemas.microsoft.com/office/drawing/2014/main" id="{B7C87F55-BE7B-127C-B68B-2717CA5D9605}"/>
                  </a:ext>
                </a:extLst>
              </p:cNvPr>
              <p:cNvSpPr/>
              <p:nvPr/>
            </p:nvSpPr>
            <p:spPr>
              <a:xfrm>
                <a:off x="6577607" y="637209"/>
                <a:ext cx="1102137" cy="38618"/>
              </a:xfrm>
              <a:custGeom>
                <a:avLst/>
                <a:gdLst>
                  <a:gd name="connsiteX0" fmla="*/ 1102144 w 1102137"/>
                  <a:gd name="connsiteY0" fmla="*/ 38625 h 38618"/>
                  <a:gd name="connsiteX1" fmla="*/ 6 w 1102137"/>
                  <a:gd name="connsiteY1" fmla="*/ 38625 h 38618"/>
                  <a:gd name="connsiteX2" fmla="*/ 6 w 1102137"/>
                  <a:gd name="connsiteY2" fmla="*/ 6 h 386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02137" h="38618">
                    <a:moveTo>
                      <a:pt x="1102144" y="38625"/>
                    </a:moveTo>
                    <a:lnTo>
                      <a:pt x="6" y="38625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Freeform: Shape 111">
                <a:extLst>
                  <a:ext uri="{FF2B5EF4-FFF2-40B4-BE49-F238E27FC236}">
                    <a16:creationId xmlns:a16="http://schemas.microsoft.com/office/drawing/2014/main" id="{DB0CC5B1-4185-129B-728F-9331CEB4B2A4}"/>
                  </a:ext>
                </a:extLst>
              </p:cNvPr>
              <p:cNvSpPr/>
              <p:nvPr/>
            </p:nvSpPr>
            <p:spPr>
              <a:xfrm>
                <a:off x="9376388" y="2954211"/>
                <a:ext cx="57" cy="38611"/>
              </a:xfrm>
              <a:custGeom>
                <a:avLst/>
                <a:gdLst>
                  <a:gd name="connsiteX0" fmla="*/ 63 w 57"/>
                  <a:gd name="connsiteY0" fmla="*/ 38618 h 38611"/>
                  <a:gd name="connsiteX1" fmla="*/ 6 w 57"/>
                  <a:gd name="connsiteY1" fmla="*/ 38618 h 38611"/>
                  <a:gd name="connsiteX2" fmla="*/ 6 w 57"/>
                  <a:gd name="connsiteY2" fmla="*/ 6 h 386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38611">
                    <a:moveTo>
                      <a:pt x="63" y="38618"/>
                    </a:moveTo>
                    <a:lnTo>
                      <a:pt x="6" y="38618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Freeform: Shape 112">
                <a:extLst>
                  <a:ext uri="{FF2B5EF4-FFF2-40B4-BE49-F238E27FC236}">
                    <a16:creationId xmlns:a16="http://schemas.microsoft.com/office/drawing/2014/main" id="{94FBBB5C-B113-590B-9FF5-57E33D0DA9E8}"/>
                  </a:ext>
                </a:extLst>
              </p:cNvPr>
              <p:cNvSpPr/>
              <p:nvPr/>
            </p:nvSpPr>
            <p:spPr>
              <a:xfrm>
                <a:off x="9376214" y="2374958"/>
                <a:ext cx="5783" cy="81457"/>
              </a:xfrm>
              <a:custGeom>
                <a:avLst/>
                <a:gdLst>
                  <a:gd name="connsiteX0" fmla="*/ 6 w 5783"/>
                  <a:gd name="connsiteY0" fmla="*/ 6 h 81457"/>
                  <a:gd name="connsiteX1" fmla="*/ 6 w 5783"/>
                  <a:gd name="connsiteY1" fmla="*/ 6 h 81457"/>
                  <a:gd name="connsiteX2" fmla="*/ 6 w 5783"/>
                  <a:gd name="connsiteY2" fmla="*/ 81463 h 8145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81457">
                    <a:moveTo>
                      <a:pt x="6" y="6"/>
                    </a:moveTo>
                    <a:lnTo>
                      <a:pt x="6" y="6"/>
                    </a:lnTo>
                    <a:lnTo>
                      <a:pt x="6" y="81463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Freeform: Shape 113">
                <a:extLst>
                  <a:ext uri="{FF2B5EF4-FFF2-40B4-BE49-F238E27FC236}">
                    <a16:creationId xmlns:a16="http://schemas.microsoft.com/office/drawing/2014/main" id="{8408CC28-8760-1F10-9BFB-1D7E1123612F}"/>
                  </a:ext>
                </a:extLst>
              </p:cNvPr>
              <p:cNvSpPr/>
              <p:nvPr/>
            </p:nvSpPr>
            <p:spPr>
              <a:xfrm>
                <a:off x="9376388" y="2915594"/>
                <a:ext cx="5783" cy="38617"/>
              </a:xfrm>
              <a:custGeom>
                <a:avLst/>
                <a:gdLst>
                  <a:gd name="connsiteX0" fmla="*/ 6 w 5783"/>
                  <a:gd name="connsiteY0" fmla="*/ 6 h 38617"/>
                  <a:gd name="connsiteX1" fmla="*/ 6 w 5783"/>
                  <a:gd name="connsiteY1" fmla="*/ 6 h 38617"/>
                  <a:gd name="connsiteX2" fmla="*/ 6 w 5783"/>
                  <a:gd name="connsiteY2" fmla="*/ 38624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7">
                    <a:moveTo>
                      <a:pt x="6" y="6"/>
                    </a:moveTo>
                    <a:lnTo>
                      <a:pt x="6" y="6"/>
                    </a:lnTo>
                    <a:lnTo>
                      <a:pt x="6" y="386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Freeform: Shape 114">
                <a:extLst>
                  <a:ext uri="{FF2B5EF4-FFF2-40B4-BE49-F238E27FC236}">
                    <a16:creationId xmlns:a16="http://schemas.microsoft.com/office/drawing/2014/main" id="{1CD194FA-D6A6-9431-E749-33BE26A4110A}"/>
                  </a:ext>
                </a:extLst>
              </p:cNvPr>
              <p:cNvSpPr/>
              <p:nvPr/>
            </p:nvSpPr>
            <p:spPr>
              <a:xfrm>
                <a:off x="5528649" y="4842202"/>
                <a:ext cx="17" cy="150242"/>
              </a:xfrm>
              <a:custGeom>
                <a:avLst/>
                <a:gdLst>
                  <a:gd name="connsiteX0" fmla="*/ 23 w 17"/>
                  <a:gd name="connsiteY0" fmla="*/ 150249 h 150242"/>
                  <a:gd name="connsiteX1" fmla="*/ 6 w 17"/>
                  <a:gd name="connsiteY1" fmla="*/ 150249 h 150242"/>
                  <a:gd name="connsiteX2" fmla="*/ 6 w 17"/>
                  <a:gd name="connsiteY2" fmla="*/ 6 h 1502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7" h="150242">
                    <a:moveTo>
                      <a:pt x="23" y="150249"/>
                    </a:moveTo>
                    <a:lnTo>
                      <a:pt x="6" y="150249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Freeform: Shape 115">
                <a:extLst>
                  <a:ext uri="{FF2B5EF4-FFF2-40B4-BE49-F238E27FC236}">
                    <a16:creationId xmlns:a16="http://schemas.microsoft.com/office/drawing/2014/main" id="{F6A91346-9C2B-0BD4-FFBD-CEAE717F16A4}"/>
                  </a:ext>
                </a:extLst>
              </p:cNvPr>
              <p:cNvSpPr/>
              <p:nvPr/>
            </p:nvSpPr>
            <p:spPr>
              <a:xfrm>
                <a:off x="8827517" y="1515740"/>
                <a:ext cx="5783" cy="67576"/>
              </a:xfrm>
              <a:custGeom>
                <a:avLst/>
                <a:gdLst>
                  <a:gd name="connsiteX0" fmla="*/ 6 w 5783"/>
                  <a:gd name="connsiteY0" fmla="*/ 67583 h 67576"/>
                  <a:gd name="connsiteX1" fmla="*/ 6 w 5783"/>
                  <a:gd name="connsiteY1" fmla="*/ 67583 h 67576"/>
                  <a:gd name="connsiteX2" fmla="*/ 6 w 5783"/>
                  <a:gd name="connsiteY2" fmla="*/ 6 h 675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67576">
                    <a:moveTo>
                      <a:pt x="6" y="67583"/>
                    </a:moveTo>
                    <a:lnTo>
                      <a:pt x="6" y="67583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Freeform: Shape 116">
                <a:extLst>
                  <a:ext uri="{FF2B5EF4-FFF2-40B4-BE49-F238E27FC236}">
                    <a16:creationId xmlns:a16="http://schemas.microsoft.com/office/drawing/2014/main" id="{DFAEB0CD-D695-3F04-BBC3-409D74DCC372}"/>
                  </a:ext>
                </a:extLst>
              </p:cNvPr>
              <p:cNvSpPr/>
              <p:nvPr/>
            </p:nvSpPr>
            <p:spPr>
              <a:xfrm>
                <a:off x="5528828" y="5927666"/>
                <a:ext cx="561907" cy="38634"/>
              </a:xfrm>
              <a:custGeom>
                <a:avLst/>
                <a:gdLst>
                  <a:gd name="connsiteX0" fmla="*/ 561914 w 561907"/>
                  <a:gd name="connsiteY0" fmla="*/ 6 h 38634"/>
                  <a:gd name="connsiteX1" fmla="*/ 6 w 561907"/>
                  <a:gd name="connsiteY1" fmla="*/ 6 h 38634"/>
                  <a:gd name="connsiteX2" fmla="*/ 6 w 561907"/>
                  <a:gd name="connsiteY2" fmla="*/ 38641 h 386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61907" h="38634">
                    <a:moveTo>
                      <a:pt x="561914" y="6"/>
                    </a:moveTo>
                    <a:lnTo>
                      <a:pt x="6" y="6"/>
                    </a:lnTo>
                    <a:lnTo>
                      <a:pt x="6" y="38641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Freeform: Shape 117">
                <a:extLst>
                  <a:ext uri="{FF2B5EF4-FFF2-40B4-BE49-F238E27FC236}">
                    <a16:creationId xmlns:a16="http://schemas.microsoft.com/office/drawing/2014/main" id="{131307BA-6B41-9A25-109F-217AFDB8AEE5}"/>
                  </a:ext>
                </a:extLst>
              </p:cNvPr>
              <p:cNvSpPr/>
              <p:nvPr/>
            </p:nvSpPr>
            <p:spPr>
              <a:xfrm>
                <a:off x="4980102" y="2324704"/>
                <a:ext cx="548460" cy="1417175"/>
              </a:xfrm>
              <a:custGeom>
                <a:avLst/>
                <a:gdLst>
                  <a:gd name="connsiteX0" fmla="*/ 548467 w 548460"/>
                  <a:gd name="connsiteY0" fmla="*/ 1417182 h 1417175"/>
                  <a:gd name="connsiteX1" fmla="*/ 6 w 548460"/>
                  <a:gd name="connsiteY1" fmla="*/ 1417182 h 1417175"/>
                  <a:gd name="connsiteX2" fmla="*/ 6 w 548460"/>
                  <a:gd name="connsiteY2" fmla="*/ 6 h 14171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8460" h="1417175">
                    <a:moveTo>
                      <a:pt x="548467" y="1417182"/>
                    </a:moveTo>
                    <a:lnTo>
                      <a:pt x="6" y="1417182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" name="Freeform: Shape 118">
                <a:extLst>
                  <a:ext uri="{FF2B5EF4-FFF2-40B4-BE49-F238E27FC236}">
                    <a16:creationId xmlns:a16="http://schemas.microsoft.com/office/drawing/2014/main" id="{100D28BC-7062-16B9-DFE6-C9EDFB8621E8}"/>
                  </a:ext>
                </a:extLst>
              </p:cNvPr>
              <p:cNvSpPr/>
              <p:nvPr/>
            </p:nvSpPr>
            <p:spPr>
              <a:xfrm>
                <a:off x="9376388" y="3070059"/>
                <a:ext cx="57" cy="38617"/>
              </a:xfrm>
              <a:custGeom>
                <a:avLst/>
                <a:gdLst>
                  <a:gd name="connsiteX0" fmla="*/ 63 w 57"/>
                  <a:gd name="connsiteY0" fmla="*/ 6 h 38617"/>
                  <a:gd name="connsiteX1" fmla="*/ 6 w 57"/>
                  <a:gd name="connsiteY1" fmla="*/ 6 h 38617"/>
                  <a:gd name="connsiteX2" fmla="*/ 6 w 57"/>
                  <a:gd name="connsiteY2" fmla="*/ 38624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38617">
                    <a:moveTo>
                      <a:pt x="63" y="6"/>
                    </a:moveTo>
                    <a:lnTo>
                      <a:pt x="6" y="6"/>
                    </a:lnTo>
                    <a:lnTo>
                      <a:pt x="6" y="386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Freeform: Shape 119">
                <a:extLst>
                  <a:ext uri="{FF2B5EF4-FFF2-40B4-BE49-F238E27FC236}">
                    <a16:creationId xmlns:a16="http://schemas.microsoft.com/office/drawing/2014/main" id="{9D7FD599-6642-01D3-34A5-43C7BDCBB978}"/>
                  </a:ext>
                </a:extLst>
              </p:cNvPr>
              <p:cNvSpPr/>
              <p:nvPr/>
            </p:nvSpPr>
            <p:spPr>
              <a:xfrm>
                <a:off x="7184546" y="1061993"/>
                <a:ext cx="1653554" cy="435875"/>
              </a:xfrm>
              <a:custGeom>
                <a:avLst/>
                <a:gdLst>
                  <a:gd name="connsiteX0" fmla="*/ 1653561 w 1653554"/>
                  <a:gd name="connsiteY0" fmla="*/ 6 h 435875"/>
                  <a:gd name="connsiteX1" fmla="*/ 6 w 1653554"/>
                  <a:gd name="connsiteY1" fmla="*/ 6 h 435875"/>
                  <a:gd name="connsiteX2" fmla="*/ 6 w 1653554"/>
                  <a:gd name="connsiteY2" fmla="*/ 435882 h 4358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53554" h="435875">
                    <a:moveTo>
                      <a:pt x="1653561" y="6"/>
                    </a:moveTo>
                    <a:lnTo>
                      <a:pt x="6" y="6"/>
                    </a:lnTo>
                    <a:lnTo>
                      <a:pt x="6" y="43588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Freeform: Shape 120">
                <a:extLst>
                  <a:ext uri="{FF2B5EF4-FFF2-40B4-BE49-F238E27FC236}">
                    <a16:creationId xmlns:a16="http://schemas.microsoft.com/office/drawing/2014/main" id="{6B1C411F-F117-0399-F7E6-AE9D47F02D8E}"/>
                  </a:ext>
                </a:extLst>
              </p:cNvPr>
              <p:cNvSpPr/>
              <p:nvPr/>
            </p:nvSpPr>
            <p:spPr>
              <a:xfrm>
                <a:off x="9376214" y="2452193"/>
                <a:ext cx="5783" cy="85679"/>
              </a:xfrm>
              <a:custGeom>
                <a:avLst/>
                <a:gdLst>
                  <a:gd name="connsiteX0" fmla="*/ 6 w 5783"/>
                  <a:gd name="connsiteY0" fmla="*/ 6 h 85679"/>
                  <a:gd name="connsiteX1" fmla="*/ 6 w 5783"/>
                  <a:gd name="connsiteY1" fmla="*/ 6 h 85679"/>
                  <a:gd name="connsiteX2" fmla="*/ 6 w 5783"/>
                  <a:gd name="connsiteY2" fmla="*/ 85686 h 8567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85679">
                    <a:moveTo>
                      <a:pt x="6" y="6"/>
                    </a:moveTo>
                    <a:lnTo>
                      <a:pt x="6" y="6"/>
                    </a:lnTo>
                    <a:lnTo>
                      <a:pt x="6" y="8568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Freeform: Shape 121">
                <a:extLst>
                  <a:ext uri="{FF2B5EF4-FFF2-40B4-BE49-F238E27FC236}">
                    <a16:creationId xmlns:a16="http://schemas.microsoft.com/office/drawing/2014/main" id="{F1C0AA2A-7BF9-0E97-B563-A70D2BE5E638}"/>
                  </a:ext>
                </a:extLst>
              </p:cNvPr>
              <p:cNvSpPr/>
              <p:nvPr/>
            </p:nvSpPr>
            <p:spPr>
              <a:xfrm>
                <a:off x="9373323" y="3919623"/>
                <a:ext cx="5783" cy="103782"/>
              </a:xfrm>
              <a:custGeom>
                <a:avLst/>
                <a:gdLst>
                  <a:gd name="connsiteX0" fmla="*/ 6 w 5783"/>
                  <a:gd name="connsiteY0" fmla="*/ 6 h 103782"/>
                  <a:gd name="connsiteX1" fmla="*/ 6 w 5783"/>
                  <a:gd name="connsiteY1" fmla="*/ 6 h 103782"/>
                  <a:gd name="connsiteX2" fmla="*/ 6 w 5783"/>
                  <a:gd name="connsiteY2" fmla="*/ 103789 h 1037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103782">
                    <a:moveTo>
                      <a:pt x="6" y="6"/>
                    </a:moveTo>
                    <a:lnTo>
                      <a:pt x="6" y="6"/>
                    </a:lnTo>
                    <a:lnTo>
                      <a:pt x="6" y="103789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Freeform: Shape 122">
                <a:extLst>
                  <a:ext uri="{FF2B5EF4-FFF2-40B4-BE49-F238E27FC236}">
                    <a16:creationId xmlns:a16="http://schemas.microsoft.com/office/drawing/2014/main" id="{000545F0-8364-EE04-3153-025F0567579D}"/>
                  </a:ext>
                </a:extLst>
              </p:cNvPr>
              <p:cNvSpPr/>
              <p:nvPr/>
            </p:nvSpPr>
            <p:spPr>
              <a:xfrm>
                <a:off x="5528753" y="5000894"/>
                <a:ext cx="6" cy="67576"/>
              </a:xfrm>
              <a:custGeom>
                <a:avLst/>
                <a:gdLst>
                  <a:gd name="connsiteX0" fmla="*/ 12 w 6"/>
                  <a:gd name="connsiteY0" fmla="*/ 6 h 67576"/>
                  <a:gd name="connsiteX1" fmla="*/ 6 w 6"/>
                  <a:gd name="connsiteY1" fmla="*/ 6 h 67576"/>
                  <a:gd name="connsiteX2" fmla="*/ 6 w 6"/>
                  <a:gd name="connsiteY2" fmla="*/ 67583 h 675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67576">
                    <a:moveTo>
                      <a:pt x="12" y="6"/>
                    </a:moveTo>
                    <a:lnTo>
                      <a:pt x="6" y="6"/>
                    </a:lnTo>
                    <a:lnTo>
                      <a:pt x="6" y="67583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Freeform: Shape 123">
                <a:extLst>
                  <a:ext uri="{FF2B5EF4-FFF2-40B4-BE49-F238E27FC236}">
                    <a16:creationId xmlns:a16="http://schemas.microsoft.com/office/drawing/2014/main" id="{D97E695C-D19B-DA42-ECDF-7EBD79A47733}"/>
                  </a:ext>
                </a:extLst>
              </p:cNvPr>
              <p:cNvSpPr/>
              <p:nvPr/>
            </p:nvSpPr>
            <p:spPr>
              <a:xfrm>
                <a:off x="5528667" y="4769188"/>
                <a:ext cx="5" cy="223255"/>
              </a:xfrm>
              <a:custGeom>
                <a:avLst/>
                <a:gdLst>
                  <a:gd name="connsiteX0" fmla="*/ 12 w 5"/>
                  <a:gd name="connsiteY0" fmla="*/ 6 h 223255"/>
                  <a:gd name="connsiteX1" fmla="*/ 6 w 5"/>
                  <a:gd name="connsiteY1" fmla="*/ 6 h 223255"/>
                  <a:gd name="connsiteX2" fmla="*/ 6 w 5"/>
                  <a:gd name="connsiteY2" fmla="*/ 223262 h 2232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" h="223255">
                    <a:moveTo>
                      <a:pt x="12" y="6"/>
                    </a:moveTo>
                    <a:lnTo>
                      <a:pt x="6" y="6"/>
                    </a:lnTo>
                    <a:lnTo>
                      <a:pt x="6" y="22326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Freeform: Shape 124">
                <a:extLst>
                  <a:ext uri="{FF2B5EF4-FFF2-40B4-BE49-F238E27FC236}">
                    <a16:creationId xmlns:a16="http://schemas.microsoft.com/office/drawing/2014/main" id="{5B035DE8-5082-F919-D1C8-0BE4EAB15DB3}"/>
                  </a:ext>
                </a:extLst>
              </p:cNvPr>
              <p:cNvSpPr/>
              <p:nvPr/>
            </p:nvSpPr>
            <p:spPr>
              <a:xfrm>
                <a:off x="9376330" y="2722511"/>
                <a:ext cx="5783" cy="106194"/>
              </a:xfrm>
              <a:custGeom>
                <a:avLst/>
                <a:gdLst>
                  <a:gd name="connsiteX0" fmla="*/ 6 w 5783"/>
                  <a:gd name="connsiteY0" fmla="*/ 6 h 106194"/>
                  <a:gd name="connsiteX1" fmla="*/ 6 w 5783"/>
                  <a:gd name="connsiteY1" fmla="*/ 6 h 106194"/>
                  <a:gd name="connsiteX2" fmla="*/ 6 w 5783"/>
                  <a:gd name="connsiteY2" fmla="*/ 106200 h 1061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106194">
                    <a:moveTo>
                      <a:pt x="6" y="6"/>
                    </a:moveTo>
                    <a:lnTo>
                      <a:pt x="6" y="6"/>
                    </a:lnTo>
                    <a:lnTo>
                      <a:pt x="6" y="106200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Freeform: Shape 125">
                <a:extLst>
                  <a:ext uri="{FF2B5EF4-FFF2-40B4-BE49-F238E27FC236}">
                    <a16:creationId xmlns:a16="http://schemas.microsoft.com/office/drawing/2014/main" id="{E14FEEBE-F56E-266B-51C9-C1180B8472DF}"/>
                  </a:ext>
                </a:extLst>
              </p:cNvPr>
              <p:cNvSpPr/>
              <p:nvPr/>
            </p:nvSpPr>
            <p:spPr>
              <a:xfrm>
                <a:off x="8827459" y="3378994"/>
                <a:ext cx="5783" cy="74817"/>
              </a:xfrm>
              <a:custGeom>
                <a:avLst/>
                <a:gdLst>
                  <a:gd name="connsiteX0" fmla="*/ 6 w 5783"/>
                  <a:gd name="connsiteY0" fmla="*/ 6 h 74817"/>
                  <a:gd name="connsiteX1" fmla="*/ 6 w 5783"/>
                  <a:gd name="connsiteY1" fmla="*/ 6 h 74817"/>
                  <a:gd name="connsiteX2" fmla="*/ 6 w 5783"/>
                  <a:gd name="connsiteY2" fmla="*/ 74824 h 748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4817">
                    <a:moveTo>
                      <a:pt x="6" y="6"/>
                    </a:moveTo>
                    <a:lnTo>
                      <a:pt x="6" y="6"/>
                    </a:lnTo>
                    <a:lnTo>
                      <a:pt x="6" y="748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Freeform: Shape 126">
                <a:extLst>
                  <a:ext uri="{FF2B5EF4-FFF2-40B4-BE49-F238E27FC236}">
                    <a16:creationId xmlns:a16="http://schemas.microsoft.com/office/drawing/2014/main" id="{61321F5B-5B2E-3AC8-4D90-1039014445E6}"/>
                  </a:ext>
                </a:extLst>
              </p:cNvPr>
              <p:cNvSpPr/>
              <p:nvPr/>
            </p:nvSpPr>
            <p:spPr>
              <a:xfrm>
                <a:off x="34702" y="792636"/>
                <a:ext cx="103304" cy="5783"/>
              </a:xfrm>
              <a:custGeom>
                <a:avLst/>
                <a:gdLst>
                  <a:gd name="connsiteX0" fmla="*/ 6 w 103304"/>
                  <a:gd name="connsiteY0" fmla="*/ 6 h 5783"/>
                  <a:gd name="connsiteX1" fmla="*/ 103311 w 103304"/>
                  <a:gd name="connsiteY1" fmla="*/ 6 h 57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3304" h="5783">
                    <a:moveTo>
                      <a:pt x="6" y="6"/>
                    </a:moveTo>
                    <a:lnTo>
                      <a:pt x="103311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Freeform: Shape 127">
                <a:extLst>
                  <a:ext uri="{FF2B5EF4-FFF2-40B4-BE49-F238E27FC236}">
                    <a16:creationId xmlns:a16="http://schemas.microsoft.com/office/drawing/2014/main" id="{AD50BDD2-2CCE-1F66-51B7-2840DF9FE6D6}"/>
                  </a:ext>
                </a:extLst>
              </p:cNvPr>
              <p:cNvSpPr/>
              <p:nvPr/>
            </p:nvSpPr>
            <p:spPr>
              <a:xfrm>
                <a:off x="8828384" y="1757093"/>
                <a:ext cx="57" cy="106228"/>
              </a:xfrm>
              <a:custGeom>
                <a:avLst/>
                <a:gdLst>
                  <a:gd name="connsiteX0" fmla="*/ 63 w 57"/>
                  <a:gd name="connsiteY0" fmla="*/ 6 h 106228"/>
                  <a:gd name="connsiteX1" fmla="*/ 6 w 57"/>
                  <a:gd name="connsiteY1" fmla="*/ 6 h 106228"/>
                  <a:gd name="connsiteX2" fmla="*/ 6 w 57"/>
                  <a:gd name="connsiteY2" fmla="*/ 106235 h 1062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106228">
                    <a:moveTo>
                      <a:pt x="63" y="6"/>
                    </a:moveTo>
                    <a:lnTo>
                      <a:pt x="6" y="6"/>
                    </a:lnTo>
                    <a:lnTo>
                      <a:pt x="6" y="106235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Freeform: Shape 128">
                <a:extLst>
                  <a:ext uri="{FF2B5EF4-FFF2-40B4-BE49-F238E27FC236}">
                    <a16:creationId xmlns:a16="http://schemas.microsoft.com/office/drawing/2014/main" id="{2C6C73A0-B46B-367A-9AFC-D077CBC9C951}"/>
                  </a:ext>
                </a:extLst>
              </p:cNvPr>
              <p:cNvSpPr/>
              <p:nvPr/>
            </p:nvSpPr>
            <p:spPr>
              <a:xfrm>
                <a:off x="5528696" y="5584971"/>
                <a:ext cx="5783" cy="510479"/>
              </a:xfrm>
              <a:custGeom>
                <a:avLst/>
                <a:gdLst>
                  <a:gd name="connsiteX0" fmla="*/ 6 w 5783"/>
                  <a:gd name="connsiteY0" fmla="*/ 510485 h 510479"/>
                  <a:gd name="connsiteX1" fmla="*/ 6 w 5783"/>
                  <a:gd name="connsiteY1" fmla="*/ 510485 h 510479"/>
                  <a:gd name="connsiteX2" fmla="*/ 6 w 5783"/>
                  <a:gd name="connsiteY2" fmla="*/ 6 h 51047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510479">
                    <a:moveTo>
                      <a:pt x="6" y="510485"/>
                    </a:moveTo>
                    <a:lnTo>
                      <a:pt x="6" y="510485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Freeform: Shape 129">
                <a:extLst>
                  <a:ext uri="{FF2B5EF4-FFF2-40B4-BE49-F238E27FC236}">
                    <a16:creationId xmlns:a16="http://schemas.microsoft.com/office/drawing/2014/main" id="{6002E698-A610-B530-18E5-4AA8A037C096}"/>
                  </a:ext>
                </a:extLst>
              </p:cNvPr>
              <p:cNvSpPr/>
              <p:nvPr/>
            </p:nvSpPr>
            <p:spPr>
              <a:xfrm>
                <a:off x="9376099" y="2221020"/>
                <a:ext cx="57" cy="77761"/>
              </a:xfrm>
              <a:custGeom>
                <a:avLst/>
                <a:gdLst>
                  <a:gd name="connsiteX0" fmla="*/ 64 w 57"/>
                  <a:gd name="connsiteY0" fmla="*/ 77767 h 77761"/>
                  <a:gd name="connsiteX1" fmla="*/ 6 w 57"/>
                  <a:gd name="connsiteY1" fmla="*/ 77767 h 77761"/>
                  <a:gd name="connsiteX2" fmla="*/ 6 w 57"/>
                  <a:gd name="connsiteY2" fmla="*/ 6 h 7776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7761">
                    <a:moveTo>
                      <a:pt x="64" y="77767"/>
                    </a:moveTo>
                    <a:lnTo>
                      <a:pt x="6" y="77767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Freeform: Shape 130">
                <a:extLst>
                  <a:ext uri="{FF2B5EF4-FFF2-40B4-BE49-F238E27FC236}">
                    <a16:creationId xmlns:a16="http://schemas.microsoft.com/office/drawing/2014/main" id="{101CD2A6-96DD-F0E2-42F2-8BB878E60E22}"/>
                  </a:ext>
                </a:extLst>
              </p:cNvPr>
              <p:cNvSpPr/>
              <p:nvPr/>
            </p:nvSpPr>
            <p:spPr>
              <a:xfrm>
                <a:off x="8827401" y="1216458"/>
                <a:ext cx="5783" cy="76026"/>
              </a:xfrm>
              <a:custGeom>
                <a:avLst/>
                <a:gdLst>
                  <a:gd name="connsiteX0" fmla="*/ 6 w 5783"/>
                  <a:gd name="connsiteY0" fmla="*/ 6 h 76026"/>
                  <a:gd name="connsiteX1" fmla="*/ 6 w 5783"/>
                  <a:gd name="connsiteY1" fmla="*/ 6 h 76026"/>
                  <a:gd name="connsiteX2" fmla="*/ 6 w 5783"/>
                  <a:gd name="connsiteY2" fmla="*/ 76032 h 760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6026">
                    <a:moveTo>
                      <a:pt x="6" y="6"/>
                    </a:moveTo>
                    <a:lnTo>
                      <a:pt x="6" y="6"/>
                    </a:lnTo>
                    <a:lnTo>
                      <a:pt x="6" y="76032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Freeform: Shape 131">
                <a:extLst>
                  <a:ext uri="{FF2B5EF4-FFF2-40B4-BE49-F238E27FC236}">
                    <a16:creationId xmlns:a16="http://schemas.microsoft.com/office/drawing/2014/main" id="{2D0C4838-C48A-F1BC-7899-49A1306AAB51}"/>
                  </a:ext>
                </a:extLst>
              </p:cNvPr>
              <p:cNvSpPr/>
              <p:nvPr/>
            </p:nvSpPr>
            <p:spPr>
              <a:xfrm>
                <a:off x="9376272" y="2529423"/>
                <a:ext cx="5783" cy="94129"/>
              </a:xfrm>
              <a:custGeom>
                <a:avLst/>
                <a:gdLst>
                  <a:gd name="connsiteX0" fmla="*/ 6 w 5783"/>
                  <a:gd name="connsiteY0" fmla="*/ 6 h 94129"/>
                  <a:gd name="connsiteX1" fmla="*/ 6 w 5783"/>
                  <a:gd name="connsiteY1" fmla="*/ 6 h 94129"/>
                  <a:gd name="connsiteX2" fmla="*/ 6 w 5783"/>
                  <a:gd name="connsiteY2" fmla="*/ 94135 h 941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94129">
                    <a:moveTo>
                      <a:pt x="6" y="6"/>
                    </a:moveTo>
                    <a:lnTo>
                      <a:pt x="6" y="6"/>
                    </a:lnTo>
                    <a:lnTo>
                      <a:pt x="6" y="94135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Freeform: Shape 132">
                <a:extLst>
                  <a:ext uri="{FF2B5EF4-FFF2-40B4-BE49-F238E27FC236}">
                    <a16:creationId xmlns:a16="http://schemas.microsoft.com/office/drawing/2014/main" id="{E522EFF8-87D6-BFD2-921D-7560F0EDE74F}"/>
                  </a:ext>
                </a:extLst>
              </p:cNvPr>
              <p:cNvSpPr/>
              <p:nvPr/>
            </p:nvSpPr>
            <p:spPr>
              <a:xfrm>
                <a:off x="9373323" y="4127188"/>
                <a:ext cx="57" cy="91717"/>
              </a:xfrm>
              <a:custGeom>
                <a:avLst/>
                <a:gdLst>
                  <a:gd name="connsiteX0" fmla="*/ 64 w 57"/>
                  <a:gd name="connsiteY0" fmla="*/ 91724 h 91717"/>
                  <a:gd name="connsiteX1" fmla="*/ 6 w 57"/>
                  <a:gd name="connsiteY1" fmla="*/ 91724 h 91717"/>
                  <a:gd name="connsiteX2" fmla="*/ 6 w 57"/>
                  <a:gd name="connsiteY2" fmla="*/ 6 h 917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91717">
                    <a:moveTo>
                      <a:pt x="64" y="91724"/>
                    </a:moveTo>
                    <a:lnTo>
                      <a:pt x="6" y="917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Freeform: Shape 133">
                <a:extLst>
                  <a:ext uri="{FF2B5EF4-FFF2-40B4-BE49-F238E27FC236}">
                    <a16:creationId xmlns:a16="http://schemas.microsoft.com/office/drawing/2014/main" id="{83C96844-F740-3FF0-6029-7CB1B9340E19}"/>
                  </a:ext>
                </a:extLst>
              </p:cNvPr>
              <p:cNvSpPr/>
              <p:nvPr/>
            </p:nvSpPr>
            <p:spPr>
              <a:xfrm>
                <a:off x="4980073" y="830293"/>
                <a:ext cx="5783" cy="747205"/>
              </a:xfrm>
              <a:custGeom>
                <a:avLst/>
                <a:gdLst>
                  <a:gd name="connsiteX0" fmla="*/ 6 w 5783"/>
                  <a:gd name="connsiteY0" fmla="*/ 6 h 747205"/>
                  <a:gd name="connsiteX1" fmla="*/ 6 w 5783"/>
                  <a:gd name="connsiteY1" fmla="*/ 6 h 747205"/>
                  <a:gd name="connsiteX2" fmla="*/ 6 w 5783"/>
                  <a:gd name="connsiteY2" fmla="*/ 747211 h 74720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47205">
                    <a:moveTo>
                      <a:pt x="6" y="6"/>
                    </a:moveTo>
                    <a:lnTo>
                      <a:pt x="6" y="6"/>
                    </a:lnTo>
                    <a:lnTo>
                      <a:pt x="6" y="747211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Freeform: Shape 134">
                <a:extLst>
                  <a:ext uri="{FF2B5EF4-FFF2-40B4-BE49-F238E27FC236}">
                    <a16:creationId xmlns:a16="http://schemas.microsoft.com/office/drawing/2014/main" id="{F6139B57-BBDB-5E53-E7C9-A523FA4A7236}"/>
                  </a:ext>
                </a:extLst>
              </p:cNvPr>
              <p:cNvSpPr/>
              <p:nvPr/>
            </p:nvSpPr>
            <p:spPr>
              <a:xfrm>
                <a:off x="5528725" y="5838389"/>
                <a:ext cx="5783" cy="142429"/>
              </a:xfrm>
              <a:custGeom>
                <a:avLst/>
                <a:gdLst>
                  <a:gd name="connsiteX0" fmla="*/ 6 w 5783"/>
                  <a:gd name="connsiteY0" fmla="*/ 142435 h 142429"/>
                  <a:gd name="connsiteX1" fmla="*/ 6 w 5783"/>
                  <a:gd name="connsiteY1" fmla="*/ 142435 h 142429"/>
                  <a:gd name="connsiteX2" fmla="*/ 6 w 5783"/>
                  <a:gd name="connsiteY2" fmla="*/ 6 h 1424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142429">
                    <a:moveTo>
                      <a:pt x="6" y="142435"/>
                    </a:moveTo>
                    <a:lnTo>
                      <a:pt x="6" y="142435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Freeform: Shape 135">
                <a:extLst>
                  <a:ext uri="{FF2B5EF4-FFF2-40B4-BE49-F238E27FC236}">
                    <a16:creationId xmlns:a16="http://schemas.microsoft.com/office/drawing/2014/main" id="{54CE05CD-9911-3076-3682-AD81E7DFB593}"/>
                  </a:ext>
                </a:extLst>
              </p:cNvPr>
              <p:cNvSpPr/>
              <p:nvPr/>
            </p:nvSpPr>
            <p:spPr>
              <a:xfrm>
                <a:off x="9376041" y="2066023"/>
                <a:ext cx="57" cy="77501"/>
              </a:xfrm>
              <a:custGeom>
                <a:avLst/>
                <a:gdLst>
                  <a:gd name="connsiteX0" fmla="*/ 64 w 57"/>
                  <a:gd name="connsiteY0" fmla="*/ 6 h 77501"/>
                  <a:gd name="connsiteX1" fmla="*/ 6 w 57"/>
                  <a:gd name="connsiteY1" fmla="*/ 6 h 77501"/>
                  <a:gd name="connsiteX2" fmla="*/ 6 w 57"/>
                  <a:gd name="connsiteY2" fmla="*/ 77507 h 7750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7501">
                    <a:moveTo>
                      <a:pt x="64" y="6"/>
                    </a:moveTo>
                    <a:lnTo>
                      <a:pt x="6" y="6"/>
                    </a:lnTo>
                    <a:lnTo>
                      <a:pt x="6" y="77507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Freeform: Shape 136">
                <a:extLst>
                  <a:ext uri="{FF2B5EF4-FFF2-40B4-BE49-F238E27FC236}">
                    <a16:creationId xmlns:a16="http://schemas.microsoft.com/office/drawing/2014/main" id="{B8C67D81-2E8F-A2EA-917A-77F398BC07B3}"/>
                  </a:ext>
                </a:extLst>
              </p:cNvPr>
              <p:cNvSpPr/>
              <p:nvPr/>
            </p:nvSpPr>
            <p:spPr>
              <a:xfrm>
                <a:off x="9376330" y="2838358"/>
                <a:ext cx="5783" cy="96541"/>
              </a:xfrm>
              <a:custGeom>
                <a:avLst/>
                <a:gdLst>
                  <a:gd name="connsiteX0" fmla="*/ 6 w 5783"/>
                  <a:gd name="connsiteY0" fmla="*/ 6 h 96541"/>
                  <a:gd name="connsiteX1" fmla="*/ 6 w 5783"/>
                  <a:gd name="connsiteY1" fmla="*/ 6 h 96541"/>
                  <a:gd name="connsiteX2" fmla="*/ 6 w 5783"/>
                  <a:gd name="connsiteY2" fmla="*/ 96547 h 9654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96541">
                    <a:moveTo>
                      <a:pt x="6" y="6"/>
                    </a:moveTo>
                    <a:lnTo>
                      <a:pt x="6" y="6"/>
                    </a:lnTo>
                    <a:lnTo>
                      <a:pt x="6" y="96547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Freeform: Shape 137">
                <a:extLst>
                  <a:ext uri="{FF2B5EF4-FFF2-40B4-BE49-F238E27FC236}">
                    <a16:creationId xmlns:a16="http://schemas.microsoft.com/office/drawing/2014/main" id="{3F70B11B-A450-334A-0542-1A3D93E1CCDF}"/>
                  </a:ext>
                </a:extLst>
              </p:cNvPr>
              <p:cNvSpPr/>
              <p:nvPr/>
            </p:nvSpPr>
            <p:spPr>
              <a:xfrm>
                <a:off x="5528563" y="2850788"/>
                <a:ext cx="5" cy="1609471"/>
              </a:xfrm>
              <a:custGeom>
                <a:avLst/>
                <a:gdLst>
                  <a:gd name="connsiteX0" fmla="*/ 12 w 5"/>
                  <a:gd name="connsiteY0" fmla="*/ 1609477 h 1609471"/>
                  <a:gd name="connsiteX1" fmla="*/ 6 w 5"/>
                  <a:gd name="connsiteY1" fmla="*/ 1609477 h 1609471"/>
                  <a:gd name="connsiteX2" fmla="*/ 6 w 5"/>
                  <a:gd name="connsiteY2" fmla="*/ 6 h 160947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" h="1609471">
                    <a:moveTo>
                      <a:pt x="12" y="1609477"/>
                    </a:moveTo>
                    <a:lnTo>
                      <a:pt x="6" y="1609477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Freeform: Shape 138">
                <a:extLst>
                  <a:ext uri="{FF2B5EF4-FFF2-40B4-BE49-F238E27FC236}">
                    <a16:creationId xmlns:a16="http://schemas.microsoft.com/office/drawing/2014/main" id="{DA1813B7-A399-55C1-0DFB-C1BA9BC6F8E1}"/>
                  </a:ext>
                </a:extLst>
              </p:cNvPr>
              <p:cNvSpPr/>
              <p:nvPr/>
            </p:nvSpPr>
            <p:spPr>
              <a:xfrm>
                <a:off x="5528725" y="5980818"/>
                <a:ext cx="34" cy="139965"/>
              </a:xfrm>
              <a:custGeom>
                <a:avLst/>
                <a:gdLst>
                  <a:gd name="connsiteX0" fmla="*/ 41 w 34"/>
                  <a:gd name="connsiteY0" fmla="*/ 139971 h 139965"/>
                  <a:gd name="connsiteX1" fmla="*/ 6 w 34"/>
                  <a:gd name="connsiteY1" fmla="*/ 139971 h 139965"/>
                  <a:gd name="connsiteX2" fmla="*/ 6 w 34"/>
                  <a:gd name="connsiteY2" fmla="*/ 6 h 1399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34" h="139965">
                    <a:moveTo>
                      <a:pt x="41" y="139971"/>
                    </a:moveTo>
                    <a:lnTo>
                      <a:pt x="6" y="13997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Freeform: Shape 139">
                <a:extLst>
                  <a:ext uri="{FF2B5EF4-FFF2-40B4-BE49-F238E27FC236}">
                    <a16:creationId xmlns:a16="http://schemas.microsoft.com/office/drawing/2014/main" id="{07DCD3F3-4072-FAD9-7B36-49D0AAD2C5F2}"/>
                  </a:ext>
                </a:extLst>
              </p:cNvPr>
              <p:cNvSpPr/>
              <p:nvPr/>
            </p:nvSpPr>
            <p:spPr>
              <a:xfrm>
                <a:off x="5528563" y="3741879"/>
                <a:ext cx="22" cy="891097"/>
              </a:xfrm>
              <a:custGeom>
                <a:avLst/>
                <a:gdLst>
                  <a:gd name="connsiteX0" fmla="*/ 29 w 22"/>
                  <a:gd name="connsiteY0" fmla="*/ 891104 h 891097"/>
                  <a:gd name="connsiteX1" fmla="*/ 6 w 22"/>
                  <a:gd name="connsiteY1" fmla="*/ 891104 h 891097"/>
                  <a:gd name="connsiteX2" fmla="*/ 6 w 22"/>
                  <a:gd name="connsiteY2" fmla="*/ 6 h 8910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2" h="891097">
                    <a:moveTo>
                      <a:pt x="29" y="891104"/>
                    </a:moveTo>
                    <a:lnTo>
                      <a:pt x="6" y="89110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Freeform: Shape 140">
                <a:extLst>
                  <a:ext uri="{FF2B5EF4-FFF2-40B4-BE49-F238E27FC236}">
                    <a16:creationId xmlns:a16="http://schemas.microsoft.com/office/drawing/2014/main" id="{281A5B26-9107-F555-E813-2A753F3EC0B3}"/>
                  </a:ext>
                </a:extLst>
              </p:cNvPr>
              <p:cNvSpPr/>
              <p:nvPr/>
            </p:nvSpPr>
            <p:spPr>
              <a:xfrm>
                <a:off x="9376214" y="2537873"/>
                <a:ext cx="57" cy="85679"/>
              </a:xfrm>
              <a:custGeom>
                <a:avLst/>
                <a:gdLst>
                  <a:gd name="connsiteX0" fmla="*/ 64 w 57"/>
                  <a:gd name="connsiteY0" fmla="*/ 85685 h 85679"/>
                  <a:gd name="connsiteX1" fmla="*/ 6 w 57"/>
                  <a:gd name="connsiteY1" fmla="*/ 85685 h 85679"/>
                  <a:gd name="connsiteX2" fmla="*/ 6 w 57"/>
                  <a:gd name="connsiteY2" fmla="*/ 6 h 8567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85679">
                    <a:moveTo>
                      <a:pt x="64" y="85685"/>
                    </a:moveTo>
                    <a:lnTo>
                      <a:pt x="6" y="85685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Freeform: Shape 141">
                <a:extLst>
                  <a:ext uri="{FF2B5EF4-FFF2-40B4-BE49-F238E27FC236}">
                    <a16:creationId xmlns:a16="http://schemas.microsoft.com/office/drawing/2014/main" id="{D7C04733-3AC0-F5A4-4982-628580E87469}"/>
                  </a:ext>
                </a:extLst>
              </p:cNvPr>
              <p:cNvSpPr/>
              <p:nvPr/>
            </p:nvSpPr>
            <p:spPr>
              <a:xfrm>
                <a:off x="5528667" y="4992444"/>
                <a:ext cx="22" cy="223249"/>
              </a:xfrm>
              <a:custGeom>
                <a:avLst/>
                <a:gdLst>
                  <a:gd name="connsiteX0" fmla="*/ 29 w 22"/>
                  <a:gd name="connsiteY0" fmla="*/ 223256 h 223249"/>
                  <a:gd name="connsiteX1" fmla="*/ 6 w 22"/>
                  <a:gd name="connsiteY1" fmla="*/ 223256 h 223249"/>
                  <a:gd name="connsiteX2" fmla="*/ 6 w 22"/>
                  <a:gd name="connsiteY2" fmla="*/ 6 h 22324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2" h="223249">
                    <a:moveTo>
                      <a:pt x="29" y="223256"/>
                    </a:moveTo>
                    <a:lnTo>
                      <a:pt x="6" y="223256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Freeform: Shape 142">
                <a:extLst>
                  <a:ext uri="{FF2B5EF4-FFF2-40B4-BE49-F238E27FC236}">
                    <a16:creationId xmlns:a16="http://schemas.microsoft.com/office/drawing/2014/main" id="{7E8FA258-8206-E515-8350-490373FA3C3B}"/>
                  </a:ext>
                </a:extLst>
              </p:cNvPr>
              <p:cNvSpPr/>
              <p:nvPr/>
            </p:nvSpPr>
            <p:spPr>
              <a:xfrm>
                <a:off x="8280669" y="1215856"/>
                <a:ext cx="546673" cy="717887"/>
              </a:xfrm>
              <a:custGeom>
                <a:avLst/>
                <a:gdLst>
                  <a:gd name="connsiteX0" fmla="*/ 546680 w 546673"/>
                  <a:gd name="connsiteY0" fmla="*/ 6 h 717887"/>
                  <a:gd name="connsiteX1" fmla="*/ 6 w 546673"/>
                  <a:gd name="connsiteY1" fmla="*/ 6 h 717887"/>
                  <a:gd name="connsiteX2" fmla="*/ 6 w 546673"/>
                  <a:gd name="connsiteY2" fmla="*/ 717894 h 7178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6673" h="717887">
                    <a:moveTo>
                      <a:pt x="546680" y="6"/>
                    </a:moveTo>
                    <a:lnTo>
                      <a:pt x="6" y="6"/>
                    </a:lnTo>
                    <a:lnTo>
                      <a:pt x="6" y="71789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Freeform: Shape 143">
                <a:extLst>
                  <a:ext uri="{FF2B5EF4-FFF2-40B4-BE49-F238E27FC236}">
                    <a16:creationId xmlns:a16="http://schemas.microsoft.com/office/drawing/2014/main" id="{11AFCF81-E3EC-DE91-BE36-241B354FF465}"/>
                  </a:ext>
                </a:extLst>
              </p:cNvPr>
              <p:cNvSpPr/>
              <p:nvPr/>
            </p:nvSpPr>
            <p:spPr>
              <a:xfrm>
                <a:off x="8827517" y="1525393"/>
                <a:ext cx="5783" cy="57923"/>
              </a:xfrm>
              <a:custGeom>
                <a:avLst/>
                <a:gdLst>
                  <a:gd name="connsiteX0" fmla="*/ 6 w 5783"/>
                  <a:gd name="connsiteY0" fmla="*/ 6 h 57923"/>
                  <a:gd name="connsiteX1" fmla="*/ 6 w 5783"/>
                  <a:gd name="connsiteY1" fmla="*/ 6 h 57923"/>
                  <a:gd name="connsiteX2" fmla="*/ 6 w 5783"/>
                  <a:gd name="connsiteY2" fmla="*/ 57930 h 57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57923">
                    <a:moveTo>
                      <a:pt x="6" y="6"/>
                    </a:moveTo>
                    <a:lnTo>
                      <a:pt x="6" y="6"/>
                    </a:lnTo>
                    <a:lnTo>
                      <a:pt x="6" y="57930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Freeform: Shape 144">
                <a:extLst>
                  <a:ext uri="{FF2B5EF4-FFF2-40B4-BE49-F238E27FC236}">
                    <a16:creationId xmlns:a16="http://schemas.microsoft.com/office/drawing/2014/main" id="{0F279201-76E7-90DF-FD85-68F3C4E90AF4}"/>
                  </a:ext>
                </a:extLst>
              </p:cNvPr>
              <p:cNvSpPr/>
              <p:nvPr/>
            </p:nvSpPr>
            <p:spPr>
              <a:xfrm>
                <a:off x="4980032" y="1165278"/>
                <a:ext cx="40" cy="412220"/>
              </a:xfrm>
              <a:custGeom>
                <a:avLst/>
                <a:gdLst>
                  <a:gd name="connsiteX0" fmla="*/ 47 w 40"/>
                  <a:gd name="connsiteY0" fmla="*/ 412226 h 412220"/>
                  <a:gd name="connsiteX1" fmla="*/ 6 w 40"/>
                  <a:gd name="connsiteY1" fmla="*/ 412226 h 412220"/>
                  <a:gd name="connsiteX2" fmla="*/ 6 w 40"/>
                  <a:gd name="connsiteY2" fmla="*/ 6 h 4122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40" h="412220">
                    <a:moveTo>
                      <a:pt x="47" y="412226"/>
                    </a:moveTo>
                    <a:lnTo>
                      <a:pt x="6" y="412226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Freeform: Shape 145">
                <a:extLst>
                  <a:ext uri="{FF2B5EF4-FFF2-40B4-BE49-F238E27FC236}">
                    <a16:creationId xmlns:a16="http://schemas.microsoft.com/office/drawing/2014/main" id="{13761BA5-A94E-7603-3A61-FC5BE2021237}"/>
                  </a:ext>
                </a:extLst>
              </p:cNvPr>
              <p:cNvSpPr/>
              <p:nvPr/>
            </p:nvSpPr>
            <p:spPr>
              <a:xfrm>
                <a:off x="6077897" y="1241316"/>
                <a:ext cx="1106649" cy="256552"/>
              </a:xfrm>
              <a:custGeom>
                <a:avLst/>
                <a:gdLst>
                  <a:gd name="connsiteX0" fmla="*/ 1106655 w 1106649"/>
                  <a:gd name="connsiteY0" fmla="*/ 256559 h 256552"/>
                  <a:gd name="connsiteX1" fmla="*/ 6 w 1106649"/>
                  <a:gd name="connsiteY1" fmla="*/ 256559 h 256552"/>
                  <a:gd name="connsiteX2" fmla="*/ 6 w 1106649"/>
                  <a:gd name="connsiteY2" fmla="*/ 6 h 2565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06649" h="256552">
                    <a:moveTo>
                      <a:pt x="1106655" y="256559"/>
                    </a:moveTo>
                    <a:lnTo>
                      <a:pt x="6" y="256559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Freeform: Shape 146">
                <a:extLst>
                  <a:ext uri="{FF2B5EF4-FFF2-40B4-BE49-F238E27FC236}">
                    <a16:creationId xmlns:a16="http://schemas.microsoft.com/office/drawing/2014/main" id="{DB075E0C-2662-2753-1F5C-00FB1195FD9F}"/>
                  </a:ext>
                </a:extLst>
              </p:cNvPr>
              <p:cNvSpPr/>
              <p:nvPr/>
            </p:nvSpPr>
            <p:spPr>
              <a:xfrm>
                <a:off x="9373438" y="4286482"/>
                <a:ext cx="5783" cy="57923"/>
              </a:xfrm>
              <a:custGeom>
                <a:avLst/>
                <a:gdLst>
                  <a:gd name="connsiteX0" fmla="*/ 6 w 5783"/>
                  <a:gd name="connsiteY0" fmla="*/ 57930 h 57923"/>
                  <a:gd name="connsiteX1" fmla="*/ 6 w 5783"/>
                  <a:gd name="connsiteY1" fmla="*/ 57930 h 57923"/>
                  <a:gd name="connsiteX2" fmla="*/ 6 w 5783"/>
                  <a:gd name="connsiteY2" fmla="*/ 6 h 57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57923">
                    <a:moveTo>
                      <a:pt x="6" y="57930"/>
                    </a:moveTo>
                    <a:lnTo>
                      <a:pt x="6" y="57930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Freeform: Shape 147">
                <a:extLst>
                  <a:ext uri="{FF2B5EF4-FFF2-40B4-BE49-F238E27FC236}">
                    <a16:creationId xmlns:a16="http://schemas.microsoft.com/office/drawing/2014/main" id="{F08581CA-B090-6D09-D399-73DFBCB004B6}"/>
                  </a:ext>
                </a:extLst>
              </p:cNvPr>
              <p:cNvSpPr/>
              <p:nvPr/>
            </p:nvSpPr>
            <p:spPr>
              <a:xfrm>
                <a:off x="9373380" y="4035476"/>
                <a:ext cx="5783" cy="38617"/>
              </a:xfrm>
              <a:custGeom>
                <a:avLst/>
                <a:gdLst>
                  <a:gd name="connsiteX0" fmla="*/ 6 w 5783"/>
                  <a:gd name="connsiteY0" fmla="*/ 38624 h 38617"/>
                  <a:gd name="connsiteX1" fmla="*/ 6 w 5783"/>
                  <a:gd name="connsiteY1" fmla="*/ 38624 h 38617"/>
                  <a:gd name="connsiteX2" fmla="*/ 6 w 5783"/>
                  <a:gd name="connsiteY2" fmla="*/ 6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7">
                    <a:moveTo>
                      <a:pt x="6" y="38624"/>
                    </a:moveTo>
                    <a:lnTo>
                      <a:pt x="6" y="386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Freeform: Shape 148">
                <a:extLst>
                  <a:ext uri="{FF2B5EF4-FFF2-40B4-BE49-F238E27FC236}">
                    <a16:creationId xmlns:a16="http://schemas.microsoft.com/office/drawing/2014/main" id="{6A4DF9A7-58C1-2FF6-BE90-9C56AD7F9764}"/>
                  </a:ext>
                </a:extLst>
              </p:cNvPr>
              <p:cNvSpPr/>
              <p:nvPr/>
            </p:nvSpPr>
            <p:spPr>
              <a:xfrm>
                <a:off x="9376330" y="2683894"/>
                <a:ext cx="57" cy="38617"/>
              </a:xfrm>
              <a:custGeom>
                <a:avLst/>
                <a:gdLst>
                  <a:gd name="connsiteX0" fmla="*/ 64 w 57"/>
                  <a:gd name="connsiteY0" fmla="*/ 6 h 38617"/>
                  <a:gd name="connsiteX1" fmla="*/ 6 w 57"/>
                  <a:gd name="connsiteY1" fmla="*/ 6 h 38617"/>
                  <a:gd name="connsiteX2" fmla="*/ 6 w 57"/>
                  <a:gd name="connsiteY2" fmla="*/ 38624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38617">
                    <a:moveTo>
                      <a:pt x="64" y="6"/>
                    </a:moveTo>
                    <a:lnTo>
                      <a:pt x="6" y="6"/>
                    </a:lnTo>
                    <a:lnTo>
                      <a:pt x="6" y="3862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Freeform: Shape 149">
                <a:extLst>
                  <a:ext uri="{FF2B5EF4-FFF2-40B4-BE49-F238E27FC236}">
                    <a16:creationId xmlns:a16="http://schemas.microsoft.com/office/drawing/2014/main" id="{46694A47-D981-E8AD-D5A0-DF9114D6CE05}"/>
                  </a:ext>
                </a:extLst>
              </p:cNvPr>
              <p:cNvSpPr/>
              <p:nvPr/>
            </p:nvSpPr>
            <p:spPr>
              <a:xfrm>
                <a:off x="9376330" y="2934900"/>
                <a:ext cx="57" cy="96541"/>
              </a:xfrm>
              <a:custGeom>
                <a:avLst/>
                <a:gdLst>
                  <a:gd name="connsiteX0" fmla="*/ 64 w 57"/>
                  <a:gd name="connsiteY0" fmla="*/ 96547 h 96541"/>
                  <a:gd name="connsiteX1" fmla="*/ 6 w 57"/>
                  <a:gd name="connsiteY1" fmla="*/ 96547 h 96541"/>
                  <a:gd name="connsiteX2" fmla="*/ 6 w 57"/>
                  <a:gd name="connsiteY2" fmla="*/ 6 h 9654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96541">
                    <a:moveTo>
                      <a:pt x="64" y="96547"/>
                    </a:moveTo>
                    <a:lnTo>
                      <a:pt x="6" y="96547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Freeform: Shape 150">
                <a:extLst>
                  <a:ext uri="{FF2B5EF4-FFF2-40B4-BE49-F238E27FC236}">
                    <a16:creationId xmlns:a16="http://schemas.microsoft.com/office/drawing/2014/main" id="{4A03CD1D-D287-87FB-3F54-707AD735D0BA}"/>
                  </a:ext>
                </a:extLst>
              </p:cNvPr>
              <p:cNvSpPr/>
              <p:nvPr/>
            </p:nvSpPr>
            <p:spPr>
              <a:xfrm>
                <a:off x="8827401" y="3224523"/>
                <a:ext cx="5783" cy="215413"/>
              </a:xfrm>
              <a:custGeom>
                <a:avLst/>
                <a:gdLst>
                  <a:gd name="connsiteX0" fmla="*/ 6 w 5783"/>
                  <a:gd name="connsiteY0" fmla="*/ 6 h 215413"/>
                  <a:gd name="connsiteX1" fmla="*/ 6 w 5783"/>
                  <a:gd name="connsiteY1" fmla="*/ 6 h 215413"/>
                  <a:gd name="connsiteX2" fmla="*/ 6 w 5783"/>
                  <a:gd name="connsiteY2" fmla="*/ 215419 h 2154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215413">
                    <a:moveTo>
                      <a:pt x="6" y="6"/>
                    </a:moveTo>
                    <a:lnTo>
                      <a:pt x="6" y="6"/>
                    </a:lnTo>
                    <a:lnTo>
                      <a:pt x="6" y="215419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Freeform: Shape 151">
                <a:extLst>
                  <a:ext uri="{FF2B5EF4-FFF2-40B4-BE49-F238E27FC236}">
                    <a16:creationId xmlns:a16="http://schemas.microsoft.com/office/drawing/2014/main" id="{9711A71A-B132-E304-32CB-964281377E86}"/>
                  </a:ext>
                </a:extLst>
              </p:cNvPr>
              <p:cNvSpPr/>
              <p:nvPr/>
            </p:nvSpPr>
            <p:spPr>
              <a:xfrm>
                <a:off x="5528719" y="5074503"/>
                <a:ext cx="6" cy="150850"/>
              </a:xfrm>
              <a:custGeom>
                <a:avLst/>
                <a:gdLst>
                  <a:gd name="connsiteX0" fmla="*/ 12 w 6"/>
                  <a:gd name="connsiteY0" fmla="*/ 150856 h 150850"/>
                  <a:gd name="connsiteX1" fmla="*/ 6 w 6"/>
                  <a:gd name="connsiteY1" fmla="*/ 150856 h 150850"/>
                  <a:gd name="connsiteX2" fmla="*/ 6 w 6"/>
                  <a:gd name="connsiteY2" fmla="*/ 6 h 150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150850">
                    <a:moveTo>
                      <a:pt x="12" y="150856"/>
                    </a:moveTo>
                    <a:lnTo>
                      <a:pt x="6" y="150856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Freeform: Shape 152">
                <a:extLst>
                  <a:ext uri="{FF2B5EF4-FFF2-40B4-BE49-F238E27FC236}">
                    <a16:creationId xmlns:a16="http://schemas.microsoft.com/office/drawing/2014/main" id="{9AAD538E-BE28-07E7-7E4C-3BD0651BB29B}"/>
                  </a:ext>
                </a:extLst>
              </p:cNvPr>
              <p:cNvSpPr/>
              <p:nvPr/>
            </p:nvSpPr>
            <p:spPr>
              <a:xfrm>
                <a:off x="5528800" y="5850459"/>
                <a:ext cx="5783" cy="57946"/>
              </a:xfrm>
              <a:custGeom>
                <a:avLst/>
                <a:gdLst>
                  <a:gd name="connsiteX0" fmla="*/ 6 w 5783"/>
                  <a:gd name="connsiteY0" fmla="*/ 6 h 57946"/>
                  <a:gd name="connsiteX1" fmla="*/ 6 w 5783"/>
                  <a:gd name="connsiteY1" fmla="*/ 6 h 57946"/>
                  <a:gd name="connsiteX2" fmla="*/ 6 w 5783"/>
                  <a:gd name="connsiteY2" fmla="*/ 57953 h 579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57946">
                    <a:moveTo>
                      <a:pt x="6" y="6"/>
                    </a:moveTo>
                    <a:lnTo>
                      <a:pt x="6" y="6"/>
                    </a:lnTo>
                    <a:lnTo>
                      <a:pt x="6" y="57953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Freeform: Shape 153">
                <a:extLst>
                  <a:ext uri="{FF2B5EF4-FFF2-40B4-BE49-F238E27FC236}">
                    <a16:creationId xmlns:a16="http://schemas.microsoft.com/office/drawing/2014/main" id="{770F4C15-3481-72A7-9AD2-A08A76DFC3B9}"/>
                  </a:ext>
                </a:extLst>
              </p:cNvPr>
              <p:cNvSpPr/>
              <p:nvPr/>
            </p:nvSpPr>
            <p:spPr>
              <a:xfrm>
                <a:off x="8827459" y="3301759"/>
                <a:ext cx="57" cy="76026"/>
              </a:xfrm>
              <a:custGeom>
                <a:avLst/>
                <a:gdLst>
                  <a:gd name="connsiteX0" fmla="*/ 64 w 57"/>
                  <a:gd name="connsiteY0" fmla="*/ 6 h 76026"/>
                  <a:gd name="connsiteX1" fmla="*/ 6 w 57"/>
                  <a:gd name="connsiteY1" fmla="*/ 6 h 76026"/>
                  <a:gd name="connsiteX2" fmla="*/ 6 w 57"/>
                  <a:gd name="connsiteY2" fmla="*/ 76033 h 760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" h="76026">
                    <a:moveTo>
                      <a:pt x="64" y="6"/>
                    </a:moveTo>
                    <a:lnTo>
                      <a:pt x="6" y="6"/>
                    </a:lnTo>
                    <a:lnTo>
                      <a:pt x="6" y="76033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Freeform: Shape 154">
                <a:extLst>
                  <a:ext uri="{FF2B5EF4-FFF2-40B4-BE49-F238E27FC236}">
                    <a16:creationId xmlns:a16="http://schemas.microsoft.com/office/drawing/2014/main" id="{E5BFD365-13A9-8E11-DE90-E3AAFDFA579C}"/>
                  </a:ext>
                </a:extLst>
              </p:cNvPr>
              <p:cNvSpPr/>
              <p:nvPr/>
            </p:nvSpPr>
            <p:spPr>
              <a:xfrm>
                <a:off x="9376157" y="2220494"/>
                <a:ext cx="5783" cy="78287"/>
              </a:xfrm>
              <a:custGeom>
                <a:avLst/>
                <a:gdLst>
                  <a:gd name="connsiteX0" fmla="*/ 6 w 5783"/>
                  <a:gd name="connsiteY0" fmla="*/ 6 h 78287"/>
                  <a:gd name="connsiteX1" fmla="*/ 6 w 5783"/>
                  <a:gd name="connsiteY1" fmla="*/ 6 h 78287"/>
                  <a:gd name="connsiteX2" fmla="*/ 6 w 5783"/>
                  <a:gd name="connsiteY2" fmla="*/ 78294 h 782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8287">
                    <a:moveTo>
                      <a:pt x="6" y="6"/>
                    </a:moveTo>
                    <a:lnTo>
                      <a:pt x="6" y="6"/>
                    </a:lnTo>
                    <a:lnTo>
                      <a:pt x="6" y="7829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Freeform: Shape 155">
                <a:extLst>
                  <a:ext uri="{FF2B5EF4-FFF2-40B4-BE49-F238E27FC236}">
                    <a16:creationId xmlns:a16="http://schemas.microsoft.com/office/drawing/2014/main" id="{07CD3AE1-D6AB-8202-5AC6-2C6D6AC7EDD9}"/>
                  </a:ext>
                </a:extLst>
              </p:cNvPr>
              <p:cNvSpPr/>
              <p:nvPr/>
            </p:nvSpPr>
            <p:spPr>
              <a:xfrm>
                <a:off x="5528800" y="5908406"/>
                <a:ext cx="28" cy="57894"/>
              </a:xfrm>
              <a:custGeom>
                <a:avLst/>
                <a:gdLst>
                  <a:gd name="connsiteX0" fmla="*/ 35 w 28"/>
                  <a:gd name="connsiteY0" fmla="*/ 57901 h 57894"/>
                  <a:gd name="connsiteX1" fmla="*/ 6 w 28"/>
                  <a:gd name="connsiteY1" fmla="*/ 57901 h 57894"/>
                  <a:gd name="connsiteX2" fmla="*/ 6 w 28"/>
                  <a:gd name="connsiteY2" fmla="*/ 6 h 578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57894">
                    <a:moveTo>
                      <a:pt x="35" y="57901"/>
                    </a:moveTo>
                    <a:lnTo>
                      <a:pt x="6" y="57901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" name="Freeform: Shape 156">
                <a:extLst>
                  <a:ext uri="{FF2B5EF4-FFF2-40B4-BE49-F238E27FC236}">
                    <a16:creationId xmlns:a16="http://schemas.microsoft.com/office/drawing/2014/main" id="{2F1B0A89-B5BB-06F0-AC77-F1291C45A9C4}"/>
                  </a:ext>
                </a:extLst>
              </p:cNvPr>
              <p:cNvSpPr/>
              <p:nvPr/>
            </p:nvSpPr>
            <p:spPr>
              <a:xfrm>
                <a:off x="8827459" y="1368511"/>
                <a:ext cx="5783" cy="74823"/>
              </a:xfrm>
              <a:custGeom>
                <a:avLst/>
                <a:gdLst>
                  <a:gd name="connsiteX0" fmla="*/ 6 w 5783"/>
                  <a:gd name="connsiteY0" fmla="*/ 74829 h 74823"/>
                  <a:gd name="connsiteX1" fmla="*/ 6 w 5783"/>
                  <a:gd name="connsiteY1" fmla="*/ 74829 h 74823"/>
                  <a:gd name="connsiteX2" fmla="*/ 6 w 5783"/>
                  <a:gd name="connsiteY2" fmla="*/ 6 h 748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4823">
                    <a:moveTo>
                      <a:pt x="6" y="74829"/>
                    </a:moveTo>
                    <a:lnTo>
                      <a:pt x="6" y="74829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Freeform: Shape 157">
                <a:extLst>
                  <a:ext uri="{FF2B5EF4-FFF2-40B4-BE49-F238E27FC236}">
                    <a16:creationId xmlns:a16="http://schemas.microsoft.com/office/drawing/2014/main" id="{50514FD4-75DF-4AA8-5090-9222DFB47A7F}"/>
                  </a:ext>
                </a:extLst>
              </p:cNvPr>
              <p:cNvSpPr/>
              <p:nvPr/>
            </p:nvSpPr>
            <p:spPr>
              <a:xfrm>
                <a:off x="5528748" y="6275265"/>
                <a:ext cx="5" cy="38577"/>
              </a:xfrm>
              <a:custGeom>
                <a:avLst/>
                <a:gdLst>
                  <a:gd name="connsiteX0" fmla="*/ 12 w 5"/>
                  <a:gd name="connsiteY0" fmla="*/ 38583 h 38577"/>
                  <a:gd name="connsiteX1" fmla="*/ 6 w 5"/>
                  <a:gd name="connsiteY1" fmla="*/ 38583 h 38577"/>
                  <a:gd name="connsiteX2" fmla="*/ 6 w 5"/>
                  <a:gd name="connsiteY2" fmla="*/ 6 h 385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" h="38577">
                    <a:moveTo>
                      <a:pt x="12" y="38583"/>
                    </a:moveTo>
                    <a:lnTo>
                      <a:pt x="6" y="38583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Freeform: Shape 158">
                <a:extLst>
                  <a:ext uri="{FF2B5EF4-FFF2-40B4-BE49-F238E27FC236}">
                    <a16:creationId xmlns:a16="http://schemas.microsoft.com/office/drawing/2014/main" id="{54200363-587B-962E-FF6E-BDA36388FF42}"/>
                  </a:ext>
                </a:extLst>
              </p:cNvPr>
              <p:cNvSpPr/>
              <p:nvPr/>
            </p:nvSpPr>
            <p:spPr>
              <a:xfrm>
                <a:off x="9376041" y="1988793"/>
                <a:ext cx="5783" cy="77362"/>
              </a:xfrm>
              <a:custGeom>
                <a:avLst/>
                <a:gdLst>
                  <a:gd name="connsiteX0" fmla="*/ 6 w 5783"/>
                  <a:gd name="connsiteY0" fmla="*/ 6 h 77362"/>
                  <a:gd name="connsiteX1" fmla="*/ 6 w 5783"/>
                  <a:gd name="connsiteY1" fmla="*/ 6 h 77362"/>
                  <a:gd name="connsiteX2" fmla="*/ 6 w 5783"/>
                  <a:gd name="connsiteY2" fmla="*/ 77369 h 773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7362">
                    <a:moveTo>
                      <a:pt x="6" y="6"/>
                    </a:moveTo>
                    <a:lnTo>
                      <a:pt x="6" y="6"/>
                    </a:lnTo>
                    <a:lnTo>
                      <a:pt x="6" y="77369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" name="Freeform: Shape 159">
                <a:extLst>
                  <a:ext uri="{FF2B5EF4-FFF2-40B4-BE49-F238E27FC236}">
                    <a16:creationId xmlns:a16="http://schemas.microsoft.com/office/drawing/2014/main" id="{53378BD9-1D9C-4E75-2497-8416789E853F}"/>
                  </a:ext>
                </a:extLst>
              </p:cNvPr>
              <p:cNvSpPr/>
              <p:nvPr/>
            </p:nvSpPr>
            <p:spPr>
              <a:xfrm>
                <a:off x="5528817" y="5522218"/>
                <a:ext cx="28" cy="57923"/>
              </a:xfrm>
              <a:custGeom>
                <a:avLst/>
                <a:gdLst>
                  <a:gd name="connsiteX0" fmla="*/ 35 w 28"/>
                  <a:gd name="connsiteY0" fmla="*/ 57929 h 57923"/>
                  <a:gd name="connsiteX1" fmla="*/ 6 w 28"/>
                  <a:gd name="connsiteY1" fmla="*/ 57929 h 57923"/>
                  <a:gd name="connsiteX2" fmla="*/ 6 w 28"/>
                  <a:gd name="connsiteY2" fmla="*/ 6 h 57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8" h="57923">
                    <a:moveTo>
                      <a:pt x="35" y="57929"/>
                    </a:moveTo>
                    <a:lnTo>
                      <a:pt x="6" y="57929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" name="Freeform: Shape 160">
                <a:extLst>
                  <a:ext uri="{FF2B5EF4-FFF2-40B4-BE49-F238E27FC236}">
                    <a16:creationId xmlns:a16="http://schemas.microsoft.com/office/drawing/2014/main" id="{083E153F-38C0-0770-7DD1-BFEDB023D192}"/>
                  </a:ext>
                </a:extLst>
              </p:cNvPr>
              <p:cNvSpPr/>
              <p:nvPr/>
            </p:nvSpPr>
            <p:spPr>
              <a:xfrm>
                <a:off x="5528696" y="5074503"/>
                <a:ext cx="22" cy="510467"/>
              </a:xfrm>
              <a:custGeom>
                <a:avLst/>
                <a:gdLst>
                  <a:gd name="connsiteX0" fmla="*/ 29 w 22"/>
                  <a:gd name="connsiteY0" fmla="*/ 6 h 510467"/>
                  <a:gd name="connsiteX1" fmla="*/ 6 w 22"/>
                  <a:gd name="connsiteY1" fmla="*/ 6 h 510467"/>
                  <a:gd name="connsiteX2" fmla="*/ 6 w 22"/>
                  <a:gd name="connsiteY2" fmla="*/ 510474 h 51046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2" h="510467">
                    <a:moveTo>
                      <a:pt x="29" y="6"/>
                    </a:moveTo>
                    <a:lnTo>
                      <a:pt x="6" y="6"/>
                    </a:lnTo>
                    <a:lnTo>
                      <a:pt x="6" y="510474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Freeform: Shape 161">
                <a:extLst>
                  <a:ext uri="{FF2B5EF4-FFF2-40B4-BE49-F238E27FC236}">
                    <a16:creationId xmlns:a16="http://schemas.microsoft.com/office/drawing/2014/main" id="{0D3BE8A8-AE37-27BD-C0D9-3EA17A092725}"/>
                  </a:ext>
                </a:extLst>
              </p:cNvPr>
              <p:cNvSpPr/>
              <p:nvPr/>
            </p:nvSpPr>
            <p:spPr>
              <a:xfrm>
                <a:off x="8827459" y="3842394"/>
                <a:ext cx="5783" cy="90503"/>
              </a:xfrm>
              <a:custGeom>
                <a:avLst/>
                <a:gdLst>
                  <a:gd name="connsiteX0" fmla="*/ 6 w 5783"/>
                  <a:gd name="connsiteY0" fmla="*/ 6 h 90503"/>
                  <a:gd name="connsiteX1" fmla="*/ 6 w 5783"/>
                  <a:gd name="connsiteY1" fmla="*/ 6 h 90503"/>
                  <a:gd name="connsiteX2" fmla="*/ 6 w 5783"/>
                  <a:gd name="connsiteY2" fmla="*/ 90509 h 905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90503">
                    <a:moveTo>
                      <a:pt x="6" y="6"/>
                    </a:moveTo>
                    <a:lnTo>
                      <a:pt x="6" y="6"/>
                    </a:lnTo>
                    <a:lnTo>
                      <a:pt x="6" y="90509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Freeform: Shape 162">
                <a:extLst>
                  <a:ext uri="{FF2B5EF4-FFF2-40B4-BE49-F238E27FC236}">
                    <a16:creationId xmlns:a16="http://schemas.microsoft.com/office/drawing/2014/main" id="{5E321685-2262-9867-08BF-541C7182AA21}"/>
                  </a:ext>
                </a:extLst>
              </p:cNvPr>
              <p:cNvSpPr/>
              <p:nvPr/>
            </p:nvSpPr>
            <p:spPr>
              <a:xfrm>
                <a:off x="8280727" y="2651626"/>
                <a:ext cx="546673" cy="788309"/>
              </a:xfrm>
              <a:custGeom>
                <a:avLst/>
                <a:gdLst>
                  <a:gd name="connsiteX0" fmla="*/ 546680 w 546673"/>
                  <a:gd name="connsiteY0" fmla="*/ 788316 h 788309"/>
                  <a:gd name="connsiteX1" fmla="*/ 6 w 546673"/>
                  <a:gd name="connsiteY1" fmla="*/ 788316 h 788309"/>
                  <a:gd name="connsiteX2" fmla="*/ 6 w 546673"/>
                  <a:gd name="connsiteY2" fmla="*/ 6 h 78830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6673" h="788309">
                    <a:moveTo>
                      <a:pt x="546680" y="788316"/>
                    </a:moveTo>
                    <a:lnTo>
                      <a:pt x="6" y="788316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Freeform: Shape 163">
                <a:extLst>
                  <a:ext uri="{FF2B5EF4-FFF2-40B4-BE49-F238E27FC236}">
                    <a16:creationId xmlns:a16="http://schemas.microsoft.com/office/drawing/2014/main" id="{DBAB44EF-E5C8-F275-DFAA-1CEBC68885E2}"/>
                  </a:ext>
                </a:extLst>
              </p:cNvPr>
              <p:cNvSpPr/>
              <p:nvPr/>
            </p:nvSpPr>
            <p:spPr>
              <a:xfrm>
                <a:off x="5528563" y="1241316"/>
                <a:ext cx="549333" cy="1609471"/>
              </a:xfrm>
              <a:custGeom>
                <a:avLst/>
                <a:gdLst>
                  <a:gd name="connsiteX0" fmla="*/ 549340 w 549333"/>
                  <a:gd name="connsiteY0" fmla="*/ 6 h 1609471"/>
                  <a:gd name="connsiteX1" fmla="*/ 6 w 549333"/>
                  <a:gd name="connsiteY1" fmla="*/ 6 h 1609471"/>
                  <a:gd name="connsiteX2" fmla="*/ 6 w 549333"/>
                  <a:gd name="connsiteY2" fmla="*/ 1609477 h 160947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9333" h="1609471">
                    <a:moveTo>
                      <a:pt x="549340" y="6"/>
                    </a:moveTo>
                    <a:lnTo>
                      <a:pt x="6" y="6"/>
                    </a:lnTo>
                    <a:lnTo>
                      <a:pt x="6" y="1609477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Freeform: Shape 164">
                <a:extLst>
                  <a:ext uri="{FF2B5EF4-FFF2-40B4-BE49-F238E27FC236}">
                    <a16:creationId xmlns:a16="http://schemas.microsoft.com/office/drawing/2014/main" id="{2F9C826F-66A3-78D4-B636-A5338E0F82F3}"/>
                  </a:ext>
                </a:extLst>
              </p:cNvPr>
              <p:cNvSpPr/>
              <p:nvPr/>
            </p:nvSpPr>
            <p:spPr>
              <a:xfrm>
                <a:off x="5528759" y="5840806"/>
                <a:ext cx="40" cy="67599"/>
              </a:xfrm>
              <a:custGeom>
                <a:avLst/>
                <a:gdLst>
                  <a:gd name="connsiteX0" fmla="*/ 47 w 40"/>
                  <a:gd name="connsiteY0" fmla="*/ 67606 h 67599"/>
                  <a:gd name="connsiteX1" fmla="*/ 6 w 40"/>
                  <a:gd name="connsiteY1" fmla="*/ 67606 h 67599"/>
                  <a:gd name="connsiteX2" fmla="*/ 6 w 40"/>
                  <a:gd name="connsiteY2" fmla="*/ 6 h 675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40" h="67599">
                    <a:moveTo>
                      <a:pt x="47" y="67606"/>
                    </a:moveTo>
                    <a:lnTo>
                      <a:pt x="6" y="67606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Freeform: Shape 165">
                <a:extLst>
                  <a:ext uri="{FF2B5EF4-FFF2-40B4-BE49-F238E27FC236}">
                    <a16:creationId xmlns:a16="http://schemas.microsoft.com/office/drawing/2014/main" id="{EA6D5E83-9AED-6AAB-C6BA-B4349827FF2C}"/>
                  </a:ext>
                </a:extLst>
              </p:cNvPr>
              <p:cNvSpPr/>
              <p:nvPr/>
            </p:nvSpPr>
            <p:spPr>
              <a:xfrm>
                <a:off x="4980102" y="907528"/>
                <a:ext cx="6" cy="1417175"/>
              </a:xfrm>
              <a:custGeom>
                <a:avLst/>
                <a:gdLst>
                  <a:gd name="connsiteX0" fmla="*/ 12 w 6"/>
                  <a:gd name="connsiteY0" fmla="*/ 6 h 1417175"/>
                  <a:gd name="connsiteX1" fmla="*/ 6 w 6"/>
                  <a:gd name="connsiteY1" fmla="*/ 6 h 1417175"/>
                  <a:gd name="connsiteX2" fmla="*/ 6 w 6"/>
                  <a:gd name="connsiteY2" fmla="*/ 1417181 h 14171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6" h="1417175">
                    <a:moveTo>
                      <a:pt x="12" y="6"/>
                    </a:moveTo>
                    <a:lnTo>
                      <a:pt x="6" y="6"/>
                    </a:lnTo>
                    <a:lnTo>
                      <a:pt x="6" y="1417181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Freeform: Shape 166">
                <a:extLst>
                  <a:ext uri="{FF2B5EF4-FFF2-40B4-BE49-F238E27FC236}">
                    <a16:creationId xmlns:a16="http://schemas.microsoft.com/office/drawing/2014/main" id="{8B7088E3-0403-4E3B-EB48-49B79163163E}"/>
                  </a:ext>
                </a:extLst>
              </p:cNvPr>
              <p:cNvSpPr/>
              <p:nvPr/>
            </p:nvSpPr>
            <p:spPr>
              <a:xfrm>
                <a:off x="8827459" y="3932897"/>
                <a:ext cx="545863" cy="90508"/>
              </a:xfrm>
              <a:custGeom>
                <a:avLst/>
                <a:gdLst>
                  <a:gd name="connsiteX0" fmla="*/ 545870 w 545863"/>
                  <a:gd name="connsiteY0" fmla="*/ 90515 h 90508"/>
                  <a:gd name="connsiteX1" fmla="*/ 6 w 545863"/>
                  <a:gd name="connsiteY1" fmla="*/ 90515 h 90508"/>
                  <a:gd name="connsiteX2" fmla="*/ 6 w 545863"/>
                  <a:gd name="connsiteY2" fmla="*/ 6 h 905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45863" h="90508">
                    <a:moveTo>
                      <a:pt x="545870" y="90515"/>
                    </a:moveTo>
                    <a:lnTo>
                      <a:pt x="6" y="90515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Freeform: Shape 167">
                <a:extLst>
                  <a:ext uri="{FF2B5EF4-FFF2-40B4-BE49-F238E27FC236}">
                    <a16:creationId xmlns:a16="http://schemas.microsoft.com/office/drawing/2014/main" id="{C8BDFFFD-5308-6455-DA57-690D682F6BBE}"/>
                  </a:ext>
                </a:extLst>
              </p:cNvPr>
              <p:cNvSpPr/>
              <p:nvPr/>
            </p:nvSpPr>
            <p:spPr>
              <a:xfrm>
                <a:off x="8827575" y="1602629"/>
                <a:ext cx="5783" cy="38611"/>
              </a:xfrm>
              <a:custGeom>
                <a:avLst/>
                <a:gdLst>
                  <a:gd name="connsiteX0" fmla="*/ 6 w 5783"/>
                  <a:gd name="connsiteY0" fmla="*/ 6 h 38611"/>
                  <a:gd name="connsiteX1" fmla="*/ 6 w 5783"/>
                  <a:gd name="connsiteY1" fmla="*/ 6 h 38611"/>
                  <a:gd name="connsiteX2" fmla="*/ 6 w 5783"/>
                  <a:gd name="connsiteY2" fmla="*/ 38618 h 386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1">
                    <a:moveTo>
                      <a:pt x="6" y="6"/>
                    </a:moveTo>
                    <a:lnTo>
                      <a:pt x="6" y="6"/>
                    </a:lnTo>
                    <a:lnTo>
                      <a:pt x="6" y="38618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Freeform: Shape 168">
                <a:extLst>
                  <a:ext uri="{FF2B5EF4-FFF2-40B4-BE49-F238E27FC236}">
                    <a16:creationId xmlns:a16="http://schemas.microsoft.com/office/drawing/2014/main" id="{63DCDD3C-7334-3423-5050-AE15E0D466F8}"/>
                  </a:ext>
                </a:extLst>
              </p:cNvPr>
              <p:cNvSpPr/>
              <p:nvPr/>
            </p:nvSpPr>
            <p:spPr>
              <a:xfrm>
                <a:off x="9373438" y="4344406"/>
                <a:ext cx="5783" cy="38617"/>
              </a:xfrm>
              <a:custGeom>
                <a:avLst/>
                <a:gdLst>
                  <a:gd name="connsiteX0" fmla="*/ 6 w 5783"/>
                  <a:gd name="connsiteY0" fmla="*/ 38624 h 38617"/>
                  <a:gd name="connsiteX1" fmla="*/ 6 w 5783"/>
                  <a:gd name="connsiteY1" fmla="*/ 38624 h 38617"/>
                  <a:gd name="connsiteX2" fmla="*/ 6 w 5783"/>
                  <a:gd name="connsiteY2" fmla="*/ 6 h 386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38617">
                    <a:moveTo>
                      <a:pt x="6" y="38624"/>
                    </a:moveTo>
                    <a:lnTo>
                      <a:pt x="6" y="38624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Freeform: Shape 169">
                <a:extLst>
                  <a:ext uri="{FF2B5EF4-FFF2-40B4-BE49-F238E27FC236}">
                    <a16:creationId xmlns:a16="http://schemas.microsoft.com/office/drawing/2014/main" id="{4AFECCD6-AF41-7DA3-9625-4DF5F443107B}"/>
                  </a:ext>
                </a:extLst>
              </p:cNvPr>
              <p:cNvSpPr/>
              <p:nvPr/>
            </p:nvSpPr>
            <p:spPr>
              <a:xfrm>
                <a:off x="5528782" y="5136047"/>
                <a:ext cx="555707" cy="57929"/>
              </a:xfrm>
              <a:custGeom>
                <a:avLst/>
                <a:gdLst>
                  <a:gd name="connsiteX0" fmla="*/ 555714 w 555707"/>
                  <a:gd name="connsiteY0" fmla="*/ 57935 h 57929"/>
                  <a:gd name="connsiteX1" fmla="*/ 6 w 555707"/>
                  <a:gd name="connsiteY1" fmla="*/ 57935 h 57929"/>
                  <a:gd name="connsiteX2" fmla="*/ 6 w 555707"/>
                  <a:gd name="connsiteY2" fmla="*/ 6 h 579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55707" h="57929">
                    <a:moveTo>
                      <a:pt x="555714" y="57935"/>
                    </a:moveTo>
                    <a:lnTo>
                      <a:pt x="6" y="57935"/>
                    </a:lnTo>
                    <a:lnTo>
                      <a:pt x="6" y="6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Freeform: Shape 170">
                <a:extLst>
                  <a:ext uri="{FF2B5EF4-FFF2-40B4-BE49-F238E27FC236}">
                    <a16:creationId xmlns:a16="http://schemas.microsoft.com/office/drawing/2014/main" id="{E19A5588-D858-5ECC-6C1A-FFEB2717DB04}"/>
                  </a:ext>
                </a:extLst>
              </p:cNvPr>
              <p:cNvSpPr/>
              <p:nvPr/>
            </p:nvSpPr>
            <p:spPr>
              <a:xfrm>
                <a:off x="5528748" y="6236630"/>
                <a:ext cx="552156" cy="38635"/>
              </a:xfrm>
              <a:custGeom>
                <a:avLst/>
                <a:gdLst>
                  <a:gd name="connsiteX0" fmla="*/ 552163 w 552156"/>
                  <a:gd name="connsiteY0" fmla="*/ 6 h 38635"/>
                  <a:gd name="connsiteX1" fmla="*/ 6 w 552156"/>
                  <a:gd name="connsiteY1" fmla="*/ 6 h 38635"/>
                  <a:gd name="connsiteX2" fmla="*/ 6 w 552156"/>
                  <a:gd name="connsiteY2" fmla="*/ 38641 h 38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52156" h="38635">
                    <a:moveTo>
                      <a:pt x="552163" y="6"/>
                    </a:moveTo>
                    <a:lnTo>
                      <a:pt x="6" y="6"/>
                    </a:lnTo>
                    <a:lnTo>
                      <a:pt x="6" y="38641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Freeform: Shape 171">
                <a:extLst>
                  <a:ext uri="{FF2B5EF4-FFF2-40B4-BE49-F238E27FC236}">
                    <a16:creationId xmlns:a16="http://schemas.microsoft.com/office/drawing/2014/main" id="{7641E968-E39A-247D-C28A-5FB2C3DBE305}"/>
                  </a:ext>
                </a:extLst>
              </p:cNvPr>
              <p:cNvSpPr/>
              <p:nvPr/>
            </p:nvSpPr>
            <p:spPr>
              <a:xfrm>
                <a:off x="9376388" y="2954211"/>
                <a:ext cx="5783" cy="77229"/>
              </a:xfrm>
              <a:custGeom>
                <a:avLst/>
                <a:gdLst>
                  <a:gd name="connsiteX0" fmla="*/ 6 w 5783"/>
                  <a:gd name="connsiteY0" fmla="*/ 6 h 77229"/>
                  <a:gd name="connsiteX1" fmla="*/ 6 w 5783"/>
                  <a:gd name="connsiteY1" fmla="*/ 6 h 77229"/>
                  <a:gd name="connsiteX2" fmla="*/ 6 w 5783"/>
                  <a:gd name="connsiteY2" fmla="*/ 77235 h 772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5783" h="77229">
                    <a:moveTo>
                      <a:pt x="6" y="6"/>
                    </a:moveTo>
                    <a:lnTo>
                      <a:pt x="6" y="6"/>
                    </a:lnTo>
                    <a:lnTo>
                      <a:pt x="6" y="77235"/>
                    </a:lnTo>
                  </a:path>
                </a:pathLst>
              </a:custGeom>
              <a:noFill/>
              <a:ln w="34702" cap="rnd">
                <a:solidFill>
                  <a:srgbClr val="00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F0F14794-5A9E-D89B-25DB-020F88A6E836}"/>
                  </a:ext>
                </a:extLst>
              </p:cNvPr>
              <p:cNvSpPr txBox="1"/>
              <p:nvPr/>
            </p:nvSpPr>
            <p:spPr>
              <a:xfrm>
                <a:off x="7145853" y="884093"/>
                <a:ext cx="1061509" cy="2063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8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Agency FB"/>
                    <a:rtl val="0"/>
                  </a:rPr>
                  <a:t>Vietnam1_JQ780458</a:t>
                </a:r>
              </a:p>
            </p:txBody>
          </p:sp>
        </p:grp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84504038-BE66-5969-1ED6-A3E998F5E1F1}"/>
                </a:ext>
              </a:extLst>
            </p:cNvPr>
            <p:cNvSpPr txBox="1"/>
            <p:nvPr/>
          </p:nvSpPr>
          <p:spPr>
            <a:xfrm>
              <a:off x="5495017" y="4628807"/>
              <a:ext cx="9893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JF866024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347BE0DF-0A81-B56E-2F37-28E2F92AE82F}"/>
                </a:ext>
              </a:extLst>
            </p:cNvPr>
            <p:cNvSpPr txBox="1"/>
            <p:nvPr/>
          </p:nvSpPr>
          <p:spPr>
            <a:xfrm>
              <a:off x="5495185" y="5435109"/>
              <a:ext cx="1362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50-E07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452CC2BD-122F-C4E2-0619-59AEF7639836}"/>
                </a:ext>
              </a:extLst>
            </p:cNvPr>
            <p:cNvSpPr txBox="1"/>
            <p:nvPr/>
          </p:nvSpPr>
          <p:spPr>
            <a:xfrm>
              <a:off x="5495121" y="4951329"/>
              <a:ext cx="9893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JF866023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328704AE-FF71-96CF-19F3-B34B58C66D1E}"/>
                </a:ext>
              </a:extLst>
            </p:cNvPr>
            <p:cNvSpPr txBox="1"/>
            <p:nvPr/>
          </p:nvSpPr>
          <p:spPr>
            <a:xfrm>
              <a:off x="6976449" y="-47731"/>
              <a:ext cx="1072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onesia_LC170005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C6271C1C-F200-EA44-0361-2B72A61AEB68}"/>
                </a:ext>
              </a:extLst>
            </p:cNvPr>
            <p:cNvSpPr txBox="1"/>
            <p:nvPr/>
          </p:nvSpPr>
          <p:spPr>
            <a:xfrm>
              <a:off x="9342495" y="2048648"/>
              <a:ext cx="15119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_BC_ZSM_HYM_10628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C1E7323E-6396-8BF3-8FF2-D83A96FEBD54}"/>
                </a:ext>
              </a:extLst>
            </p:cNvPr>
            <p:cNvSpPr txBox="1"/>
            <p:nvPr/>
          </p:nvSpPr>
          <p:spPr>
            <a:xfrm>
              <a:off x="7129370" y="113529"/>
              <a:ext cx="11063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onesia1_JQ780460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51AECC55-8FDA-A1D3-69A6-189DA1752FBC}"/>
                </a:ext>
              </a:extLst>
            </p:cNvPr>
            <p:cNvSpPr txBox="1"/>
            <p:nvPr/>
          </p:nvSpPr>
          <p:spPr>
            <a:xfrm>
              <a:off x="10434859" y="274789"/>
              <a:ext cx="11063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onesia3_JQ780462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F0EFF0B0-8CE3-3913-6180-E1D3DF81E616}"/>
                </a:ext>
              </a:extLst>
            </p:cNvPr>
            <p:cNvSpPr txBox="1"/>
            <p:nvPr/>
          </p:nvSpPr>
          <p:spPr>
            <a:xfrm>
              <a:off x="9342553" y="2209906"/>
              <a:ext cx="15119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_BC_ZSM_HYM_10631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369D6664-2CD5-569C-95AE-94DE292FF9E6}"/>
                </a:ext>
              </a:extLst>
            </p:cNvPr>
            <p:cNvSpPr txBox="1"/>
            <p:nvPr/>
          </p:nvSpPr>
          <p:spPr>
            <a:xfrm>
              <a:off x="5495162" y="5838257"/>
              <a:ext cx="13580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50-F03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04323B9C-0782-905A-56A3-0C1928BE47EB}"/>
                </a:ext>
              </a:extLst>
            </p:cNvPr>
            <p:cNvSpPr txBox="1"/>
            <p:nvPr/>
          </p:nvSpPr>
          <p:spPr>
            <a:xfrm>
              <a:off x="6976449" y="32899"/>
              <a:ext cx="1072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onesia_LC170002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C12B7F12-87D6-99CC-7394-169950F8F4C3}"/>
                </a:ext>
              </a:extLst>
            </p:cNvPr>
            <p:cNvSpPr txBox="1"/>
            <p:nvPr/>
          </p:nvSpPr>
          <p:spPr>
            <a:xfrm>
              <a:off x="8794029" y="3661246"/>
              <a:ext cx="13853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Thailand_CBG-A00324-H02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DA1A9E21-E5AE-2FD8-127B-37CEC260CF3B}"/>
                </a:ext>
              </a:extLst>
            </p:cNvPr>
            <p:cNvSpPr txBox="1"/>
            <p:nvPr/>
          </p:nvSpPr>
          <p:spPr>
            <a:xfrm>
              <a:off x="6055745" y="5515735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0104-G02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B23E1192-E13D-5AB6-BA5B-04E0149CCDE5}"/>
                </a:ext>
              </a:extLst>
            </p:cNvPr>
            <p:cNvSpPr txBox="1"/>
            <p:nvPr/>
          </p:nvSpPr>
          <p:spPr>
            <a:xfrm>
              <a:off x="5495156" y="6241435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49-A07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EDE6EDA2-3AD3-7FA2-3F06-1641C3E1D5A1}"/>
                </a:ext>
              </a:extLst>
            </p:cNvPr>
            <p:cNvSpPr txBox="1"/>
            <p:nvPr/>
          </p:nvSpPr>
          <p:spPr>
            <a:xfrm>
              <a:off x="9342727" y="2693686"/>
              <a:ext cx="8386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UK_KY224070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82E500E9-9C19-97AB-733A-43B44384A15D}"/>
                </a:ext>
              </a:extLst>
            </p:cNvPr>
            <p:cNvSpPr txBox="1"/>
            <p:nvPr/>
          </p:nvSpPr>
          <p:spPr>
            <a:xfrm>
              <a:off x="8223989" y="194159"/>
              <a:ext cx="11063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onesia2_JQ780461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D117810E-8B8C-58E7-C5AB-80240595F874}"/>
                </a:ext>
              </a:extLst>
            </p:cNvPr>
            <p:cNvSpPr txBox="1"/>
            <p:nvPr/>
          </p:nvSpPr>
          <p:spPr>
            <a:xfrm>
              <a:off x="9340818" y="1564868"/>
              <a:ext cx="1072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 dirty="0">
                  <a:ln/>
                  <a:solidFill>
                    <a:srgbClr val="FF0066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Zhejiang1_JQ780449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D718AAE7-BBD2-5FAC-65B4-D986D5AA455C}"/>
                </a:ext>
              </a:extLst>
            </p:cNvPr>
            <p:cNvSpPr txBox="1"/>
            <p:nvPr/>
          </p:nvSpPr>
          <p:spPr>
            <a:xfrm>
              <a:off x="4946470" y="597308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99542-A01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2BD29198-5E44-1287-88EE-47C277DBDB4F}"/>
                </a:ext>
              </a:extLst>
            </p:cNvPr>
            <p:cNvSpPr txBox="1"/>
            <p:nvPr/>
          </p:nvSpPr>
          <p:spPr>
            <a:xfrm>
              <a:off x="5495121" y="5757625"/>
              <a:ext cx="9893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JF866022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A734E3D8-1DF4-D8B0-B605-0F6E7C1D3B9C}"/>
                </a:ext>
              </a:extLst>
            </p:cNvPr>
            <p:cNvSpPr txBox="1"/>
            <p:nvPr/>
          </p:nvSpPr>
          <p:spPr>
            <a:xfrm>
              <a:off x="6537063" y="355419"/>
              <a:ext cx="1050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Malaysia_LC170011</a:t>
              </a: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7C69A55D-1ABC-D052-EBFC-6F682F332942}"/>
                </a:ext>
              </a:extLst>
            </p:cNvPr>
            <p:cNvSpPr txBox="1"/>
            <p:nvPr/>
          </p:nvSpPr>
          <p:spPr>
            <a:xfrm>
              <a:off x="5495092" y="4870697"/>
              <a:ext cx="14253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NIBGE_HYM-0673</a:t>
              </a:r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6897B118-00AF-B65D-E755-9CAC1731507D}"/>
                </a:ext>
              </a:extLst>
            </p:cNvPr>
            <p:cNvSpPr txBox="1"/>
            <p:nvPr/>
          </p:nvSpPr>
          <p:spPr>
            <a:xfrm>
              <a:off x="6618844" y="5676999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49-G05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2D9F0E79-87FC-CF2F-6DC6-E5AC98CE3335}"/>
                </a:ext>
              </a:extLst>
            </p:cNvPr>
            <p:cNvSpPr txBox="1"/>
            <p:nvPr/>
          </p:nvSpPr>
          <p:spPr>
            <a:xfrm>
              <a:off x="7646142" y="516679"/>
              <a:ext cx="1050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Malaysia_LC170009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B1DDD170-C851-4F41-5EBD-C41CF6A09697}"/>
                </a:ext>
              </a:extLst>
            </p:cNvPr>
            <p:cNvSpPr txBox="1"/>
            <p:nvPr/>
          </p:nvSpPr>
          <p:spPr>
            <a:xfrm>
              <a:off x="9342611" y="2290538"/>
              <a:ext cx="9701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_MF363129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8FA142A4-AE14-E33E-0399-B3E68B0D3F1E}"/>
                </a:ext>
              </a:extLst>
            </p:cNvPr>
            <p:cNvSpPr txBox="1"/>
            <p:nvPr/>
          </p:nvSpPr>
          <p:spPr>
            <a:xfrm>
              <a:off x="9342842" y="2935576"/>
              <a:ext cx="1047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Belgium_MF363128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A3A7F8EB-8046-9001-EFDC-2D796526B94A}"/>
                </a:ext>
              </a:extLst>
            </p:cNvPr>
            <p:cNvSpPr txBox="1"/>
            <p:nvPr/>
          </p:nvSpPr>
          <p:spPr>
            <a:xfrm>
              <a:off x="7737640" y="5273845"/>
              <a:ext cx="13580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0104-F10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546288F3-4630-767B-50DC-EF2F8E6A4A5A}"/>
                </a:ext>
              </a:extLst>
            </p:cNvPr>
            <p:cNvSpPr txBox="1"/>
            <p:nvPr/>
          </p:nvSpPr>
          <p:spPr>
            <a:xfrm>
              <a:off x="9342785" y="2854950"/>
              <a:ext cx="8386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UK_KX712225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4009F127-B237-CB33-42B9-B67E13AA1FAE}"/>
                </a:ext>
              </a:extLst>
            </p:cNvPr>
            <p:cNvSpPr txBox="1"/>
            <p:nvPr/>
          </p:nvSpPr>
          <p:spPr>
            <a:xfrm>
              <a:off x="5495046" y="4709439"/>
              <a:ext cx="9893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JF866021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5A633E7B-EDD7-9EA4-13F8-626D7D24DC4D}"/>
                </a:ext>
              </a:extLst>
            </p:cNvPr>
            <p:cNvSpPr txBox="1"/>
            <p:nvPr/>
          </p:nvSpPr>
          <p:spPr>
            <a:xfrm>
              <a:off x="6057133" y="5999491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50-D02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AA446261-49BB-735C-9DC3-3E589BFFC34D}"/>
                </a:ext>
              </a:extLst>
            </p:cNvPr>
            <p:cNvSpPr txBox="1"/>
            <p:nvPr/>
          </p:nvSpPr>
          <p:spPr>
            <a:xfrm>
              <a:off x="8793855" y="1161719"/>
              <a:ext cx="9076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Japan_LC170008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32D77DA2-499A-1946-CE08-E2FD1C0F7095}"/>
                </a:ext>
              </a:extLst>
            </p:cNvPr>
            <p:cNvSpPr txBox="1"/>
            <p:nvPr/>
          </p:nvSpPr>
          <p:spPr>
            <a:xfrm>
              <a:off x="9342842" y="3016208"/>
              <a:ext cx="8386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UK_KY224071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5795DB58-2A66-0C98-F99E-23DB03E735BC}"/>
                </a:ext>
              </a:extLst>
            </p:cNvPr>
            <p:cNvSpPr txBox="1"/>
            <p:nvPr/>
          </p:nvSpPr>
          <p:spPr>
            <a:xfrm>
              <a:off x="8804497" y="919829"/>
              <a:ext cx="9813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Taiwan_LC170012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215FA58B-59AE-AA8E-7538-9BEA7356120C}"/>
                </a:ext>
              </a:extLst>
            </p:cNvPr>
            <p:cNvSpPr txBox="1"/>
            <p:nvPr/>
          </p:nvSpPr>
          <p:spPr>
            <a:xfrm>
              <a:off x="9339835" y="4306290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China_LC170000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AF937BDB-8D02-454F-4733-36B4878EB591}"/>
                </a:ext>
              </a:extLst>
            </p:cNvPr>
            <p:cNvSpPr txBox="1"/>
            <p:nvPr/>
          </p:nvSpPr>
          <p:spPr>
            <a:xfrm>
              <a:off x="9342611" y="2371170"/>
              <a:ext cx="15119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_BC_ZSM_HYM_10629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F44A5CFB-3E40-8E43-CBE5-12C14433538E}"/>
                </a:ext>
              </a:extLst>
            </p:cNvPr>
            <p:cNvSpPr txBox="1"/>
            <p:nvPr/>
          </p:nvSpPr>
          <p:spPr>
            <a:xfrm>
              <a:off x="5495243" y="5596367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0840-H06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DB4F1BC8-2E1D-8E96-99F7-A2852B609CCA}"/>
                </a:ext>
              </a:extLst>
            </p:cNvPr>
            <p:cNvSpPr txBox="1"/>
            <p:nvPr/>
          </p:nvSpPr>
          <p:spPr>
            <a:xfrm>
              <a:off x="9339719" y="3903136"/>
              <a:ext cx="1072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onesia_LC170003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48AF3BF1-0126-5D7D-D960-E8FA673A2ED9}"/>
                </a:ext>
              </a:extLst>
            </p:cNvPr>
            <p:cNvSpPr txBox="1"/>
            <p:nvPr/>
          </p:nvSpPr>
          <p:spPr>
            <a:xfrm>
              <a:off x="5495069" y="4790070"/>
              <a:ext cx="14253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NIBGE_HYM-0676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232E9CD3-1D26-3A49-7C9D-E3C463B5F325}"/>
                </a:ext>
              </a:extLst>
            </p:cNvPr>
            <p:cNvSpPr txBox="1"/>
            <p:nvPr/>
          </p:nvSpPr>
          <p:spPr>
            <a:xfrm>
              <a:off x="5495156" y="5031954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0840-H10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77BF48B0-05D6-A093-AF7F-B44FE56FE6D5}"/>
                </a:ext>
              </a:extLst>
            </p:cNvPr>
            <p:cNvSpPr txBox="1"/>
            <p:nvPr/>
          </p:nvSpPr>
          <p:spPr>
            <a:xfrm>
              <a:off x="8793971" y="3580620"/>
              <a:ext cx="13853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Thailand_CBG-A00325-A01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F219A5B9-F757-722C-58C1-CF91C4FDFA40}"/>
                </a:ext>
              </a:extLst>
            </p:cNvPr>
            <p:cNvSpPr txBox="1"/>
            <p:nvPr/>
          </p:nvSpPr>
          <p:spPr>
            <a:xfrm>
              <a:off x="8793855" y="3338730"/>
              <a:ext cx="10390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Thailand_LC170013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290F049C-9940-4C5D-1840-F418EC30DD80}"/>
                </a:ext>
              </a:extLst>
            </p:cNvPr>
            <p:cNvSpPr txBox="1"/>
            <p:nvPr/>
          </p:nvSpPr>
          <p:spPr>
            <a:xfrm>
              <a:off x="8794839" y="1645499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FF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China_LC169997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2561631E-3EFE-F0D8-ECD1-F1E75E99210C}"/>
                </a:ext>
              </a:extLst>
            </p:cNvPr>
            <p:cNvSpPr txBox="1"/>
            <p:nvPr/>
          </p:nvSpPr>
          <p:spPr>
            <a:xfrm>
              <a:off x="6544003" y="436049"/>
              <a:ext cx="1050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Malaysia_LC170010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4DFDDA1C-778A-7148-02FF-4824163E1600}"/>
                </a:ext>
              </a:extLst>
            </p:cNvPr>
            <p:cNvSpPr txBox="1"/>
            <p:nvPr/>
          </p:nvSpPr>
          <p:spPr>
            <a:xfrm>
              <a:off x="8793798" y="1081088"/>
              <a:ext cx="9076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Japan_LC145053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B7EFB6D4-A341-E813-DEB7-CFD39B592691}"/>
                </a:ext>
              </a:extLst>
            </p:cNvPr>
            <p:cNvSpPr txBox="1"/>
            <p:nvPr/>
          </p:nvSpPr>
          <p:spPr>
            <a:xfrm>
              <a:off x="9342669" y="2451796"/>
              <a:ext cx="8386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UK_KY224072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6C34AD19-10CC-16A6-CD92-5E50E102029B}"/>
                </a:ext>
              </a:extLst>
            </p:cNvPr>
            <p:cNvSpPr txBox="1"/>
            <p:nvPr/>
          </p:nvSpPr>
          <p:spPr>
            <a:xfrm>
              <a:off x="4946470" y="677939"/>
              <a:ext cx="14766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NIBGE_HYM-01002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F9CB2FFC-CCC3-1283-FCF2-2B118DB7CDD4}"/>
                </a:ext>
              </a:extLst>
            </p:cNvPr>
            <p:cNvSpPr txBox="1"/>
            <p:nvPr/>
          </p:nvSpPr>
          <p:spPr>
            <a:xfrm>
              <a:off x="9342495" y="1968016"/>
              <a:ext cx="8386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UK_KY224073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4898BD8A-7D4C-FE55-EFEF-D34A6A4E3CC9}"/>
                </a:ext>
              </a:extLst>
            </p:cNvPr>
            <p:cNvSpPr txBox="1"/>
            <p:nvPr/>
          </p:nvSpPr>
          <p:spPr>
            <a:xfrm>
              <a:off x="9342727" y="2774318"/>
              <a:ext cx="9525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_KF958704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8C037309-E5AD-DE3F-8B1C-EE435E04B9DF}"/>
                </a:ext>
              </a:extLst>
            </p:cNvPr>
            <p:cNvSpPr txBox="1"/>
            <p:nvPr/>
          </p:nvSpPr>
          <p:spPr>
            <a:xfrm>
              <a:off x="5494965" y="4467549"/>
              <a:ext cx="8851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ia_LC169998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06BDE358-6CF6-7FE0-DF05-A27778415B91}"/>
                </a:ext>
              </a:extLst>
            </p:cNvPr>
            <p:cNvSpPr txBox="1"/>
            <p:nvPr/>
          </p:nvSpPr>
          <p:spPr>
            <a:xfrm>
              <a:off x="7156495" y="5193219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49-A06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28D7F4EB-33C2-4587-234A-805162B91929}"/>
                </a:ext>
              </a:extLst>
            </p:cNvPr>
            <p:cNvSpPr txBox="1"/>
            <p:nvPr/>
          </p:nvSpPr>
          <p:spPr>
            <a:xfrm>
              <a:off x="6049325" y="6160767"/>
              <a:ext cx="13692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49-C07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3D29A425-5F4D-5487-F57C-2050CAF5DBE4}"/>
                </a:ext>
              </a:extLst>
            </p:cNvPr>
            <p:cNvSpPr txBox="1"/>
            <p:nvPr/>
          </p:nvSpPr>
          <p:spPr>
            <a:xfrm>
              <a:off x="9342669" y="2532428"/>
              <a:ext cx="13324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_UM_AAAA_00599</a:t>
              </a: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507CE2F8-8DA8-DCB4-9374-ABC352965867}"/>
                </a:ext>
              </a:extLst>
            </p:cNvPr>
            <p:cNvSpPr txBox="1"/>
            <p:nvPr/>
          </p:nvSpPr>
          <p:spPr>
            <a:xfrm>
              <a:off x="8793913" y="3419356"/>
              <a:ext cx="13692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Thailand_CBG-A00328-F09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C931D5F0-C83C-9D1C-6B70-49C43C641921}"/>
                </a:ext>
              </a:extLst>
            </p:cNvPr>
            <p:cNvSpPr txBox="1"/>
            <p:nvPr/>
          </p:nvSpPr>
          <p:spPr>
            <a:xfrm>
              <a:off x="8793913" y="1322978"/>
              <a:ext cx="9076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Japan_LC145055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3FBF8D4E-65DF-13FE-CB95-D80EA625358B}"/>
                </a:ext>
              </a:extLst>
            </p:cNvPr>
            <p:cNvSpPr txBox="1"/>
            <p:nvPr/>
          </p:nvSpPr>
          <p:spPr>
            <a:xfrm>
              <a:off x="10434859" y="3983769"/>
              <a:ext cx="10326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Yunnan2_JQ780456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1ECC230E-5DC4-6312-F2C2-E5C1CB5A5EE4}"/>
                </a:ext>
              </a:extLst>
            </p:cNvPr>
            <p:cNvSpPr txBox="1"/>
            <p:nvPr/>
          </p:nvSpPr>
          <p:spPr>
            <a:xfrm>
              <a:off x="9342553" y="1726132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FF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China_LC169996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977F98F6-0362-0FC0-FC95-38A2E64DE244}"/>
                </a:ext>
              </a:extLst>
            </p:cNvPr>
            <p:cNvSpPr txBox="1"/>
            <p:nvPr/>
          </p:nvSpPr>
          <p:spPr>
            <a:xfrm>
              <a:off x="8793913" y="1403609"/>
              <a:ext cx="8066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SK_LC145054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391856A4-83C0-CA34-3A04-B2F619CB8115}"/>
                </a:ext>
              </a:extLst>
            </p:cNvPr>
            <p:cNvSpPr txBox="1"/>
            <p:nvPr/>
          </p:nvSpPr>
          <p:spPr>
            <a:xfrm>
              <a:off x="8793740" y="1000461"/>
              <a:ext cx="17638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 dirty="0">
                  <a:ln/>
                  <a:solidFill>
                    <a:srgbClr val="FF0066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Zhejiang3_JQ780454_SK_JQ780452</a:t>
              </a: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62285939-A6A4-125B-9D33-34F5A82CABBE}"/>
                </a:ext>
              </a:extLst>
            </p:cNvPr>
            <p:cNvSpPr txBox="1"/>
            <p:nvPr/>
          </p:nvSpPr>
          <p:spPr>
            <a:xfrm>
              <a:off x="5495150" y="6563927"/>
              <a:ext cx="14253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NIBGE_HYM-0672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5B1AEAD0-C5DA-8B24-59F7-BF4F72FE2F68}"/>
                </a:ext>
              </a:extLst>
            </p:cNvPr>
            <p:cNvSpPr txBox="1"/>
            <p:nvPr/>
          </p:nvSpPr>
          <p:spPr>
            <a:xfrm>
              <a:off x="9342553" y="1806758"/>
              <a:ext cx="10326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FF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Yunnan3_JQ780457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8395CFAC-5CB8-6C0B-81BD-F8DB42D93E92}"/>
                </a:ext>
              </a:extLst>
            </p:cNvPr>
            <p:cNvSpPr txBox="1"/>
            <p:nvPr/>
          </p:nvSpPr>
          <p:spPr>
            <a:xfrm>
              <a:off x="9342785" y="3096840"/>
              <a:ext cx="9525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_KF958705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7F764D1D-3CDC-DB1C-1A6E-012920C3F94A}"/>
                </a:ext>
              </a:extLst>
            </p:cNvPr>
            <p:cNvSpPr txBox="1"/>
            <p:nvPr/>
          </p:nvSpPr>
          <p:spPr>
            <a:xfrm>
              <a:off x="9345098" y="3741879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Thailand_CBG-A13345-E04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20EB7E8A-B8FF-50EA-B257-75551D3480FA}"/>
                </a:ext>
              </a:extLst>
            </p:cNvPr>
            <p:cNvSpPr txBox="1"/>
            <p:nvPr/>
          </p:nvSpPr>
          <p:spPr>
            <a:xfrm>
              <a:off x="5495185" y="5112587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49-G02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519FD39F-20B6-F805-98C4-35EDCD350A1B}"/>
                </a:ext>
              </a:extLst>
            </p:cNvPr>
            <p:cNvSpPr txBox="1"/>
            <p:nvPr/>
          </p:nvSpPr>
          <p:spPr>
            <a:xfrm>
              <a:off x="9339777" y="4064400"/>
              <a:ext cx="10727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onesia_LC170004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744BF0C9-A7A3-0B5B-4316-9D22459608B2}"/>
                </a:ext>
              </a:extLst>
            </p:cNvPr>
            <p:cNvSpPr txBox="1"/>
            <p:nvPr/>
          </p:nvSpPr>
          <p:spPr>
            <a:xfrm>
              <a:off x="8793855" y="1242352"/>
              <a:ext cx="9076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Japan_LC170007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53D04192-AC1C-C54D-AC76-37AF69966740}"/>
                </a:ext>
              </a:extLst>
            </p:cNvPr>
            <p:cNvSpPr txBox="1"/>
            <p:nvPr/>
          </p:nvSpPr>
          <p:spPr>
            <a:xfrm>
              <a:off x="9342785" y="2613060"/>
              <a:ext cx="1047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Belgium_MF363127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7BE41C38-415E-8281-7AA6-87ACF6E3C0EB}"/>
                </a:ext>
              </a:extLst>
            </p:cNvPr>
            <p:cNvSpPr txBox="1"/>
            <p:nvPr/>
          </p:nvSpPr>
          <p:spPr>
            <a:xfrm>
              <a:off x="8793798" y="3177466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China_LC170001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AF43A3FA-028E-96F6-23C6-1B98EF16032D}"/>
                </a:ext>
              </a:extLst>
            </p:cNvPr>
            <p:cNvSpPr txBox="1"/>
            <p:nvPr/>
          </p:nvSpPr>
          <p:spPr>
            <a:xfrm>
              <a:off x="5495225" y="6080159"/>
              <a:ext cx="1362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50-E08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E13E4E47-4561-FCB4-55BE-A024DD4A1552}"/>
                </a:ext>
              </a:extLst>
            </p:cNvPr>
            <p:cNvSpPr txBox="1"/>
            <p:nvPr/>
          </p:nvSpPr>
          <p:spPr>
            <a:xfrm>
              <a:off x="5495196" y="5918889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50-D1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03E1E441-8F07-6F28-9B6D-5E8D92456646}"/>
                </a:ext>
              </a:extLst>
            </p:cNvPr>
            <p:cNvSpPr txBox="1"/>
            <p:nvPr/>
          </p:nvSpPr>
          <p:spPr>
            <a:xfrm>
              <a:off x="8793913" y="3258099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Thailand_CBG-A00326-E05</a:t>
              </a: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7DB47617-0D4E-8D43-2707-46B8A7E618EE}"/>
                </a:ext>
              </a:extLst>
            </p:cNvPr>
            <p:cNvSpPr txBox="1"/>
            <p:nvPr/>
          </p:nvSpPr>
          <p:spPr>
            <a:xfrm>
              <a:off x="9342553" y="2129279"/>
              <a:ext cx="15119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_BC_ZSM_HYM_1063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60D2BCC3-84E7-17B7-00E7-CBD39249193F}"/>
                </a:ext>
              </a:extLst>
            </p:cNvPr>
            <p:cNvSpPr txBox="1"/>
            <p:nvPr/>
          </p:nvSpPr>
          <p:spPr>
            <a:xfrm>
              <a:off x="5495150" y="6402651"/>
              <a:ext cx="1362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49-E01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3BA0754F-E65B-851A-8921-E6A52D398458}"/>
                </a:ext>
              </a:extLst>
            </p:cNvPr>
            <p:cNvSpPr txBox="1"/>
            <p:nvPr/>
          </p:nvSpPr>
          <p:spPr>
            <a:xfrm>
              <a:off x="9342438" y="1887389"/>
              <a:ext cx="3162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 dirty="0">
                  <a:ln/>
                  <a:solidFill>
                    <a:srgbClr val="3366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Jiangsu/Zhejiang</a:t>
              </a:r>
              <a:r>
                <a:rPr lang="en-US" sz="800" spc="0" baseline="0">
                  <a:ln/>
                  <a:solidFill>
                    <a:srgbClr val="3366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_JQ780450_</a:t>
              </a:r>
              <a:r>
                <a:rPr lang="en-US" sz="800" spc="0" baseline="0" dirty="0">
                  <a:ln/>
                  <a:solidFill>
                    <a:srgbClr val="3366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Zhejiang2</a:t>
              </a:r>
              <a:r>
                <a:rPr lang="en-US" sz="800" spc="0" baseline="0">
                  <a:ln/>
                  <a:solidFill>
                    <a:srgbClr val="3366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_JQ780451_</a:t>
              </a:r>
              <a:r>
                <a:rPr lang="en-US" sz="800" spc="0" baseline="0" dirty="0">
                  <a:ln/>
                  <a:solidFill>
                    <a:srgbClr val="3366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France</a:t>
              </a:r>
              <a:r>
                <a:rPr lang="en-US" sz="800" spc="0" baseline="0">
                  <a:ln/>
                  <a:solidFill>
                    <a:srgbClr val="3366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_JQ780453</a:t>
              </a:r>
              <a:endParaRPr lang="en-US" sz="800" spc="0" baseline="0" dirty="0">
                <a:ln/>
                <a:solidFill>
                  <a:srgbClr val="3366FF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gency FB"/>
                <a:rtl val="0"/>
              </a:endParaRP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5DBE131D-A72B-AA50-7E13-5B30A9F94716}"/>
                </a:ext>
              </a:extLst>
            </p:cNvPr>
            <p:cNvSpPr txBox="1"/>
            <p:nvPr/>
          </p:nvSpPr>
          <p:spPr>
            <a:xfrm>
              <a:off x="5494988" y="4548180"/>
              <a:ext cx="14766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NIBGE_HYM-00809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B6EB7987-0FC8-7F3F-E07C-C8AAA8EB0715}"/>
                </a:ext>
              </a:extLst>
            </p:cNvPr>
            <p:cNvSpPr txBox="1"/>
            <p:nvPr/>
          </p:nvSpPr>
          <p:spPr>
            <a:xfrm>
              <a:off x="8793913" y="3499989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Thailand_CBG-A00326-E06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DE6824C4-6296-433D-8F84-ABDEF9FED398}"/>
                </a:ext>
              </a:extLst>
            </p:cNvPr>
            <p:cNvSpPr txBox="1"/>
            <p:nvPr/>
          </p:nvSpPr>
          <p:spPr>
            <a:xfrm>
              <a:off x="6047301" y="6483319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1151-A10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5C2A8D87-7E54-2BE9-B5F1-75255F91A289}"/>
                </a:ext>
              </a:extLst>
            </p:cNvPr>
            <p:cNvSpPr txBox="1"/>
            <p:nvPr/>
          </p:nvSpPr>
          <p:spPr>
            <a:xfrm>
              <a:off x="8793855" y="3822510"/>
              <a:ext cx="10278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Vietnam_LC170014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E23151C4-985B-2BB2-D85C-54DF9334440C}"/>
                </a:ext>
              </a:extLst>
            </p:cNvPr>
            <p:cNvSpPr txBox="1"/>
            <p:nvPr/>
          </p:nvSpPr>
          <p:spPr>
            <a:xfrm>
              <a:off x="4946504" y="758571"/>
              <a:ext cx="14766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 dirty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NIBGE_HYM-01003</a:t>
              </a: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2111480A-6D00-7330-C278-42A20D0557AC}"/>
                </a:ext>
              </a:extLst>
            </p:cNvPr>
            <p:cNvSpPr txBox="1"/>
            <p:nvPr/>
          </p:nvSpPr>
          <p:spPr>
            <a:xfrm>
              <a:off x="9339835" y="4225659"/>
              <a:ext cx="10326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Yunnan1_JQ780455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1AC3542F-7210-1793-81E6-A7CA6FE62C5F}"/>
                </a:ext>
              </a:extLst>
            </p:cNvPr>
            <p:cNvSpPr txBox="1"/>
            <p:nvPr/>
          </p:nvSpPr>
          <p:spPr>
            <a:xfrm>
              <a:off x="9339777" y="4145027"/>
              <a:ext cx="8851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India_LC169999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F537550B-32C2-73BB-787A-5BB3692DE934}"/>
                </a:ext>
              </a:extLst>
            </p:cNvPr>
            <p:cNvSpPr txBox="1"/>
            <p:nvPr/>
          </p:nvSpPr>
          <p:spPr>
            <a:xfrm>
              <a:off x="8793971" y="1484236"/>
              <a:ext cx="8066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SK_LC170006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5BD8149D-4788-E527-B6E8-AA293A84A8FC}"/>
                </a:ext>
              </a:extLst>
            </p:cNvPr>
            <p:cNvSpPr txBox="1"/>
            <p:nvPr/>
          </p:nvSpPr>
          <p:spPr>
            <a:xfrm>
              <a:off x="9339835" y="4386917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China_LC169995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79B71681-1910-5FED-854B-4DD6F7930112}"/>
                </a:ext>
              </a:extLst>
            </p:cNvPr>
            <p:cNvSpPr txBox="1"/>
            <p:nvPr/>
          </p:nvSpPr>
          <p:spPr>
            <a:xfrm>
              <a:off x="5495156" y="5354477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0840-G08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B9C55369-DD92-6428-E7C3-51DC31A56EDD}"/>
                </a:ext>
              </a:extLst>
            </p:cNvPr>
            <p:cNvSpPr txBox="1"/>
            <p:nvPr/>
          </p:nvSpPr>
          <p:spPr>
            <a:xfrm>
              <a:off x="6047301" y="6322043"/>
              <a:ext cx="13740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gency FB"/>
                  <a:rtl val="0"/>
                </a:rPr>
                <a:t>Pakistan_BIOUG40840-G0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169741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03</Words>
  <Application>Microsoft Office PowerPoint</Application>
  <PresentationFormat>Widescreen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uhua Xia</dc:creator>
  <cp:lastModifiedBy>Xuhua Xia</cp:lastModifiedBy>
  <cp:revision>1</cp:revision>
  <dcterms:created xsi:type="dcterms:W3CDTF">2024-08-31T21:15:33Z</dcterms:created>
  <dcterms:modified xsi:type="dcterms:W3CDTF">2024-09-22T21:50:27Z</dcterms:modified>
</cp:coreProperties>
</file>